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71" r:id="rId2"/>
    <p:sldId id="272" r:id="rId3"/>
    <p:sldId id="274" r:id="rId4"/>
    <p:sldId id="273" r:id="rId5"/>
    <p:sldId id="268" r:id="rId6"/>
  </p:sldIdLst>
  <p:sldSz cx="6858000" cy="9906000" type="A4"/>
  <p:notesSz cx="6742113" cy="98758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83" userDrawn="1">
          <p15:clr>
            <a:srgbClr val="A4A3A4"/>
          </p15:clr>
        </p15:guide>
        <p15:guide id="2" pos="2183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11" userDrawn="1">
          <p15:clr>
            <a:srgbClr val="A4A3A4"/>
          </p15:clr>
        </p15:guide>
        <p15:guide id="2" pos="2124" userDrawn="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B75C3C5-5744-4DFF-8FC8-0BA2091C75E0}" v="5" dt="2024-10-17T23:12:20.96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168" autoAdjust="0"/>
    <p:restoredTop sz="95504" autoAdjust="0"/>
  </p:normalViewPr>
  <p:slideViewPr>
    <p:cSldViewPr snapToGrid="0">
      <p:cViewPr varScale="1">
        <p:scale>
          <a:sx n="81" d="100"/>
          <a:sy n="81" d="100"/>
        </p:scale>
        <p:origin x="3546" y="108"/>
      </p:cViewPr>
      <p:guideLst>
        <p:guide orient="horz" pos="3483"/>
        <p:guide pos="2183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69" d="100"/>
          <a:sy n="69" d="100"/>
        </p:scale>
        <p:origin x="2505" y="24"/>
      </p:cViewPr>
      <p:guideLst>
        <p:guide orient="horz" pos="3111"/>
        <p:guide pos="2124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優治 酒井" userId="af82edebe887f20f" providerId="LiveId" clId="{AB75C3C5-5744-4DFF-8FC8-0BA2091C75E0}"/>
    <pc:docChg chg="custSel addSld modSld modNotesMaster">
      <pc:chgData name="優治 酒井" userId="af82edebe887f20f" providerId="LiveId" clId="{AB75C3C5-5744-4DFF-8FC8-0BA2091C75E0}" dt="2024-10-17T23:12:20.965" v="73"/>
      <pc:docMkLst>
        <pc:docMk/>
      </pc:docMkLst>
      <pc:sldChg chg="modSp mod">
        <pc:chgData name="優治 酒井" userId="af82edebe887f20f" providerId="LiveId" clId="{AB75C3C5-5744-4DFF-8FC8-0BA2091C75E0}" dt="2024-10-17T22:17:05.218" v="17" actId="20577"/>
        <pc:sldMkLst>
          <pc:docMk/>
          <pc:sldMk cId="4038104200" sldId="268"/>
        </pc:sldMkLst>
        <pc:spChg chg="mod">
          <ac:chgData name="優治 酒井" userId="af82edebe887f20f" providerId="LiveId" clId="{AB75C3C5-5744-4DFF-8FC8-0BA2091C75E0}" dt="2024-10-17T22:17:01.732" v="15" actId="20577"/>
          <ac:spMkLst>
            <pc:docMk/>
            <pc:sldMk cId="4038104200" sldId="268"/>
            <ac:spMk id="6" creationId="{EC0E472B-CCA1-0D39-21E8-FFA036703CD6}"/>
          </ac:spMkLst>
        </pc:spChg>
        <pc:spChg chg="mod">
          <ac:chgData name="優治 酒井" userId="af82edebe887f20f" providerId="LiveId" clId="{AB75C3C5-5744-4DFF-8FC8-0BA2091C75E0}" dt="2024-10-17T22:17:05.218" v="17" actId="20577"/>
          <ac:spMkLst>
            <pc:docMk/>
            <pc:sldMk cId="4038104200" sldId="268"/>
            <ac:spMk id="39" creationId="{2D809454-6C6F-441A-FF22-695A5AB34C54}"/>
          </ac:spMkLst>
        </pc:spChg>
      </pc:sldChg>
      <pc:sldChg chg="addSp modSp">
        <pc:chgData name="優治 酒井" userId="af82edebe887f20f" providerId="LiveId" clId="{AB75C3C5-5744-4DFF-8FC8-0BA2091C75E0}" dt="2024-10-17T22:16:22.347" v="1"/>
        <pc:sldMkLst>
          <pc:docMk/>
          <pc:sldMk cId="1973638820" sldId="272"/>
        </pc:sldMkLst>
        <pc:graphicFrameChg chg="add mod">
          <ac:chgData name="優治 酒井" userId="af82edebe887f20f" providerId="LiveId" clId="{AB75C3C5-5744-4DFF-8FC8-0BA2091C75E0}" dt="2024-10-17T22:16:22.347" v="1"/>
          <ac:graphicFrameMkLst>
            <pc:docMk/>
            <pc:sldMk cId="1973638820" sldId="272"/>
            <ac:graphicFrameMk id="4" creationId="{6501D501-2AA5-59A2-0441-32C550D7E00C}"/>
          </ac:graphicFrameMkLst>
        </pc:graphicFrameChg>
      </pc:sldChg>
      <pc:sldChg chg="modSp mod">
        <pc:chgData name="優治 酒井" userId="af82edebe887f20f" providerId="LiveId" clId="{AB75C3C5-5744-4DFF-8FC8-0BA2091C75E0}" dt="2024-10-17T22:16:57.799" v="13" actId="20577"/>
        <pc:sldMkLst>
          <pc:docMk/>
          <pc:sldMk cId="2637805845" sldId="273"/>
        </pc:sldMkLst>
        <pc:spChg chg="mod">
          <ac:chgData name="優治 酒井" userId="af82edebe887f20f" providerId="LiveId" clId="{AB75C3C5-5744-4DFF-8FC8-0BA2091C75E0}" dt="2024-10-17T22:16:57.799" v="13" actId="20577"/>
          <ac:spMkLst>
            <pc:docMk/>
            <pc:sldMk cId="2637805845" sldId="273"/>
            <ac:spMk id="2" creationId="{03DB2D03-761C-871E-B84B-2A37290E04A2}"/>
          </ac:spMkLst>
        </pc:spChg>
        <pc:spChg chg="mod">
          <ac:chgData name="優治 酒井" userId="af82edebe887f20f" providerId="LiveId" clId="{AB75C3C5-5744-4DFF-8FC8-0BA2091C75E0}" dt="2024-10-17T22:16:55.619" v="11" actId="20577"/>
          <ac:spMkLst>
            <pc:docMk/>
            <pc:sldMk cId="2637805845" sldId="273"/>
            <ac:spMk id="5" creationId="{A1053185-CC71-DF88-47D8-279B4F83EA63}"/>
          </ac:spMkLst>
        </pc:spChg>
      </pc:sldChg>
      <pc:sldChg chg="addSp delSp modSp add mod">
        <pc:chgData name="優治 酒井" userId="af82edebe887f20f" providerId="LiveId" clId="{AB75C3C5-5744-4DFF-8FC8-0BA2091C75E0}" dt="2024-10-17T22:18:20.219" v="72" actId="20577"/>
        <pc:sldMkLst>
          <pc:docMk/>
          <pc:sldMk cId="986960098" sldId="274"/>
        </pc:sldMkLst>
        <pc:spChg chg="mod">
          <ac:chgData name="優治 酒井" userId="af82edebe887f20f" providerId="LiveId" clId="{AB75C3C5-5744-4DFF-8FC8-0BA2091C75E0}" dt="2024-10-17T22:18:20.219" v="72" actId="20577"/>
          <ac:spMkLst>
            <pc:docMk/>
            <pc:sldMk cId="986960098" sldId="274"/>
            <ac:spMk id="4" creationId="{AFC9886A-AF24-CF3B-11D6-DA35C9E497EB}"/>
          </ac:spMkLst>
        </pc:spChg>
        <pc:spChg chg="mod">
          <ac:chgData name="優治 酒井" userId="af82edebe887f20f" providerId="LiveId" clId="{AB75C3C5-5744-4DFF-8FC8-0BA2091C75E0}" dt="2024-10-17T22:17:32.673" v="53" actId="6549"/>
          <ac:spMkLst>
            <pc:docMk/>
            <pc:sldMk cId="986960098" sldId="274"/>
            <ac:spMk id="5" creationId="{0BE06C8E-34C4-7672-8BDA-F2224B925B45}"/>
          </ac:spMkLst>
        </pc:spChg>
        <pc:picChg chg="del">
          <ac:chgData name="優治 酒井" userId="af82edebe887f20f" providerId="LiveId" clId="{AB75C3C5-5744-4DFF-8FC8-0BA2091C75E0}" dt="2024-10-17T22:16:29.214" v="3" actId="478"/>
          <ac:picMkLst>
            <pc:docMk/>
            <pc:sldMk cId="986960098" sldId="274"/>
            <ac:picMk id="3" creationId="{EC44482D-ACF0-A1FE-1274-97E933CD979A}"/>
          </ac:picMkLst>
        </pc:picChg>
        <pc:picChg chg="add mod">
          <ac:chgData name="優治 酒井" userId="af82edebe887f20f" providerId="LiveId" clId="{AB75C3C5-5744-4DFF-8FC8-0BA2091C75E0}" dt="2024-10-17T22:16:46.553" v="7" actId="1076"/>
          <ac:picMkLst>
            <pc:docMk/>
            <pc:sldMk cId="986960098" sldId="274"/>
            <ac:picMk id="6" creationId="{68B092E7-C028-7AD6-2A39-89588C66EAC1}"/>
          </ac:picMkLst>
        </pc:picChg>
      </pc:sldChg>
    </pc:docChg>
  </pc:docChgLst>
  <pc:docChgLst>
    <pc:chgData name="酒井 優治" userId="af82edebe887f20f" providerId="LiveId" clId="{22C4BA42-4E19-4E70-8263-879C0FD9C514}"/>
    <pc:docChg chg="undo custSel addSld delSld modSld">
      <pc:chgData name="酒井 優治" userId="af82edebe887f20f" providerId="LiveId" clId="{22C4BA42-4E19-4E70-8263-879C0FD9C514}" dt="2022-03-30T23:37:20.982" v="947" actId="1076"/>
      <pc:docMkLst>
        <pc:docMk/>
      </pc:docMkLst>
      <pc:sldChg chg="addSp delSp modSp add mod">
        <pc:chgData name="酒井 優治" userId="af82edebe887f20f" providerId="LiveId" clId="{22C4BA42-4E19-4E70-8263-879C0FD9C514}" dt="2022-03-30T01:12:32.034" v="61" actId="1076"/>
        <pc:sldMkLst>
          <pc:docMk/>
          <pc:sldMk cId="2696857125" sldId="266"/>
        </pc:sldMkLst>
        <pc:spChg chg="add mod">
          <ac:chgData name="酒井 優治" userId="af82edebe887f20f" providerId="LiveId" clId="{22C4BA42-4E19-4E70-8263-879C0FD9C514}" dt="2022-03-15T10:24:45.849" v="40"/>
          <ac:spMkLst>
            <pc:docMk/>
            <pc:sldMk cId="2696857125" sldId="266"/>
            <ac:spMk id="3" creationId="{11A45509-B403-46FA-A109-7531958C33A6}"/>
          </ac:spMkLst>
        </pc:spChg>
        <pc:spChg chg="add mod">
          <ac:chgData name="酒井 優治" userId="af82edebe887f20f" providerId="LiveId" clId="{22C4BA42-4E19-4E70-8263-879C0FD9C514}" dt="2022-03-15T10:24:45.849" v="40"/>
          <ac:spMkLst>
            <pc:docMk/>
            <pc:sldMk cId="2696857125" sldId="266"/>
            <ac:spMk id="4" creationId="{B0465965-2CE3-4D93-8425-4A901A95AFFA}"/>
          </ac:spMkLst>
        </pc:spChg>
        <pc:picChg chg="add mod">
          <ac:chgData name="酒井 優治" userId="af82edebe887f20f" providerId="LiveId" clId="{22C4BA42-4E19-4E70-8263-879C0FD9C514}" dt="2022-03-30T01:12:32.034" v="61" actId="1076"/>
          <ac:picMkLst>
            <pc:docMk/>
            <pc:sldMk cId="2696857125" sldId="266"/>
            <ac:picMk id="2" creationId="{EB26E17E-AC6C-4109-89CB-4BCCDFA2DA64}"/>
          </ac:picMkLst>
        </pc:picChg>
        <pc:picChg chg="add del mod">
          <ac:chgData name="酒井 優治" userId="af82edebe887f20f" providerId="LiveId" clId="{22C4BA42-4E19-4E70-8263-879C0FD9C514}" dt="2022-03-29T09:22:33.890" v="47" actId="478"/>
          <ac:picMkLst>
            <pc:docMk/>
            <pc:sldMk cId="2696857125" sldId="266"/>
            <ac:picMk id="5" creationId="{11D10CE9-0D38-4D6B-9729-23C5A6E7172C}"/>
          </ac:picMkLst>
        </pc:picChg>
        <pc:picChg chg="del mod">
          <ac:chgData name="酒井 優治" userId="af82edebe887f20f" providerId="LiveId" clId="{22C4BA42-4E19-4E70-8263-879C0FD9C514}" dt="2022-03-30T01:11:37.296" v="59" actId="478"/>
          <ac:picMkLst>
            <pc:docMk/>
            <pc:sldMk cId="2696857125" sldId="266"/>
            <ac:picMk id="6" creationId="{3FAF1668-B04C-4CA4-98AA-28C177DBFAD0}"/>
          </ac:picMkLst>
        </pc:picChg>
      </pc:sldChg>
      <pc:sldChg chg="add del">
        <pc:chgData name="酒井 優治" userId="af82edebe887f20f" providerId="LiveId" clId="{22C4BA42-4E19-4E70-8263-879C0FD9C514}" dt="2022-03-15T10:24:33.965" v="38" actId="47"/>
        <pc:sldMkLst>
          <pc:docMk/>
          <pc:sldMk cId="3015159007" sldId="269"/>
        </pc:sldMkLst>
      </pc:sldChg>
      <pc:sldChg chg="addSp delSp modSp add mod">
        <pc:chgData name="酒井 優治" userId="af82edebe887f20f" providerId="LiveId" clId="{22C4BA42-4E19-4E70-8263-879C0FD9C514}" dt="2022-03-30T06:38:50.656" v="917" actId="1076"/>
        <pc:sldMkLst>
          <pc:docMk/>
          <pc:sldMk cId="1889218569" sldId="270"/>
        </pc:sldMkLst>
        <pc:spChg chg="add mod">
          <ac:chgData name="酒井 優治" userId="af82edebe887f20f" providerId="LiveId" clId="{22C4BA42-4E19-4E70-8263-879C0FD9C514}" dt="2022-03-15T10:24:41.480" v="39"/>
          <ac:spMkLst>
            <pc:docMk/>
            <pc:sldMk cId="1889218569" sldId="270"/>
            <ac:spMk id="5" creationId="{3C999F1F-C335-4B41-ADA4-E58A5F7320BD}"/>
          </ac:spMkLst>
        </pc:spChg>
        <pc:spChg chg="add mod">
          <ac:chgData name="酒井 優治" userId="af82edebe887f20f" providerId="LiveId" clId="{22C4BA42-4E19-4E70-8263-879C0FD9C514}" dt="2022-03-15T10:24:41.480" v="39"/>
          <ac:spMkLst>
            <pc:docMk/>
            <pc:sldMk cId="1889218569" sldId="270"/>
            <ac:spMk id="6" creationId="{1DB06248-0732-43EE-BAA1-CC609C15D738}"/>
          </ac:spMkLst>
        </pc:spChg>
        <pc:picChg chg="add del mod">
          <ac:chgData name="酒井 優治" userId="af82edebe887f20f" providerId="LiveId" clId="{22C4BA42-4E19-4E70-8263-879C0FD9C514}" dt="2022-03-30T01:10:48.342" v="54" actId="478"/>
          <ac:picMkLst>
            <pc:docMk/>
            <pc:sldMk cId="1889218569" sldId="270"/>
            <ac:picMk id="2" creationId="{97F0B685-AA39-451A-B5E1-8A172275F60C}"/>
          </ac:picMkLst>
        </pc:picChg>
        <pc:picChg chg="add mod">
          <ac:chgData name="酒井 優治" userId="af82edebe887f20f" providerId="LiveId" clId="{22C4BA42-4E19-4E70-8263-879C0FD9C514}" dt="2022-03-30T06:38:50.656" v="917" actId="1076"/>
          <ac:picMkLst>
            <pc:docMk/>
            <pc:sldMk cId="1889218569" sldId="270"/>
            <ac:picMk id="3" creationId="{9D9AD12F-5AF5-4E8E-8F51-40049E0F2DAE}"/>
          </ac:picMkLst>
        </pc:picChg>
        <pc:picChg chg="del">
          <ac:chgData name="酒井 優治" userId="af82edebe887f20f" providerId="LiveId" clId="{22C4BA42-4E19-4E70-8263-879C0FD9C514}" dt="2022-03-15T01:57:21.674" v="2" actId="478"/>
          <ac:picMkLst>
            <pc:docMk/>
            <pc:sldMk cId="1889218569" sldId="270"/>
            <ac:picMk id="4" creationId="{4C9094FE-DC31-4953-A58E-04EC51250B81}"/>
          </ac:picMkLst>
        </pc:picChg>
        <pc:picChg chg="add del mod">
          <ac:chgData name="酒井 優治" userId="af82edebe887f20f" providerId="LiveId" clId="{22C4BA42-4E19-4E70-8263-879C0FD9C514}" dt="2022-03-30T06:38:49.275" v="916"/>
          <ac:picMkLst>
            <pc:docMk/>
            <pc:sldMk cId="1889218569" sldId="270"/>
            <ac:picMk id="7" creationId="{D915080C-F4E0-4A11-91B6-DCA6C37EF7B3}"/>
          </ac:picMkLst>
        </pc:picChg>
      </pc:sldChg>
      <pc:sldChg chg="addSp delSp modSp add mod">
        <pc:chgData name="酒井 優治" userId="af82edebe887f20f" providerId="LiveId" clId="{22C4BA42-4E19-4E70-8263-879C0FD9C514}" dt="2022-03-30T01:12:44.201" v="62" actId="1076"/>
        <pc:sldMkLst>
          <pc:docMk/>
          <pc:sldMk cId="764672988" sldId="271"/>
        </pc:sldMkLst>
        <pc:spChg chg="del">
          <ac:chgData name="酒井 優治" userId="af82edebe887f20f" providerId="LiveId" clId="{22C4BA42-4E19-4E70-8263-879C0FD9C514}" dt="2022-03-15T03:33:39.551" v="17" actId="478"/>
          <ac:spMkLst>
            <pc:docMk/>
            <pc:sldMk cId="764672988" sldId="271"/>
            <ac:spMk id="5" creationId="{C137C133-A914-487F-9AC3-0D933FD3F3F4}"/>
          </ac:spMkLst>
        </pc:spChg>
        <pc:spChg chg="add mod">
          <ac:chgData name="酒井 優治" userId="af82edebe887f20f" providerId="LiveId" clId="{22C4BA42-4E19-4E70-8263-879C0FD9C514}" dt="2022-03-15T10:24:49.762" v="41"/>
          <ac:spMkLst>
            <pc:docMk/>
            <pc:sldMk cId="764672988" sldId="271"/>
            <ac:spMk id="7" creationId="{F9DC4AA7-9FB2-4B51-832A-1D46274E63AD}"/>
          </ac:spMkLst>
        </pc:spChg>
        <pc:spChg chg="add mod">
          <ac:chgData name="酒井 優治" userId="af82edebe887f20f" providerId="LiveId" clId="{22C4BA42-4E19-4E70-8263-879C0FD9C514}" dt="2022-03-15T10:24:49.762" v="41"/>
          <ac:spMkLst>
            <pc:docMk/>
            <pc:sldMk cId="764672988" sldId="271"/>
            <ac:spMk id="8" creationId="{85D948B6-3660-4C56-AEA1-7A6241F4B42A}"/>
          </ac:spMkLst>
        </pc:spChg>
        <pc:graphicFrameChg chg="add del mod">
          <ac:chgData name="酒井 優治" userId="af82edebe887f20f" providerId="LiveId" clId="{22C4BA42-4E19-4E70-8263-879C0FD9C514}" dt="2022-03-15T03:33:35.409" v="15" actId="478"/>
          <ac:graphicFrameMkLst>
            <pc:docMk/>
            <pc:sldMk cId="764672988" sldId="271"/>
            <ac:graphicFrameMk id="6" creationId="{57ACD47B-544F-47AE-8B14-4473AD2DDC64}"/>
          </ac:graphicFrameMkLst>
        </pc:graphicFrameChg>
        <pc:picChg chg="add mod modCrop">
          <ac:chgData name="酒井 優治" userId="af82edebe887f20f" providerId="LiveId" clId="{22C4BA42-4E19-4E70-8263-879C0FD9C514}" dt="2022-03-30T01:12:44.201" v="62" actId="1076"/>
          <ac:picMkLst>
            <pc:docMk/>
            <pc:sldMk cId="764672988" sldId="271"/>
            <ac:picMk id="2" creationId="{7206F050-6AF0-4DEA-A19D-994D6A48E5FD}"/>
          </ac:picMkLst>
        </pc:picChg>
        <pc:picChg chg="del mod">
          <ac:chgData name="酒井 優治" userId="af82edebe887f20f" providerId="LiveId" clId="{22C4BA42-4E19-4E70-8263-879C0FD9C514}" dt="2022-03-15T03:30:03.518" v="10" actId="478"/>
          <ac:picMkLst>
            <pc:docMk/>
            <pc:sldMk cId="764672988" sldId="271"/>
            <ac:picMk id="4" creationId="{8703DBB5-D8D7-4E58-B7AA-9FD5F9F9320B}"/>
          </ac:picMkLst>
        </pc:picChg>
      </pc:sldChg>
      <pc:sldChg chg="addSp delSp modSp mod">
        <pc:chgData name="酒井 優治" userId="af82edebe887f20f" providerId="LiveId" clId="{22C4BA42-4E19-4E70-8263-879C0FD9C514}" dt="2022-03-30T06:14:47.158" v="911" actId="14100"/>
        <pc:sldMkLst>
          <pc:docMk/>
          <pc:sldMk cId="2246250910" sldId="299"/>
        </pc:sldMkLst>
        <pc:spChg chg="add del mod">
          <ac:chgData name="酒井 優治" userId="af82edebe887f20f" providerId="LiveId" clId="{22C4BA42-4E19-4E70-8263-879C0FD9C514}" dt="2022-03-30T05:30:16.837" v="97" actId="478"/>
          <ac:spMkLst>
            <pc:docMk/>
            <pc:sldMk cId="2246250910" sldId="299"/>
            <ac:spMk id="6" creationId="{C0B81809-7B1E-4C75-AC36-557E6A52B8EA}"/>
          </ac:spMkLst>
        </pc:spChg>
        <pc:spChg chg="add del mod">
          <ac:chgData name="酒井 優治" userId="af82edebe887f20f" providerId="LiveId" clId="{22C4BA42-4E19-4E70-8263-879C0FD9C514}" dt="2022-03-30T05:28:17.234" v="64" actId="478"/>
          <ac:spMkLst>
            <pc:docMk/>
            <pc:sldMk cId="2246250910" sldId="299"/>
            <ac:spMk id="8" creationId="{24FEAC29-175C-46BA-9DE7-8A4348C70D7A}"/>
          </ac:spMkLst>
        </pc:spChg>
        <pc:spChg chg="add del mod">
          <ac:chgData name="酒井 優治" userId="af82edebe887f20f" providerId="LiveId" clId="{22C4BA42-4E19-4E70-8263-879C0FD9C514}" dt="2022-03-30T05:28:17.234" v="64" actId="478"/>
          <ac:spMkLst>
            <pc:docMk/>
            <pc:sldMk cId="2246250910" sldId="299"/>
            <ac:spMk id="9" creationId="{F5A6F260-3F57-4F3C-8624-49BA4C694460}"/>
          </ac:spMkLst>
        </pc:spChg>
        <pc:spChg chg="add del mod">
          <ac:chgData name="酒井 優治" userId="af82edebe887f20f" providerId="LiveId" clId="{22C4BA42-4E19-4E70-8263-879C0FD9C514}" dt="2022-03-30T05:28:17.234" v="64" actId="478"/>
          <ac:spMkLst>
            <pc:docMk/>
            <pc:sldMk cId="2246250910" sldId="299"/>
            <ac:spMk id="10" creationId="{9AF3F44B-269E-44EF-9456-151E73C77A4C}"/>
          </ac:spMkLst>
        </pc:spChg>
        <pc:spChg chg="mod">
          <ac:chgData name="酒井 優治" userId="af82edebe887f20f" providerId="LiveId" clId="{22C4BA42-4E19-4E70-8263-879C0FD9C514}" dt="2022-03-15T10:24:20.569" v="36"/>
          <ac:spMkLst>
            <pc:docMk/>
            <pc:sldMk cId="2246250910" sldId="299"/>
            <ac:spMk id="10" creationId="{BC81E036-6812-4C88-8B3E-715F33018DD1}"/>
          </ac:spMkLst>
        </pc:spChg>
        <pc:spChg chg="add del mod">
          <ac:chgData name="酒井 優治" userId="af82edebe887f20f" providerId="LiveId" clId="{22C4BA42-4E19-4E70-8263-879C0FD9C514}" dt="2022-03-30T05:28:17.234" v="64" actId="478"/>
          <ac:spMkLst>
            <pc:docMk/>
            <pc:sldMk cId="2246250910" sldId="299"/>
            <ac:spMk id="12" creationId="{BE1B4E46-63A0-454A-81EA-D2440279EE9E}"/>
          </ac:spMkLst>
        </pc:spChg>
        <pc:spChg chg="add del mod">
          <ac:chgData name="酒井 優治" userId="af82edebe887f20f" providerId="LiveId" clId="{22C4BA42-4E19-4E70-8263-879C0FD9C514}" dt="2022-03-30T01:10:24.337" v="51" actId="478"/>
          <ac:spMkLst>
            <pc:docMk/>
            <pc:sldMk cId="2246250910" sldId="299"/>
            <ac:spMk id="13" creationId="{1D36C8FA-81C2-4F44-B559-5DEF3341E145}"/>
          </ac:spMkLst>
        </pc:spChg>
        <pc:spChg chg="add del mod">
          <ac:chgData name="酒井 優治" userId="af82edebe887f20f" providerId="LiveId" clId="{22C4BA42-4E19-4E70-8263-879C0FD9C514}" dt="2022-03-30T05:28:17.234" v="64" actId="478"/>
          <ac:spMkLst>
            <pc:docMk/>
            <pc:sldMk cId="2246250910" sldId="299"/>
            <ac:spMk id="14" creationId="{E6345472-6A1B-46AA-9BF5-DAB8D570243D}"/>
          </ac:spMkLst>
        </pc:spChg>
        <pc:spChg chg="add del mod">
          <ac:chgData name="酒井 優治" userId="af82edebe887f20f" providerId="LiveId" clId="{22C4BA42-4E19-4E70-8263-879C0FD9C514}" dt="2022-03-30T05:28:17.234" v="64" actId="478"/>
          <ac:spMkLst>
            <pc:docMk/>
            <pc:sldMk cId="2246250910" sldId="299"/>
            <ac:spMk id="15" creationId="{76B07F46-AAF0-4013-91F2-DD644DF2BD70}"/>
          </ac:spMkLst>
        </pc:spChg>
        <pc:spChg chg="add del mod">
          <ac:chgData name="酒井 優治" userId="af82edebe887f20f" providerId="LiveId" clId="{22C4BA42-4E19-4E70-8263-879C0FD9C514}" dt="2022-03-30T05:28:17.234" v="64" actId="478"/>
          <ac:spMkLst>
            <pc:docMk/>
            <pc:sldMk cId="2246250910" sldId="299"/>
            <ac:spMk id="16" creationId="{8AB14009-4E8D-4456-8947-0347DEC50EFD}"/>
          </ac:spMkLst>
        </pc:spChg>
        <pc:spChg chg="add del mod">
          <ac:chgData name="酒井 優治" userId="af82edebe887f20f" providerId="LiveId" clId="{22C4BA42-4E19-4E70-8263-879C0FD9C514}" dt="2022-03-30T05:28:17.234" v="64" actId="478"/>
          <ac:spMkLst>
            <pc:docMk/>
            <pc:sldMk cId="2246250910" sldId="299"/>
            <ac:spMk id="17" creationId="{C8D36F42-1A75-4F67-A66F-A977ED38076F}"/>
          </ac:spMkLst>
        </pc:spChg>
        <pc:spChg chg="add del mod">
          <ac:chgData name="酒井 優治" userId="af82edebe887f20f" providerId="LiveId" clId="{22C4BA42-4E19-4E70-8263-879C0FD9C514}" dt="2022-03-30T05:28:17.234" v="64" actId="478"/>
          <ac:spMkLst>
            <pc:docMk/>
            <pc:sldMk cId="2246250910" sldId="299"/>
            <ac:spMk id="18" creationId="{48E8E22D-EDA9-49B2-B011-90ABF81DFBA8}"/>
          </ac:spMkLst>
        </pc:spChg>
        <pc:spChg chg="add del mod">
          <ac:chgData name="酒井 優治" userId="af82edebe887f20f" providerId="LiveId" clId="{22C4BA42-4E19-4E70-8263-879C0FD9C514}" dt="2022-03-30T05:28:17.234" v="64" actId="478"/>
          <ac:spMkLst>
            <pc:docMk/>
            <pc:sldMk cId="2246250910" sldId="299"/>
            <ac:spMk id="19" creationId="{BF54A546-76E8-4DD6-A08C-36C776C813FB}"/>
          </ac:spMkLst>
        </pc:spChg>
        <pc:spChg chg="add del mod">
          <ac:chgData name="酒井 優治" userId="af82edebe887f20f" providerId="LiveId" clId="{22C4BA42-4E19-4E70-8263-879C0FD9C514}" dt="2022-03-30T05:28:17.234" v="64" actId="478"/>
          <ac:spMkLst>
            <pc:docMk/>
            <pc:sldMk cId="2246250910" sldId="299"/>
            <ac:spMk id="20" creationId="{918FC6E3-1A67-4056-A4E0-B67989629200}"/>
          </ac:spMkLst>
        </pc:spChg>
        <pc:spChg chg="add del mod">
          <ac:chgData name="酒井 優治" userId="af82edebe887f20f" providerId="LiveId" clId="{22C4BA42-4E19-4E70-8263-879C0FD9C514}" dt="2022-03-30T05:28:17.234" v="64" actId="478"/>
          <ac:spMkLst>
            <pc:docMk/>
            <pc:sldMk cId="2246250910" sldId="299"/>
            <ac:spMk id="21" creationId="{A08D87E8-04B4-4ED5-9E04-1F216FD45F6F}"/>
          </ac:spMkLst>
        </pc:spChg>
        <pc:spChg chg="add del mod">
          <ac:chgData name="酒井 優治" userId="af82edebe887f20f" providerId="LiveId" clId="{22C4BA42-4E19-4E70-8263-879C0FD9C514}" dt="2022-03-30T05:28:17.234" v="64" actId="478"/>
          <ac:spMkLst>
            <pc:docMk/>
            <pc:sldMk cId="2246250910" sldId="299"/>
            <ac:spMk id="22" creationId="{217C0CDB-515B-4247-A972-F3487899CD3E}"/>
          </ac:spMkLst>
        </pc:spChg>
        <pc:spChg chg="add del mod">
          <ac:chgData name="酒井 優治" userId="af82edebe887f20f" providerId="LiveId" clId="{22C4BA42-4E19-4E70-8263-879C0FD9C514}" dt="2022-03-30T05:28:17.234" v="64" actId="478"/>
          <ac:spMkLst>
            <pc:docMk/>
            <pc:sldMk cId="2246250910" sldId="299"/>
            <ac:spMk id="23" creationId="{BCEDBCBB-AB05-4FC9-A10D-36599F5D03DE}"/>
          </ac:spMkLst>
        </pc:spChg>
        <pc:spChg chg="add del mod">
          <ac:chgData name="酒井 優治" userId="af82edebe887f20f" providerId="LiveId" clId="{22C4BA42-4E19-4E70-8263-879C0FD9C514}" dt="2022-03-30T05:28:17.234" v="64" actId="478"/>
          <ac:spMkLst>
            <pc:docMk/>
            <pc:sldMk cId="2246250910" sldId="299"/>
            <ac:spMk id="24" creationId="{DC6D5D19-F266-4479-89DA-2BF76D67A7F9}"/>
          </ac:spMkLst>
        </pc:spChg>
        <pc:spChg chg="add del mod">
          <ac:chgData name="酒井 優治" userId="af82edebe887f20f" providerId="LiveId" clId="{22C4BA42-4E19-4E70-8263-879C0FD9C514}" dt="2022-03-30T05:28:17.234" v="64" actId="478"/>
          <ac:spMkLst>
            <pc:docMk/>
            <pc:sldMk cId="2246250910" sldId="299"/>
            <ac:spMk id="25" creationId="{48812172-C9DA-48A4-ACAF-A024CEDB1C5F}"/>
          </ac:spMkLst>
        </pc:spChg>
        <pc:spChg chg="del">
          <ac:chgData name="酒井 優治" userId="af82edebe887f20f" providerId="LiveId" clId="{22C4BA42-4E19-4E70-8263-879C0FD9C514}" dt="2022-03-30T01:10:24.337" v="51" actId="478"/>
          <ac:spMkLst>
            <pc:docMk/>
            <pc:sldMk cId="2246250910" sldId="299"/>
            <ac:spMk id="26" creationId="{27A74965-3DA6-43C4-97DA-597FC03063D7}"/>
          </ac:spMkLst>
        </pc:spChg>
        <pc:spChg chg="add del mod">
          <ac:chgData name="酒井 優治" userId="af82edebe887f20f" providerId="LiveId" clId="{22C4BA42-4E19-4E70-8263-879C0FD9C514}" dt="2022-03-30T05:28:17.234" v="64" actId="478"/>
          <ac:spMkLst>
            <pc:docMk/>
            <pc:sldMk cId="2246250910" sldId="299"/>
            <ac:spMk id="26" creationId="{29F915B9-F982-4744-BC47-AF32A4AB463E}"/>
          </ac:spMkLst>
        </pc:spChg>
        <pc:spChg chg="add del mod">
          <ac:chgData name="酒井 優治" userId="af82edebe887f20f" providerId="LiveId" clId="{22C4BA42-4E19-4E70-8263-879C0FD9C514}" dt="2022-03-30T05:28:17.234" v="64" actId="478"/>
          <ac:spMkLst>
            <pc:docMk/>
            <pc:sldMk cId="2246250910" sldId="299"/>
            <ac:spMk id="27" creationId="{2D90CA85-2845-469E-999A-49608D8EC4E0}"/>
          </ac:spMkLst>
        </pc:spChg>
        <pc:spChg chg="add del mod">
          <ac:chgData name="酒井 優治" userId="af82edebe887f20f" providerId="LiveId" clId="{22C4BA42-4E19-4E70-8263-879C0FD9C514}" dt="2022-03-30T05:28:17.234" v="64" actId="478"/>
          <ac:spMkLst>
            <pc:docMk/>
            <pc:sldMk cId="2246250910" sldId="299"/>
            <ac:spMk id="28" creationId="{978F87EA-9C67-4D6F-B1DE-2C42DB100067}"/>
          </ac:spMkLst>
        </pc:spChg>
        <pc:spChg chg="add del mod">
          <ac:chgData name="酒井 優治" userId="af82edebe887f20f" providerId="LiveId" clId="{22C4BA42-4E19-4E70-8263-879C0FD9C514}" dt="2022-03-30T05:28:17.234" v="64" actId="478"/>
          <ac:spMkLst>
            <pc:docMk/>
            <pc:sldMk cId="2246250910" sldId="299"/>
            <ac:spMk id="29" creationId="{69654144-1F21-4594-AA1E-58C27E932E71}"/>
          </ac:spMkLst>
        </pc:spChg>
        <pc:spChg chg="add del mod">
          <ac:chgData name="酒井 優治" userId="af82edebe887f20f" providerId="LiveId" clId="{22C4BA42-4E19-4E70-8263-879C0FD9C514}" dt="2022-03-30T05:28:17.234" v="64" actId="478"/>
          <ac:spMkLst>
            <pc:docMk/>
            <pc:sldMk cId="2246250910" sldId="299"/>
            <ac:spMk id="30" creationId="{9627182B-391A-4768-8CC3-BAEA2F68810A}"/>
          </ac:spMkLst>
        </pc:spChg>
        <pc:spChg chg="add del mod">
          <ac:chgData name="酒井 優治" userId="af82edebe887f20f" providerId="LiveId" clId="{22C4BA42-4E19-4E70-8263-879C0FD9C514}" dt="2022-03-30T05:28:17.234" v="64" actId="478"/>
          <ac:spMkLst>
            <pc:docMk/>
            <pc:sldMk cId="2246250910" sldId="299"/>
            <ac:spMk id="31" creationId="{2DFAAE8C-9754-4546-8DAB-5765730CE2DA}"/>
          </ac:spMkLst>
        </pc:spChg>
        <pc:spChg chg="add del mod">
          <ac:chgData name="酒井 優治" userId="af82edebe887f20f" providerId="LiveId" clId="{22C4BA42-4E19-4E70-8263-879C0FD9C514}" dt="2022-03-30T05:28:17.234" v="64" actId="478"/>
          <ac:spMkLst>
            <pc:docMk/>
            <pc:sldMk cId="2246250910" sldId="299"/>
            <ac:spMk id="32" creationId="{083329A6-1A7F-4A79-B341-8FED65DFB1E0}"/>
          </ac:spMkLst>
        </pc:spChg>
        <pc:spChg chg="add del mod">
          <ac:chgData name="酒井 優治" userId="af82edebe887f20f" providerId="LiveId" clId="{22C4BA42-4E19-4E70-8263-879C0FD9C514}" dt="2022-03-30T05:28:17.234" v="64" actId="478"/>
          <ac:spMkLst>
            <pc:docMk/>
            <pc:sldMk cId="2246250910" sldId="299"/>
            <ac:spMk id="33" creationId="{EFAA38B7-EB23-402B-ACA0-904333E317D6}"/>
          </ac:spMkLst>
        </pc:spChg>
        <pc:spChg chg="add mod">
          <ac:chgData name="酒井 優治" userId="af82edebe887f20f" providerId="LiveId" clId="{22C4BA42-4E19-4E70-8263-879C0FD9C514}" dt="2022-03-30T05:28:14.117" v="63"/>
          <ac:spMkLst>
            <pc:docMk/>
            <pc:sldMk cId="2246250910" sldId="299"/>
            <ac:spMk id="37" creationId="{7484DFB5-726D-4867-A434-4272F7BA0B75}"/>
          </ac:spMkLst>
        </pc:spChg>
        <pc:spChg chg="add mod">
          <ac:chgData name="酒井 優治" userId="af82edebe887f20f" providerId="LiveId" clId="{22C4BA42-4E19-4E70-8263-879C0FD9C514}" dt="2022-03-30T05:28:14.117" v="63"/>
          <ac:spMkLst>
            <pc:docMk/>
            <pc:sldMk cId="2246250910" sldId="299"/>
            <ac:spMk id="39" creationId="{9B4A139C-B601-4131-A854-7F688E584389}"/>
          </ac:spMkLst>
        </pc:spChg>
        <pc:spChg chg="add mod">
          <ac:chgData name="酒井 優治" userId="af82edebe887f20f" providerId="LiveId" clId="{22C4BA42-4E19-4E70-8263-879C0FD9C514}" dt="2022-03-30T05:28:14.117" v="63"/>
          <ac:spMkLst>
            <pc:docMk/>
            <pc:sldMk cId="2246250910" sldId="299"/>
            <ac:spMk id="40" creationId="{60934AFD-9844-4599-9283-719ABFA90485}"/>
          </ac:spMkLst>
        </pc:spChg>
        <pc:spChg chg="add mod">
          <ac:chgData name="酒井 優治" userId="af82edebe887f20f" providerId="LiveId" clId="{22C4BA42-4E19-4E70-8263-879C0FD9C514}" dt="2022-03-30T05:28:14.117" v="63"/>
          <ac:spMkLst>
            <pc:docMk/>
            <pc:sldMk cId="2246250910" sldId="299"/>
            <ac:spMk id="42" creationId="{E254EAEE-E6B8-4264-87F7-7565D62CBDA9}"/>
          </ac:spMkLst>
        </pc:spChg>
        <pc:spChg chg="add mod">
          <ac:chgData name="酒井 優治" userId="af82edebe887f20f" providerId="LiveId" clId="{22C4BA42-4E19-4E70-8263-879C0FD9C514}" dt="2022-03-30T05:28:14.117" v="63"/>
          <ac:spMkLst>
            <pc:docMk/>
            <pc:sldMk cId="2246250910" sldId="299"/>
            <ac:spMk id="44" creationId="{4DF53F63-F708-4FD6-99A1-B824A81BCFB9}"/>
          </ac:spMkLst>
        </pc:spChg>
        <pc:spChg chg="add mod">
          <ac:chgData name="酒井 優治" userId="af82edebe887f20f" providerId="LiveId" clId="{22C4BA42-4E19-4E70-8263-879C0FD9C514}" dt="2022-03-30T05:28:14.117" v="63"/>
          <ac:spMkLst>
            <pc:docMk/>
            <pc:sldMk cId="2246250910" sldId="299"/>
            <ac:spMk id="45" creationId="{FF792879-D24E-45D4-9E4C-F466C4592225}"/>
          </ac:spMkLst>
        </pc:spChg>
        <pc:spChg chg="add mod">
          <ac:chgData name="酒井 優治" userId="af82edebe887f20f" providerId="LiveId" clId="{22C4BA42-4E19-4E70-8263-879C0FD9C514}" dt="2022-03-30T05:28:14.117" v="63"/>
          <ac:spMkLst>
            <pc:docMk/>
            <pc:sldMk cId="2246250910" sldId="299"/>
            <ac:spMk id="46" creationId="{81C11D6D-84B7-475C-ACA9-9B0CD2D361A3}"/>
          </ac:spMkLst>
        </pc:spChg>
        <pc:spChg chg="add mod">
          <ac:chgData name="酒井 優治" userId="af82edebe887f20f" providerId="LiveId" clId="{22C4BA42-4E19-4E70-8263-879C0FD9C514}" dt="2022-03-30T05:28:14.117" v="63"/>
          <ac:spMkLst>
            <pc:docMk/>
            <pc:sldMk cId="2246250910" sldId="299"/>
            <ac:spMk id="47" creationId="{D6B99FF7-4155-423E-A1C7-D64F2469BA14}"/>
          </ac:spMkLst>
        </pc:spChg>
        <pc:spChg chg="add mod">
          <ac:chgData name="酒井 優治" userId="af82edebe887f20f" providerId="LiveId" clId="{22C4BA42-4E19-4E70-8263-879C0FD9C514}" dt="2022-03-30T05:28:14.117" v="63"/>
          <ac:spMkLst>
            <pc:docMk/>
            <pc:sldMk cId="2246250910" sldId="299"/>
            <ac:spMk id="48" creationId="{319B2102-A87C-40CD-861D-9ADCB1A0790C}"/>
          </ac:spMkLst>
        </pc:spChg>
        <pc:spChg chg="add mod">
          <ac:chgData name="酒井 優治" userId="af82edebe887f20f" providerId="LiveId" clId="{22C4BA42-4E19-4E70-8263-879C0FD9C514}" dt="2022-03-30T05:28:14.117" v="63"/>
          <ac:spMkLst>
            <pc:docMk/>
            <pc:sldMk cId="2246250910" sldId="299"/>
            <ac:spMk id="49" creationId="{9B9B126F-6717-4E55-BF04-4EE1914133DB}"/>
          </ac:spMkLst>
        </pc:spChg>
        <pc:spChg chg="add mod">
          <ac:chgData name="酒井 優治" userId="af82edebe887f20f" providerId="LiveId" clId="{22C4BA42-4E19-4E70-8263-879C0FD9C514}" dt="2022-03-30T05:28:14.117" v="63"/>
          <ac:spMkLst>
            <pc:docMk/>
            <pc:sldMk cId="2246250910" sldId="299"/>
            <ac:spMk id="50" creationId="{A42FB813-143E-4BC0-8363-D14893DE9443}"/>
          </ac:spMkLst>
        </pc:spChg>
        <pc:spChg chg="add mod">
          <ac:chgData name="酒井 優治" userId="af82edebe887f20f" providerId="LiveId" clId="{22C4BA42-4E19-4E70-8263-879C0FD9C514}" dt="2022-03-30T05:28:14.117" v="63"/>
          <ac:spMkLst>
            <pc:docMk/>
            <pc:sldMk cId="2246250910" sldId="299"/>
            <ac:spMk id="51" creationId="{F0837909-C85C-42AB-8950-3EE5A8E37595}"/>
          </ac:spMkLst>
        </pc:spChg>
        <pc:spChg chg="mod">
          <ac:chgData name="酒井 優治" userId="af82edebe887f20f" providerId="LiveId" clId="{22C4BA42-4E19-4E70-8263-879C0FD9C514}" dt="2022-03-30T06:14:47.158" v="911" actId="14100"/>
          <ac:spMkLst>
            <pc:docMk/>
            <pc:sldMk cId="2246250910" sldId="299"/>
            <ac:spMk id="61" creationId="{EB21CE13-E22F-42C6-9276-06F663EF7211}"/>
          </ac:spMkLst>
        </pc:spChg>
        <pc:spChg chg="add del mod">
          <ac:chgData name="酒井 優治" userId="af82edebe887f20f" providerId="LiveId" clId="{22C4BA42-4E19-4E70-8263-879C0FD9C514}" dt="2022-03-30T05:31:18.476" v="115" actId="478"/>
          <ac:spMkLst>
            <pc:docMk/>
            <pc:sldMk cId="2246250910" sldId="299"/>
            <ac:spMk id="68" creationId="{A6FA6A81-5B37-47E7-9B80-6B94DDDB1B62}"/>
          </ac:spMkLst>
        </pc:spChg>
        <pc:spChg chg="del mod">
          <ac:chgData name="酒井 優治" userId="af82edebe887f20f" providerId="LiveId" clId="{22C4BA42-4E19-4E70-8263-879C0FD9C514}" dt="2022-03-30T05:34:25.084" v="156" actId="21"/>
          <ac:spMkLst>
            <pc:docMk/>
            <pc:sldMk cId="2246250910" sldId="299"/>
            <ac:spMk id="78" creationId="{977BF09E-32F2-4E79-AAFF-170A359EDACF}"/>
          </ac:spMkLst>
        </pc:spChg>
        <pc:spChg chg="add mod">
          <ac:chgData name="酒井 優治" userId="af82edebe887f20f" providerId="LiveId" clId="{22C4BA42-4E19-4E70-8263-879C0FD9C514}" dt="2022-03-30T05:35:01.163" v="195" actId="1038"/>
          <ac:spMkLst>
            <pc:docMk/>
            <pc:sldMk cId="2246250910" sldId="299"/>
            <ac:spMk id="80" creationId="{0D134F96-32FA-4385-A4C5-3BDF24E7B3B2}"/>
          </ac:spMkLst>
        </pc:spChg>
        <pc:grpChg chg="del">
          <ac:chgData name="酒井 優治" userId="af82edebe887f20f" providerId="LiveId" clId="{22C4BA42-4E19-4E70-8263-879C0FD9C514}" dt="2022-03-13T22:47:04.749" v="0" actId="478"/>
          <ac:grpSpMkLst>
            <pc:docMk/>
            <pc:sldMk cId="2246250910" sldId="299"/>
            <ac:grpSpMk id="3" creationId="{8BF5F705-A18E-4A01-98FE-02290A7D7D8A}"/>
          </ac:grpSpMkLst>
        </pc:grpChg>
        <pc:grpChg chg="add del mod">
          <ac:chgData name="酒井 優治" userId="af82edebe887f20f" providerId="LiveId" clId="{22C4BA42-4E19-4E70-8263-879C0FD9C514}" dt="2022-03-30T01:10:24.337" v="51" actId="478"/>
          <ac:grpSpMkLst>
            <pc:docMk/>
            <pc:sldMk cId="2246250910" sldId="299"/>
            <ac:grpSpMk id="8" creationId="{90176DCF-DD2E-432A-A6CD-0CA51914C947}"/>
          </ac:grpSpMkLst>
        </pc:grpChg>
        <pc:grpChg chg="add del mod">
          <ac:chgData name="酒井 優治" userId="af82edebe887f20f" providerId="LiveId" clId="{22C4BA42-4E19-4E70-8263-879C0FD9C514}" dt="2022-03-30T05:28:17.234" v="64" actId="478"/>
          <ac:grpSpMkLst>
            <pc:docMk/>
            <pc:sldMk cId="2246250910" sldId="299"/>
            <ac:grpSpMk id="34" creationId="{86A01D29-C88B-4DF9-A04A-CE99B798FE67}"/>
          </ac:grpSpMkLst>
        </pc:grpChg>
        <pc:grpChg chg="add mod">
          <ac:chgData name="酒井 優治" userId="af82edebe887f20f" providerId="LiveId" clId="{22C4BA42-4E19-4E70-8263-879C0FD9C514}" dt="2022-03-30T05:28:14.117" v="63"/>
          <ac:grpSpMkLst>
            <pc:docMk/>
            <pc:sldMk cId="2246250910" sldId="299"/>
            <ac:grpSpMk id="35" creationId="{4AEB26BC-4CC1-4FE5-8B91-8AC1B0A9200D}"/>
          </ac:grpSpMkLst>
        </pc:grpChg>
        <pc:grpChg chg="add mod">
          <ac:chgData name="酒井 優治" userId="af82edebe887f20f" providerId="LiveId" clId="{22C4BA42-4E19-4E70-8263-879C0FD9C514}" dt="2022-03-30T05:28:14.117" v="63"/>
          <ac:grpSpMkLst>
            <pc:docMk/>
            <pc:sldMk cId="2246250910" sldId="299"/>
            <ac:grpSpMk id="36" creationId="{CEFB3236-56C4-4DD8-98E1-A41A81032E5F}"/>
          </ac:grpSpMkLst>
        </pc:grpChg>
        <pc:grpChg chg="add mod">
          <ac:chgData name="酒井 優治" userId="af82edebe887f20f" providerId="LiveId" clId="{22C4BA42-4E19-4E70-8263-879C0FD9C514}" dt="2022-03-30T05:28:14.117" v="63"/>
          <ac:grpSpMkLst>
            <pc:docMk/>
            <pc:sldMk cId="2246250910" sldId="299"/>
            <ac:grpSpMk id="38" creationId="{1717A6FB-265D-494B-BD20-8ED3DBB49E0B}"/>
          </ac:grpSpMkLst>
        </pc:grpChg>
        <pc:grpChg chg="add mod">
          <ac:chgData name="酒井 優治" userId="af82edebe887f20f" providerId="LiveId" clId="{22C4BA42-4E19-4E70-8263-879C0FD9C514}" dt="2022-03-30T05:28:14.117" v="63"/>
          <ac:grpSpMkLst>
            <pc:docMk/>
            <pc:sldMk cId="2246250910" sldId="299"/>
            <ac:grpSpMk id="41" creationId="{15D7C387-5DFA-4AF4-AB59-0E50354F799C}"/>
          </ac:grpSpMkLst>
        </pc:grpChg>
        <pc:grpChg chg="add mod">
          <ac:chgData name="酒井 優治" userId="af82edebe887f20f" providerId="LiveId" clId="{22C4BA42-4E19-4E70-8263-879C0FD9C514}" dt="2022-03-30T05:28:14.117" v="63"/>
          <ac:grpSpMkLst>
            <pc:docMk/>
            <pc:sldMk cId="2246250910" sldId="299"/>
            <ac:grpSpMk id="43" creationId="{32E1A150-A5E9-43A1-8CAE-D19C70022D7A}"/>
          </ac:grpSpMkLst>
        </pc:grpChg>
        <pc:grpChg chg="add del mod">
          <ac:chgData name="酒井 優治" userId="af82edebe887f20f" providerId="LiveId" clId="{22C4BA42-4E19-4E70-8263-879C0FD9C514}" dt="2022-03-30T05:34:58.351" v="192" actId="478"/>
          <ac:grpSpMkLst>
            <pc:docMk/>
            <pc:sldMk cId="2246250910" sldId="299"/>
            <ac:grpSpMk id="72" creationId="{81E4D6F0-5EF5-46BF-8946-2B659D87FEF4}"/>
          </ac:grpSpMkLst>
        </pc:grpChg>
        <pc:grpChg chg="mod">
          <ac:chgData name="酒井 優治" userId="af82edebe887f20f" providerId="LiveId" clId="{22C4BA42-4E19-4E70-8263-879C0FD9C514}" dt="2022-03-30T05:33:51.892" v="148"/>
          <ac:grpSpMkLst>
            <pc:docMk/>
            <pc:sldMk cId="2246250910" sldId="299"/>
            <ac:grpSpMk id="75" creationId="{85AD9905-5AD9-48F1-8852-1B25856ECDE5}"/>
          </ac:grpSpMkLst>
        </pc:grpChg>
        <pc:picChg chg="add del mod">
          <ac:chgData name="酒井 優治" userId="af82edebe887f20f" providerId="LiveId" clId="{22C4BA42-4E19-4E70-8263-879C0FD9C514}" dt="2022-03-30T05:28:23.218" v="66" actId="478"/>
          <ac:picMkLst>
            <pc:docMk/>
            <pc:sldMk cId="2246250910" sldId="299"/>
            <ac:picMk id="3" creationId="{6D56878A-D322-47F4-91E7-7B38C1D92422}"/>
          </ac:picMkLst>
        </pc:picChg>
        <pc:picChg chg="add mod modCrop">
          <ac:chgData name="酒井 優治" userId="af82edebe887f20f" providerId="LiveId" clId="{22C4BA42-4E19-4E70-8263-879C0FD9C514}" dt="2022-03-30T05:38:02.912" v="905" actId="1366"/>
          <ac:picMkLst>
            <pc:docMk/>
            <pc:sldMk cId="2246250910" sldId="299"/>
            <ac:picMk id="5" creationId="{1AF38D4B-0A29-4145-B576-B46E171C76A6}"/>
          </ac:picMkLst>
        </pc:picChg>
        <pc:picChg chg="mod">
          <ac:chgData name="酒井 優治" userId="af82edebe887f20f" providerId="LiveId" clId="{22C4BA42-4E19-4E70-8263-879C0FD9C514}" dt="2022-03-15T10:24:20.569" v="36"/>
          <ac:picMkLst>
            <pc:docMk/>
            <pc:sldMk cId="2246250910" sldId="299"/>
            <ac:picMk id="9" creationId="{64534635-00F1-4441-9674-DD864A1C3517}"/>
          </ac:picMkLst>
        </pc:picChg>
        <pc:picChg chg="add del mod">
          <ac:chgData name="酒井 優治" userId="af82edebe887f20f" providerId="LiveId" clId="{22C4BA42-4E19-4E70-8263-879C0FD9C514}" dt="2022-03-30T01:10:24.337" v="51" actId="478"/>
          <ac:picMkLst>
            <pc:docMk/>
            <pc:sldMk cId="2246250910" sldId="299"/>
            <ac:picMk id="11" creationId="{0410414E-DFDF-4714-95E8-0EB3C2DD23AF}"/>
          </ac:picMkLst>
        </pc:picChg>
        <pc:picChg chg="add del mod">
          <ac:chgData name="酒井 優治" userId="af82edebe887f20f" providerId="LiveId" clId="{22C4BA42-4E19-4E70-8263-879C0FD9C514}" dt="2022-03-30T01:10:24.337" v="51" actId="478"/>
          <ac:picMkLst>
            <pc:docMk/>
            <pc:sldMk cId="2246250910" sldId="299"/>
            <ac:picMk id="12" creationId="{A8EC23FD-ADB8-45B0-B441-643F6EDE2CE4}"/>
          </ac:picMkLst>
        </pc:picChg>
        <pc:picChg chg="add mod ord modCrop">
          <ac:chgData name="酒井 優治" userId="af82edebe887f20f" providerId="LiveId" clId="{22C4BA42-4E19-4E70-8263-879C0FD9C514}" dt="2022-03-30T05:38:07.526" v="906" actId="1366"/>
          <ac:picMkLst>
            <pc:docMk/>
            <pc:sldMk cId="2246250910" sldId="299"/>
            <ac:picMk id="65" creationId="{407250B4-F3AA-4122-9DA0-5B8D9C29E4BB}"/>
          </ac:picMkLst>
        </pc:picChg>
        <pc:picChg chg="add mod modCrop">
          <ac:chgData name="酒井 優治" userId="af82edebe887f20f" providerId="LiveId" clId="{22C4BA42-4E19-4E70-8263-879C0FD9C514}" dt="2022-03-30T05:33:00.370" v="147" actId="1076"/>
          <ac:picMkLst>
            <pc:docMk/>
            <pc:sldMk cId="2246250910" sldId="299"/>
            <ac:picMk id="69" creationId="{9E8F5F08-CDC3-4899-A7BF-1CABA6039D1E}"/>
          </ac:picMkLst>
        </pc:picChg>
        <pc:picChg chg="add mod modCrop">
          <ac:chgData name="酒井 優治" userId="af82edebe887f20f" providerId="LiveId" clId="{22C4BA42-4E19-4E70-8263-879C0FD9C514}" dt="2022-03-30T05:33:00.370" v="147" actId="1076"/>
          <ac:picMkLst>
            <pc:docMk/>
            <pc:sldMk cId="2246250910" sldId="299"/>
            <ac:picMk id="71" creationId="{56436CA7-7F11-4C57-B751-7DF1DAAA8E91}"/>
          </ac:picMkLst>
        </pc:picChg>
        <pc:picChg chg="mod">
          <ac:chgData name="酒井 優治" userId="af82edebe887f20f" providerId="LiveId" clId="{22C4BA42-4E19-4E70-8263-879C0FD9C514}" dt="2022-03-30T05:33:51.892" v="148"/>
          <ac:picMkLst>
            <pc:docMk/>
            <pc:sldMk cId="2246250910" sldId="299"/>
            <ac:picMk id="73" creationId="{19010FD5-0351-46D1-A9FF-A3192856F7F3}"/>
          </ac:picMkLst>
        </pc:picChg>
        <pc:picChg chg="mod">
          <ac:chgData name="酒井 優治" userId="af82edebe887f20f" providerId="LiveId" clId="{22C4BA42-4E19-4E70-8263-879C0FD9C514}" dt="2022-03-30T05:33:51.892" v="148"/>
          <ac:picMkLst>
            <pc:docMk/>
            <pc:sldMk cId="2246250910" sldId="299"/>
            <ac:picMk id="74" creationId="{B1B335DC-A00E-4DF3-B9B1-6B2F97D4D6BB}"/>
          </ac:picMkLst>
        </pc:picChg>
        <pc:picChg chg="mod">
          <ac:chgData name="酒井 優治" userId="af82edebe887f20f" providerId="LiveId" clId="{22C4BA42-4E19-4E70-8263-879C0FD9C514}" dt="2022-03-30T05:33:51.892" v="148"/>
          <ac:picMkLst>
            <pc:docMk/>
            <pc:sldMk cId="2246250910" sldId="299"/>
            <ac:picMk id="76" creationId="{0EA4BB73-64A3-4797-B01B-D2DA8E480BAF}"/>
          </ac:picMkLst>
        </pc:picChg>
        <pc:picChg chg="mod">
          <ac:chgData name="酒井 優治" userId="af82edebe887f20f" providerId="LiveId" clId="{22C4BA42-4E19-4E70-8263-879C0FD9C514}" dt="2022-03-30T05:33:51.892" v="148"/>
          <ac:picMkLst>
            <pc:docMk/>
            <pc:sldMk cId="2246250910" sldId="299"/>
            <ac:picMk id="77" creationId="{0CF95E12-8F47-4E63-87A9-E6850D94B509}"/>
          </ac:picMkLst>
        </pc:picChg>
        <pc:picChg chg="add del mod modCrop">
          <ac:chgData name="酒井 優治" userId="af82edebe887f20f" providerId="LiveId" clId="{22C4BA42-4E19-4E70-8263-879C0FD9C514}" dt="2022-03-30T05:34:44.953" v="184" actId="478"/>
          <ac:picMkLst>
            <pc:docMk/>
            <pc:sldMk cId="2246250910" sldId="299"/>
            <ac:picMk id="79" creationId="{DBD35007-2480-4F90-9383-687E8E80F257}"/>
          </ac:picMkLst>
        </pc:picChg>
        <pc:cxnChg chg="add del mod">
          <ac:chgData name="酒井 優治" userId="af82edebe887f20f" providerId="LiveId" clId="{22C4BA42-4E19-4E70-8263-879C0FD9C514}" dt="2022-03-30T05:28:17.234" v="64" actId="478"/>
          <ac:cxnSpMkLst>
            <pc:docMk/>
            <pc:sldMk cId="2246250910" sldId="299"/>
            <ac:cxnSpMk id="11" creationId="{CE9A4955-C2D4-45C7-86D6-9F7C24975C30}"/>
          </ac:cxnSpMkLst>
        </pc:cxnChg>
        <pc:cxnChg chg="add del mod">
          <ac:chgData name="酒井 優治" userId="af82edebe887f20f" providerId="LiveId" clId="{22C4BA42-4E19-4E70-8263-879C0FD9C514}" dt="2022-03-30T05:28:17.234" v="64" actId="478"/>
          <ac:cxnSpMkLst>
            <pc:docMk/>
            <pc:sldMk cId="2246250910" sldId="299"/>
            <ac:cxnSpMk id="13" creationId="{E6405D16-3E1B-4342-8FE4-06202E7F0BD7}"/>
          </ac:cxnSpMkLst>
        </pc:cxnChg>
        <pc:cxnChg chg="add mod">
          <ac:chgData name="酒井 優治" userId="af82edebe887f20f" providerId="LiveId" clId="{22C4BA42-4E19-4E70-8263-879C0FD9C514}" dt="2022-03-30T05:28:14.117" v="63"/>
          <ac:cxnSpMkLst>
            <pc:docMk/>
            <pc:sldMk cId="2246250910" sldId="299"/>
            <ac:cxnSpMk id="52" creationId="{35EF78AF-8744-4AB1-B38E-D288ACD2A3BD}"/>
          </ac:cxnSpMkLst>
        </pc:cxnChg>
        <pc:cxnChg chg="add mod">
          <ac:chgData name="酒井 優治" userId="af82edebe887f20f" providerId="LiveId" clId="{22C4BA42-4E19-4E70-8263-879C0FD9C514}" dt="2022-03-30T05:28:14.117" v="63"/>
          <ac:cxnSpMkLst>
            <pc:docMk/>
            <pc:sldMk cId="2246250910" sldId="299"/>
            <ac:cxnSpMk id="53" creationId="{A195FA7F-BB13-406A-8F53-6B6212105FD9}"/>
          </ac:cxnSpMkLst>
        </pc:cxnChg>
        <pc:cxnChg chg="add mod">
          <ac:chgData name="酒井 優治" userId="af82edebe887f20f" providerId="LiveId" clId="{22C4BA42-4E19-4E70-8263-879C0FD9C514}" dt="2022-03-30T05:28:14.117" v="63"/>
          <ac:cxnSpMkLst>
            <pc:docMk/>
            <pc:sldMk cId="2246250910" sldId="299"/>
            <ac:cxnSpMk id="54" creationId="{26D34FAE-3F76-49D9-9475-12B44DE1A2EF}"/>
          </ac:cxnSpMkLst>
        </pc:cxnChg>
        <pc:cxnChg chg="add mod">
          <ac:chgData name="酒井 優治" userId="af82edebe887f20f" providerId="LiveId" clId="{22C4BA42-4E19-4E70-8263-879C0FD9C514}" dt="2022-03-30T05:28:14.117" v="63"/>
          <ac:cxnSpMkLst>
            <pc:docMk/>
            <pc:sldMk cId="2246250910" sldId="299"/>
            <ac:cxnSpMk id="55" creationId="{FD58E3AE-0372-47AE-9798-389AE2994236}"/>
          </ac:cxnSpMkLst>
        </pc:cxnChg>
        <pc:cxnChg chg="add mod">
          <ac:chgData name="酒井 優治" userId="af82edebe887f20f" providerId="LiveId" clId="{22C4BA42-4E19-4E70-8263-879C0FD9C514}" dt="2022-03-30T05:28:14.117" v="63"/>
          <ac:cxnSpMkLst>
            <pc:docMk/>
            <pc:sldMk cId="2246250910" sldId="299"/>
            <ac:cxnSpMk id="56" creationId="{18114AEB-F094-4400-B41B-FAF2D8530389}"/>
          </ac:cxnSpMkLst>
        </pc:cxnChg>
        <pc:cxnChg chg="add mod">
          <ac:chgData name="酒井 優治" userId="af82edebe887f20f" providerId="LiveId" clId="{22C4BA42-4E19-4E70-8263-879C0FD9C514}" dt="2022-03-30T05:28:14.117" v="63"/>
          <ac:cxnSpMkLst>
            <pc:docMk/>
            <pc:sldMk cId="2246250910" sldId="299"/>
            <ac:cxnSpMk id="57" creationId="{70D64C0A-B35A-4837-8FD2-8FDBE5D55958}"/>
          </ac:cxnSpMkLst>
        </pc:cxnChg>
        <pc:cxnChg chg="add mod">
          <ac:chgData name="酒井 優治" userId="af82edebe887f20f" providerId="LiveId" clId="{22C4BA42-4E19-4E70-8263-879C0FD9C514}" dt="2022-03-30T05:28:14.117" v="63"/>
          <ac:cxnSpMkLst>
            <pc:docMk/>
            <pc:sldMk cId="2246250910" sldId="299"/>
            <ac:cxnSpMk id="58" creationId="{068456DF-940C-4C57-AE22-7FF86211D742}"/>
          </ac:cxnSpMkLst>
        </pc:cxnChg>
        <pc:cxnChg chg="add mod">
          <ac:chgData name="酒井 優治" userId="af82edebe887f20f" providerId="LiveId" clId="{22C4BA42-4E19-4E70-8263-879C0FD9C514}" dt="2022-03-30T05:28:14.117" v="63"/>
          <ac:cxnSpMkLst>
            <pc:docMk/>
            <pc:sldMk cId="2246250910" sldId="299"/>
            <ac:cxnSpMk id="60" creationId="{B884586E-108A-418B-B9A0-13FF072496DC}"/>
          </ac:cxnSpMkLst>
        </pc:cxnChg>
        <pc:cxnChg chg="add mod">
          <ac:chgData name="酒井 優治" userId="af82edebe887f20f" providerId="LiveId" clId="{22C4BA42-4E19-4E70-8263-879C0FD9C514}" dt="2022-03-30T05:28:14.117" v="63"/>
          <ac:cxnSpMkLst>
            <pc:docMk/>
            <pc:sldMk cId="2246250910" sldId="299"/>
            <ac:cxnSpMk id="62" creationId="{ADCFF14D-25A6-4EBC-A823-1C89118F64BF}"/>
          </ac:cxnSpMkLst>
        </pc:cxnChg>
        <pc:cxnChg chg="add mod">
          <ac:chgData name="酒井 優治" userId="af82edebe887f20f" providerId="LiveId" clId="{22C4BA42-4E19-4E70-8263-879C0FD9C514}" dt="2022-03-30T05:28:14.117" v="63"/>
          <ac:cxnSpMkLst>
            <pc:docMk/>
            <pc:sldMk cId="2246250910" sldId="299"/>
            <ac:cxnSpMk id="63" creationId="{FF4495DA-4747-4056-99D2-C8A55FE4DD5C}"/>
          </ac:cxnSpMkLst>
        </pc:cxnChg>
        <pc:cxnChg chg="add mod">
          <ac:chgData name="酒井 優治" userId="af82edebe887f20f" providerId="LiveId" clId="{22C4BA42-4E19-4E70-8263-879C0FD9C514}" dt="2022-03-30T05:33:00.370" v="147" actId="1076"/>
          <ac:cxnSpMkLst>
            <pc:docMk/>
            <pc:sldMk cId="2246250910" sldId="299"/>
            <ac:cxnSpMk id="67" creationId="{704ECDE3-12C3-42D9-9437-1CAE8D6B9D9C}"/>
          </ac:cxnSpMkLst>
        </pc:cxnChg>
        <pc:cxnChg chg="add mod">
          <ac:chgData name="酒井 優治" userId="af82edebe887f20f" providerId="LiveId" clId="{22C4BA42-4E19-4E70-8263-879C0FD9C514}" dt="2022-03-30T05:33:00.370" v="147" actId="1076"/>
          <ac:cxnSpMkLst>
            <pc:docMk/>
            <pc:sldMk cId="2246250910" sldId="299"/>
            <ac:cxnSpMk id="70" creationId="{B0B121F0-DA4F-41F9-ACE3-A8EB405928BC}"/>
          </ac:cxnSpMkLst>
        </pc:cxnChg>
      </pc:sldChg>
      <pc:sldChg chg="addSp delSp modSp add mod">
        <pc:chgData name="酒井 優治" userId="af82edebe887f20f" providerId="LiveId" clId="{22C4BA42-4E19-4E70-8263-879C0FD9C514}" dt="2022-03-30T23:37:20.982" v="947" actId="1076"/>
        <pc:sldMkLst>
          <pc:docMk/>
          <pc:sldMk cId="889158849" sldId="300"/>
        </pc:sldMkLst>
        <pc:picChg chg="mod">
          <ac:chgData name="酒井 優治" userId="af82edebe887f20f" providerId="LiveId" clId="{22C4BA42-4E19-4E70-8263-879C0FD9C514}" dt="2022-03-30T23:37:17.958" v="945" actId="1076"/>
          <ac:picMkLst>
            <pc:docMk/>
            <pc:sldMk cId="889158849" sldId="300"/>
            <ac:picMk id="5" creationId="{11D10CE9-0D38-4D6B-9729-23C5A6E7172C}"/>
          </ac:picMkLst>
        </pc:picChg>
        <pc:picChg chg="add del mod">
          <ac:chgData name="酒井 優治" userId="af82edebe887f20f" providerId="LiveId" clId="{22C4BA42-4E19-4E70-8263-879C0FD9C514}" dt="2022-03-30T07:31:40.764" v="934"/>
          <ac:picMkLst>
            <pc:docMk/>
            <pc:sldMk cId="889158849" sldId="300"/>
            <ac:picMk id="6" creationId="{0A6B17A9-1CB8-4C7C-AB74-9702796B8B1B}"/>
          </ac:picMkLst>
        </pc:picChg>
        <pc:picChg chg="del">
          <ac:chgData name="酒井 優治" userId="af82edebe887f20f" providerId="LiveId" clId="{22C4BA42-4E19-4E70-8263-879C0FD9C514}" dt="2022-03-29T09:22:32.130" v="46" actId="478"/>
          <ac:picMkLst>
            <pc:docMk/>
            <pc:sldMk cId="889158849" sldId="300"/>
            <ac:picMk id="6" creationId="{3FAF1668-B04C-4CA4-98AA-28C177DBFAD0}"/>
          </ac:picMkLst>
        </pc:picChg>
        <pc:picChg chg="add mod">
          <ac:chgData name="酒井 優治" userId="af82edebe887f20f" providerId="LiveId" clId="{22C4BA42-4E19-4E70-8263-879C0FD9C514}" dt="2022-03-30T23:37:20.982" v="947" actId="1076"/>
          <ac:picMkLst>
            <pc:docMk/>
            <pc:sldMk cId="889158849" sldId="300"/>
            <ac:picMk id="7" creationId="{10124C59-E056-41CD-94BC-56B9322259E3}"/>
          </ac:picMkLst>
        </pc:picChg>
      </pc:sldChg>
      <pc:sldChg chg="add">
        <pc:chgData name="酒井 優治" userId="af82edebe887f20f" providerId="LiveId" clId="{22C4BA42-4E19-4E70-8263-879C0FD9C514}" dt="2022-03-30T05:28:20.400" v="65"/>
        <pc:sldMkLst>
          <pc:docMk/>
          <pc:sldMk cId="3617991554" sldId="301"/>
        </pc:sldMkLst>
      </pc:sldChg>
      <pc:sldChg chg="addSp delSp modSp add mod">
        <pc:chgData name="酒井 優治" userId="af82edebe887f20f" providerId="LiveId" clId="{22C4BA42-4E19-4E70-8263-879C0FD9C514}" dt="2022-03-30T23:37:14.723" v="944" actId="1076"/>
        <pc:sldMkLst>
          <pc:docMk/>
          <pc:sldMk cId="1014723978" sldId="302"/>
        </pc:sldMkLst>
        <pc:picChg chg="del">
          <ac:chgData name="酒井 優治" userId="af82edebe887f20f" providerId="LiveId" clId="{22C4BA42-4E19-4E70-8263-879C0FD9C514}" dt="2022-03-30T06:38:55.631" v="919" actId="478"/>
          <ac:picMkLst>
            <pc:docMk/>
            <pc:sldMk cId="1014723978" sldId="302"/>
            <ac:picMk id="3" creationId="{9D9AD12F-5AF5-4E8E-8F51-40049E0F2DAE}"/>
          </ac:picMkLst>
        </pc:picChg>
        <pc:picChg chg="add mod">
          <ac:chgData name="酒井 優治" userId="af82edebe887f20f" providerId="LiveId" clId="{22C4BA42-4E19-4E70-8263-879C0FD9C514}" dt="2022-03-30T23:37:14.723" v="944" actId="1076"/>
          <ac:picMkLst>
            <pc:docMk/>
            <pc:sldMk cId="1014723978" sldId="302"/>
            <ac:picMk id="7" creationId="{22EB307A-7006-4B88-A529-A543BB4BA2BC}"/>
          </ac:picMkLst>
        </pc:picChg>
        <pc:picChg chg="add del mod">
          <ac:chgData name="酒井 優治" userId="af82edebe887f20f" providerId="LiveId" clId="{22C4BA42-4E19-4E70-8263-879C0FD9C514}" dt="2022-03-30T07:31:43.386" v="939"/>
          <ac:picMkLst>
            <pc:docMk/>
            <pc:sldMk cId="1014723978" sldId="302"/>
            <ac:picMk id="8" creationId="{19F8C354-0173-402E-AE28-16BCE432B2A7}"/>
          </ac:picMkLst>
        </pc:picChg>
        <pc:picChg chg="add del mod">
          <ac:chgData name="酒井 優治" userId="af82edebe887f20f" providerId="LiveId" clId="{22C4BA42-4E19-4E70-8263-879C0FD9C514}" dt="2022-03-30T23:37:12.935" v="943" actId="21"/>
          <ac:picMkLst>
            <pc:docMk/>
            <pc:sldMk cId="1014723978" sldId="302"/>
            <ac:picMk id="9" creationId="{D2FD5908-C957-41A8-B3E3-D23E94D806D0}"/>
          </ac:picMkLst>
        </pc:picChg>
      </pc:sldChg>
    </pc:docChg>
  </pc:docChgLst>
  <pc:docChgLst>
    <pc:chgData name="酒井 優治" userId="af82edebe887f20f" providerId="LiveId" clId="{5E29B9ED-BA76-4833-8341-18FBB4455910}"/>
    <pc:docChg chg="undo custSel addSld delSld modSld">
      <pc:chgData name="酒井 優治" userId="af82edebe887f20f" providerId="LiveId" clId="{5E29B9ED-BA76-4833-8341-18FBB4455910}" dt="2023-09-01T04:41:51.477" v="461" actId="20577"/>
      <pc:docMkLst>
        <pc:docMk/>
      </pc:docMkLst>
      <pc:sldChg chg="addSp delSp modSp mod">
        <pc:chgData name="酒井 優治" userId="af82edebe887f20f" providerId="LiveId" clId="{5E29B9ED-BA76-4833-8341-18FBB4455910}" dt="2023-09-01T04:41:51.477" v="461" actId="20577"/>
        <pc:sldMkLst>
          <pc:docMk/>
          <pc:sldMk cId="1889218569" sldId="270"/>
        </pc:sldMkLst>
        <pc:spChg chg="add mod">
          <ac:chgData name="酒井 優治" userId="af82edebe887f20f" providerId="LiveId" clId="{5E29B9ED-BA76-4833-8341-18FBB4455910}" dt="2023-08-29T08:06:24.703" v="427" actId="2711"/>
          <ac:spMkLst>
            <pc:docMk/>
            <pc:sldMk cId="1889218569" sldId="270"/>
            <ac:spMk id="4" creationId="{4FB47D94-5F97-2C07-3617-65689B9061DA}"/>
          </ac:spMkLst>
        </pc:spChg>
        <pc:spChg chg="mod">
          <ac:chgData name="酒井 優治" userId="af82edebe887f20f" providerId="LiveId" clId="{5E29B9ED-BA76-4833-8341-18FBB4455910}" dt="2023-08-29T08:00:16.902" v="273" actId="20577"/>
          <ac:spMkLst>
            <pc:docMk/>
            <pc:sldMk cId="1889218569" sldId="270"/>
            <ac:spMk id="5" creationId="{3C999F1F-C335-4B41-ADA4-E58A5F7320BD}"/>
          </ac:spMkLst>
        </pc:spChg>
        <pc:spChg chg="mod">
          <ac:chgData name="酒井 優治" userId="af82edebe887f20f" providerId="LiveId" clId="{5E29B9ED-BA76-4833-8341-18FBB4455910}" dt="2023-09-01T04:41:51.477" v="461" actId="20577"/>
          <ac:spMkLst>
            <pc:docMk/>
            <pc:sldMk cId="1889218569" sldId="270"/>
            <ac:spMk id="6" creationId="{1DB06248-0732-43EE-BAA1-CC609C15D738}"/>
          </ac:spMkLst>
        </pc:spChg>
        <pc:spChg chg="del">
          <ac:chgData name="酒井 優治" userId="af82edebe887f20f" providerId="LiveId" clId="{5E29B9ED-BA76-4833-8341-18FBB4455910}" dt="2023-08-29T07:50:15.741" v="83" actId="478"/>
          <ac:spMkLst>
            <pc:docMk/>
            <pc:sldMk cId="1889218569" sldId="270"/>
            <ac:spMk id="7" creationId="{FD80B1FF-B366-4C43-BBF5-79CEB9426ABC}"/>
          </ac:spMkLst>
        </pc:spChg>
        <pc:spChg chg="del">
          <ac:chgData name="酒井 優治" userId="af82edebe887f20f" providerId="LiveId" clId="{5E29B9ED-BA76-4833-8341-18FBB4455910}" dt="2023-08-29T07:50:15.741" v="83" actId="478"/>
          <ac:spMkLst>
            <pc:docMk/>
            <pc:sldMk cId="1889218569" sldId="270"/>
            <ac:spMk id="8" creationId="{50FFAE18-3097-4B39-B9A9-0FC4A2D491BA}"/>
          </ac:spMkLst>
        </pc:spChg>
        <pc:spChg chg="add mod">
          <ac:chgData name="酒井 優治" userId="af82edebe887f20f" providerId="LiveId" clId="{5E29B9ED-BA76-4833-8341-18FBB4455910}" dt="2023-08-29T08:09:04.692" v="453" actId="14100"/>
          <ac:spMkLst>
            <pc:docMk/>
            <pc:sldMk cId="1889218569" sldId="270"/>
            <ac:spMk id="9" creationId="{3D789386-9D39-A1AE-EEEE-0932121DFB9C}"/>
          </ac:spMkLst>
        </pc:spChg>
        <pc:picChg chg="del mod">
          <ac:chgData name="酒井 優治" userId="af82edebe887f20f" providerId="LiveId" clId="{5E29B9ED-BA76-4833-8341-18FBB4455910}" dt="2023-08-29T07:59:24.763" v="249" actId="478"/>
          <ac:picMkLst>
            <pc:docMk/>
            <pc:sldMk cId="1889218569" sldId="270"/>
            <ac:picMk id="2" creationId="{DB353A91-1ED3-1A41-A1EC-07F54DD8B3AA}"/>
          </ac:picMkLst>
        </pc:picChg>
        <pc:picChg chg="del mod">
          <ac:chgData name="酒井 優治" userId="af82edebe887f20f" providerId="LiveId" clId="{5E29B9ED-BA76-4833-8341-18FBB4455910}" dt="2023-08-29T07:58:55.632" v="246" actId="478"/>
          <ac:picMkLst>
            <pc:docMk/>
            <pc:sldMk cId="1889218569" sldId="270"/>
            <ac:picMk id="3" creationId="{2A4995AD-5500-152D-CB14-91DDE17EE7F3}"/>
          </ac:picMkLst>
        </pc:picChg>
        <pc:picChg chg="add del mod">
          <ac:chgData name="酒井 優治" userId="af82edebe887f20f" providerId="LiveId" clId="{5E29B9ED-BA76-4833-8341-18FBB4455910}" dt="2023-08-29T08:08:09.121" v="428" actId="478"/>
          <ac:picMkLst>
            <pc:docMk/>
            <pc:sldMk cId="1889218569" sldId="270"/>
            <ac:picMk id="10" creationId="{C970B49A-D29D-959A-EA96-2E837071B4C8}"/>
          </ac:picMkLst>
        </pc:picChg>
        <pc:picChg chg="add mod">
          <ac:chgData name="酒井 優治" userId="af82edebe887f20f" providerId="LiveId" clId="{5E29B9ED-BA76-4833-8341-18FBB4455910}" dt="2023-08-29T07:59:03.559" v="248" actId="1076"/>
          <ac:picMkLst>
            <pc:docMk/>
            <pc:sldMk cId="1889218569" sldId="270"/>
            <ac:picMk id="11" creationId="{B693DC0C-E906-C3AE-8375-9B88B2456500}"/>
          </ac:picMkLst>
        </pc:picChg>
        <pc:picChg chg="add mod">
          <ac:chgData name="酒井 優治" userId="af82edebe887f20f" providerId="LiveId" clId="{5E29B9ED-BA76-4833-8341-18FBB4455910}" dt="2023-08-29T07:59:33.564" v="251" actId="1076"/>
          <ac:picMkLst>
            <pc:docMk/>
            <pc:sldMk cId="1889218569" sldId="270"/>
            <ac:picMk id="12" creationId="{48AFA20C-1DC5-067C-0AEB-6C4F111D7D0E}"/>
          </ac:picMkLst>
        </pc:picChg>
        <pc:picChg chg="add mod">
          <ac:chgData name="酒井 優治" userId="af82edebe887f20f" providerId="LiveId" clId="{5E29B9ED-BA76-4833-8341-18FBB4455910}" dt="2023-08-29T08:08:20.609" v="431" actId="1076"/>
          <ac:picMkLst>
            <pc:docMk/>
            <pc:sldMk cId="1889218569" sldId="270"/>
            <ac:picMk id="13" creationId="{5D488124-16DE-465A-D9EE-9F6EC0094A42}"/>
          </ac:picMkLst>
        </pc:picChg>
      </pc:sldChg>
      <pc:sldChg chg="modSp add mod">
        <pc:chgData name="酒井 優治" userId="af82edebe887f20f" providerId="LiveId" clId="{5E29B9ED-BA76-4833-8341-18FBB4455910}" dt="2023-09-01T04:41:37.288" v="460" actId="120"/>
        <pc:sldMkLst>
          <pc:docMk/>
          <pc:sldMk cId="2035010568" sldId="271"/>
        </pc:sldMkLst>
        <pc:spChg chg="mod">
          <ac:chgData name="酒井 優治" userId="af82edebe887f20f" providerId="LiveId" clId="{5E29B9ED-BA76-4833-8341-18FBB4455910}" dt="2023-09-01T04:41:37.288" v="460" actId="120"/>
          <ac:spMkLst>
            <pc:docMk/>
            <pc:sldMk cId="2035010568" sldId="271"/>
            <ac:spMk id="4" creationId="{A5EBB3A2-3DDB-4131-B1A0-A870C43C6D39}"/>
          </ac:spMkLst>
        </pc:spChg>
        <pc:spChg chg="mod">
          <ac:chgData name="酒井 優治" userId="af82edebe887f20f" providerId="LiveId" clId="{5E29B9ED-BA76-4833-8341-18FBB4455910}" dt="2023-08-29T07:49:58.933" v="82" actId="20577"/>
          <ac:spMkLst>
            <pc:docMk/>
            <pc:sldMk cId="2035010568" sldId="271"/>
            <ac:spMk id="61" creationId="{EB21CE13-E22F-42C6-9276-06F663EF7211}"/>
          </ac:spMkLst>
        </pc:spChg>
      </pc:sldChg>
      <pc:sldChg chg="del">
        <pc:chgData name="酒井 優治" userId="af82edebe887f20f" providerId="LiveId" clId="{5E29B9ED-BA76-4833-8341-18FBB4455910}" dt="2023-08-29T07:50:48.830" v="87" actId="47"/>
        <pc:sldMkLst>
          <pc:docMk/>
          <pc:sldMk cId="889158849" sldId="300"/>
        </pc:sldMkLst>
      </pc:sldChg>
    </pc:docChg>
  </pc:docChgLst>
  <pc:docChgLst>
    <pc:chgData name="酒井 優治" userId="af82edebe887f20f" providerId="LiveId" clId="{09180B15-C956-4E6F-B8B9-D602D6DE1356}"/>
    <pc:docChg chg="undo redo custSel addSld delSld modSld sldOrd">
      <pc:chgData name="酒井 優治" userId="af82edebe887f20f" providerId="LiveId" clId="{09180B15-C956-4E6F-B8B9-D602D6DE1356}" dt="2022-04-04T00:57:07.446" v="1256" actId="6549"/>
      <pc:docMkLst>
        <pc:docMk/>
      </pc:docMkLst>
      <pc:sldChg chg="addSp modSp mod ord">
        <pc:chgData name="酒井 優治" userId="af82edebe887f20f" providerId="LiveId" clId="{09180B15-C956-4E6F-B8B9-D602D6DE1356}" dt="2022-04-04T00:57:07.446" v="1256" actId="6549"/>
        <pc:sldMkLst>
          <pc:docMk/>
          <pc:sldMk cId="2696857125" sldId="266"/>
        </pc:sldMkLst>
        <pc:spChg chg="mod">
          <ac:chgData name="酒井 優治" userId="af82edebe887f20f" providerId="LiveId" clId="{09180B15-C956-4E6F-B8B9-D602D6DE1356}" dt="2022-04-01T03:34:40.374" v="1235" actId="114"/>
          <ac:spMkLst>
            <pc:docMk/>
            <pc:sldMk cId="2696857125" sldId="266"/>
            <ac:spMk id="3" creationId="{11A45509-B403-46FA-A109-7531958C33A6}"/>
          </ac:spMkLst>
        </pc:spChg>
        <pc:spChg chg="mod">
          <ac:chgData name="酒井 優治" userId="af82edebe887f20f" providerId="LiveId" clId="{09180B15-C956-4E6F-B8B9-D602D6DE1356}" dt="2022-04-04T00:57:07.446" v="1256" actId="6549"/>
          <ac:spMkLst>
            <pc:docMk/>
            <pc:sldMk cId="2696857125" sldId="266"/>
            <ac:spMk id="4" creationId="{B0465965-2CE3-4D93-8425-4A901A95AFFA}"/>
          </ac:spMkLst>
        </pc:spChg>
        <pc:spChg chg="add mod">
          <ac:chgData name="酒井 優治" userId="af82edebe887f20f" providerId="LiveId" clId="{09180B15-C956-4E6F-B8B9-D602D6DE1356}" dt="2022-03-31T06:19:47.949" v="867"/>
          <ac:spMkLst>
            <pc:docMk/>
            <pc:sldMk cId="2696857125" sldId="266"/>
            <ac:spMk id="5" creationId="{041F7DBE-FE29-4B74-8795-A6BDB574FBEB}"/>
          </ac:spMkLst>
        </pc:spChg>
        <pc:spChg chg="add mod">
          <ac:chgData name="酒井 優治" userId="af82edebe887f20f" providerId="LiveId" clId="{09180B15-C956-4E6F-B8B9-D602D6DE1356}" dt="2022-03-31T06:19:47.949" v="867"/>
          <ac:spMkLst>
            <pc:docMk/>
            <pc:sldMk cId="2696857125" sldId="266"/>
            <ac:spMk id="6" creationId="{E1663C06-BE58-45A3-BD6D-8B58A6CA4446}"/>
          </ac:spMkLst>
        </pc:spChg>
        <pc:spChg chg="add mod">
          <ac:chgData name="酒井 優治" userId="af82edebe887f20f" providerId="LiveId" clId="{09180B15-C956-4E6F-B8B9-D602D6DE1356}" dt="2022-04-01T03:35:20.623" v="1238" actId="1076"/>
          <ac:spMkLst>
            <pc:docMk/>
            <pc:sldMk cId="2696857125" sldId="266"/>
            <ac:spMk id="7" creationId="{4C53C49A-B2B8-44AD-8B23-EBF9ADFA7270}"/>
          </ac:spMkLst>
        </pc:spChg>
        <pc:spChg chg="add mod">
          <ac:chgData name="酒井 優治" userId="af82edebe887f20f" providerId="LiveId" clId="{09180B15-C956-4E6F-B8B9-D602D6DE1356}" dt="2022-04-01T03:35:28.656" v="1240" actId="1076"/>
          <ac:spMkLst>
            <pc:docMk/>
            <pc:sldMk cId="2696857125" sldId="266"/>
            <ac:spMk id="8" creationId="{56CE7B99-D122-4303-8FC0-0EA4EEB97219}"/>
          </ac:spMkLst>
        </pc:spChg>
      </pc:sldChg>
      <pc:sldChg chg="addSp delSp modSp mod">
        <pc:chgData name="酒井 優治" userId="af82edebe887f20f" providerId="LiveId" clId="{09180B15-C956-4E6F-B8B9-D602D6DE1356}" dt="2022-03-31T06:19:07.199" v="838" actId="1035"/>
        <pc:sldMkLst>
          <pc:docMk/>
          <pc:sldMk cId="1889218569" sldId="270"/>
        </pc:sldMkLst>
        <pc:spChg chg="add mod">
          <ac:chgData name="酒井 優治" userId="af82edebe887f20f" providerId="LiveId" clId="{09180B15-C956-4E6F-B8B9-D602D6DE1356}" dt="2022-03-31T05:38:54.676" v="548" actId="1076"/>
          <ac:spMkLst>
            <pc:docMk/>
            <pc:sldMk cId="1889218569" sldId="270"/>
            <ac:spMk id="2" creationId="{570BD45F-389C-494C-BEAD-EB538FCF75CA}"/>
          </ac:spMkLst>
        </pc:spChg>
        <pc:spChg chg="mod">
          <ac:chgData name="酒井 優治" userId="af82edebe887f20f" providerId="LiveId" clId="{09180B15-C956-4E6F-B8B9-D602D6DE1356}" dt="2022-03-31T06:19:07.199" v="838" actId="1035"/>
          <ac:spMkLst>
            <pc:docMk/>
            <pc:sldMk cId="1889218569" sldId="270"/>
            <ac:spMk id="5" creationId="{3C999F1F-C335-4B41-ADA4-E58A5F7320BD}"/>
          </ac:spMkLst>
        </pc:spChg>
        <pc:spChg chg="mod">
          <ac:chgData name="酒井 優治" userId="af82edebe887f20f" providerId="LiveId" clId="{09180B15-C956-4E6F-B8B9-D602D6DE1356}" dt="2022-03-31T06:19:07.199" v="838" actId="1035"/>
          <ac:spMkLst>
            <pc:docMk/>
            <pc:sldMk cId="1889218569" sldId="270"/>
            <ac:spMk id="6" creationId="{1DB06248-0732-43EE-BAA1-CC609C15D738}"/>
          </ac:spMkLst>
        </pc:spChg>
        <pc:spChg chg="add mod">
          <ac:chgData name="酒井 優治" userId="af82edebe887f20f" providerId="LiveId" clId="{09180B15-C956-4E6F-B8B9-D602D6DE1356}" dt="2022-03-31T05:32:11.162" v="302"/>
          <ac:spMkLst>
            <pc:docMk/>
            <pc:sldMk cId="1889218569" sldId="270"/>
            <ac:spMk id="7" creationId="{FD80B1FF-B366-4C43-BBF5-79CEB9426ABC}"/>
          </ac:spMkLst>
        </pc:spChg>
        <pc:spChg chg="add mod">
          <ac:chgData name="酒井 優治" userId="af82edebe887f20f" providerId="LiveId" clId="{09180B15-C956-4E6F-B8B9-D602D6DE1356}" dt="2022-03-31T05:32:11.162" v="302"/>
          <ac:spMkLst>
            <pc:docMk/>
            <pc:sldMk cId="1889218569" sldId="270"/>
            <ac:spMk id="8" creationId="{50FFAE18-3097-4B39-B9A9-0FC4A2D491BA}"/>
          </ac:spMkLst>
        </pc:spChg>
        <pc:spChg chg="add mod">
          <ac:chgData name="酒井 優治" userId="af82edebe887f20f" providerId="LiveId" clId="{09180B15-C956-4E6F-B8B9-D602D6DE1356}" dt="2022-03-31T05:39:00.887" v="550" actId="1076"/>
          <ac:spMkLst>
            <pc:docMk/>
            <pc:sldMk cId="1889218569" sldId="270"/>
            <ac:spMk id="9" creationId="{79A8CFE1-09AF-4404-B9CD-5FEDED883CE6}"/>
          </ac:spMkLst>
        </pc:spChg>
        <pc:spChg chg="add mod">
          <ac:chgData name="酒井 優治" userId="af82edebe887f20f" providerId="LiveId" clId="{09180B15-C956-4E6F-B8B9-D602D6DE1356}" dt="2022-03-31T05:39:03.925" v="552" actId="1076"/>
          <ac:spMkLst>
            <pc:docMk/>
            <pc:sldMk cId="1889218569" sldId="270"/>
            <ac:spMk id="10" creationId="{F6DD3530-3EBC-40CD-82C7-56E876938897}"/>
          </ac:spMkLst>
        </pc:spChg>
        <pc:spChg chg="add mod">
          <ac:chgData name="酒井 優治" userId="af82edebe887f20f" providerId="LiveId" clId="{09180B15-C956-4E6F-B8B9-D602D6DE1356}" dt="2022-03-31T05:39:20.927" v="561" actId="1037"/>
          <ac:spMkLst>
            <pc:docMk/>
            <pc:sldMk cId="1889218569" sldId="270"/>
            <ac:spMk id="12" creationId="{387734E3-DCD4-41EA-95B1-E58CE4FEDA5E}"/>
          </ac:spMkLst>
        </pc:spChg>
        <pc:spChg chg="add mod">
          <ac:chgData name="酒井 優治" userId="af82edebe887f20f" providerId="LiveId" clId="{09180B15-C956-4E6F-B8B9-D602D6DE1356}" dt="2022-03-31T05:39:13.911" v="556" actId="1076"/>
          <ac:spMkLst>
            <pc:docMk/>
            <pc:sldMk cId="1889218569" sldId="270"/>
            <ac:spMk id="13" creationId="{3BD37D75-A52F-4A51-9F3D-4510E5AA36E6}"/>
          </ac:spMkLst>
        </pc:spChg>
        <pc:picChg chg="add del mod">
          <ac:chgData name="酒井 優治" userId="af82edebe887f20f" providerId="LiveId" clId="{09180B15-C956-4E6F-B8B9-D602D6DE1356}" dt="2022-03-31T05:39:06.833" v="555" actId="478"/>
          <ac:picMkLst>
            <pc:docMk/>
            <pc:sldMk cId="1889218569" sldId="270"/>
            <ac:picMk id="11" creationId="{ECC26B6E-90F4-4189-A30E-80BF40663746}"/>
          </ac:picMkLst>
        </pc:picChg>
      </pc:sldChg>
      <pc:sldChg chg="addSp modSp mod">
        <pc:chgData name="酒井 優治" userId="af82edebe887f20f" providerId="LiveId" clId="{09180B15-C956-4E6F-B8B9-D602D6DE1356}" dt="2022-04-04T00:56:59.333" v="1254" actId="20577"/>
        <pc:sldMkLst>
          <pc:docMk/>
          <pc:sldMk cId="764672988" sldId="271"/>
        </pc:sldMkLst>
        <pc:spChg chg="add mod">
          <ac:chgData name="酒井 優治" userId="af82edebe887f20f" providerId="LiveId" clId="{09180B15-C956-4E6F-B8B9-D602D6DE1356}" dt="2022-03-31T06:19:50.417" v="868"/>
          <ac:spMkLst>
            <pc:docMk/>
            <pc:sldMk cId="764672988" sldId="271"/>
            <ac:spMk id="5" creationId="{4C46981F-F462-41C5-993C-DCFC8873085A}"/>
          </ac:spMkLst>
        </pc:spChg>
        <pc:spChg chg="add mod">
          <ac:chgData name="酒井 優治" userId="af82edebe887f20f" providerId="LiveId" clId="{09180B15-C956-4E6F-B8B9-D602D6DE1356}" dt="2022-03-31T06:19:50.417" v="868"/>
          <ac:spMkLst>
            <pc:docMk/>
            <pc:sldMk cId="764672988" sldId="271"/>
            <ac:spMk id="6" creationId="{600FA632-D3F8-4D22-A545-ACBB8C088944}"/>
          </ac:spMkLst>
        </pc:spChg>
        <pc:spChg chg="mod">
          <ac:chgData name="酒井 優治" userId="af82edebe887f20f" providerId="LiveId" clId="{09180B15-C956-4E6F-B8B9-D602D6DE1356}" dt="2022-04-01T02:48:20.387" v="1231" actId="20577"/>
          <ac:spMkLst>
            <pc:docMk/>
            <pc:sldMk cId="764672988" sldId="271"/>
            <ac:spMk id="7" creationId="{F9DC4AA7-9FB2-4B51-832A-1D46274E63AD}"/>
          </ac:spMkLst>
        </pc:spChg>
        <pc:spChg chg="mod">
          <ac:chgData name="酒井 優治" userId="af82edebe887f20f" providerId="LiveId" clId="{09180B15-C956-4E6F-B8B9-D602D6DE1356}" dt="2022-04-04T00:56:59.333" v="1254" actId="20577"/>
          <ac:spMkLst>
            <pc:docMk/>
            <pc:sldMk cId="764672988" sldId="271"/>
            <ac:spMk id="8" creationId="{85D948B6-3660-4C56-AEA1-7A6241F4B42A}"/>
          </ac:spMkLst>
        </pc:spChg>
      </pc:sldChg>
      <pc:sldChg chg="addSp delSp modSp mod">
        <pc:chgData name="酒井 優治" userId="af82edebe887f20f" providerId="LiveId" clId="{09180B15-C956-4E6F-B8B9-D602D6DE1356}" dt="2022-03-31T06:18:57.497" v="804" actId="1035"/>
        <pc:sldMkLst>
          <pc:docMk/>
          <pc:sldMk cId="2246250910" sldId="299"/>
        </pc:sldMkLst>
        <pc:spChg chg="mod">
          <ac:chgData name="酒井 優治" userId="af82edebe887f20f" providerId="LiveId" clId="{09180B15-C956-4E6F-B8B9-D602D6DE1356}" dt="2022-03-31T06:18:57.497" v="804" actId="1035"/>
          <ac:spMkLst>
            <pc:docMk/>
            <pc:sldMk cId="2246250910" sldId="299"/>
            <ac:spMk id="2" creationId="{00000000-0000-0000-0000-000000000000}"/>
          </ac:spMkLst>
        </pc:spChg>
        <pc:spChg chg="mod">
          <ac:chgData name="酒井 優治" userId="af82edebe887f20f" providerId="LiveId" clId="{09180B15-C956-4E6F-B8B9-D602D6DE1356}" dt="2022-03-31T06:18:57.497" v="804" actId="1035"/>
          <ac:spMkLst>
            <pc:docMk/>
            <pc:sldMk cId="2246250910" sldId="299"/>
            <ac:spMk id="7" creationId="{00000000-0000-0000-0000-000000000000}"/>
          </ac:spMkLst>
        </pc:spChg>
        <pc:spChg chg="add del mod">
          <ac:chgData name="酒井 優治" userId="af82edebe887f20f" providerId="LiveId" clId="{09180B15-C956-4E6F-B8B9-D602D6DE1356}" dt="2022-03-31T05:22:34.395" v="218"/>
          <ac:spMkLst>
            <pc:docMk/>
            <pc:sldMk cId="2246250910" sldId="299"/>
            <ac:spMk id="14" creationId="{4C04747E-9A0F-44AD-8AF8-050619017B8D}"/>
          </ac:spMkLst>
        </pc:spChg>
        <pc:spChg chg="mod">
          <ac:chgData name="酒井 優治" userId="af82edebe887f20f" providerId="LiveId" clId="{09180B15-C956-4E6F-B8B9-D602D6DE1356}" dt="2022-03-31T02:44:49.560" v="18" actId="20577"/>
          <ac:spMkLst>
            <pc:docMk/>
            <pc:sldMk cId="2246250910" sldId="299"/>
            <ac:spMk id="61" creationId="{EB21CE13-E22F-42C6-9276-06F663EF7211}"/>
          </ac:spMkLst>
        </pc:spChg>
        <pc:spChg chg="del">
          <ac:chgData name="酒井 優治" userId="af82edebe887f20f" providerId="LiveId" clId="{09180B15-C956-4E6F-B8B9-D602D6DE1356}" dt="2022-03-31T05:18:49.524" v="212" actId="478"/>
          <ac:spMkLst>
            <pc:docMk/>
            <pc:sldMk cId="2246250910" sldId="299"/>
            <ac:spMk id="80" creationId="{0D134F96-32FA-4385-A4C5-3BDF24E7B3B2}"/>
          </ac:spMkLst>
        </pc:spChg>
      </pc:sldChg>
      <pc:sldChg chg="addSp delSp modSp mod">
        <pc:chgData name="酒井 優治" userId="af82edebe887f20f" providerId="LiveId" clId="{09180B15-C956-4E6F-B8B9-D602D6DE1356}" dt="2022-04-01T03:37:40.279" v="1248" actId="1076"/>
        <pc:sldMkLst>
          <pc:docMk/>
          <pc:sldMk cId="889158849" sldId="300"/>
        </pc:sldMkLst>
        <pc:spChg chg="mod">
          <ac:chgData name="酒井 優治" userId="af82edebe887f20f" providerId="LiveId" clId="{09180B15-C956-4E6F-B8B9-D602D6DE1356}" dt="2022-04-01T03:37:01.702" v="1245" actId="947"/>
          <ac:spMkLst>
            <pc:docMk/>
            <pc:sldMk cId="889158849" sldId="300"/>
            <ac:spMk id="3" creationId="{11A45509-B403-46FA-A109-7531958C33A6}"/>
          </ac:spMkLst>
        </pc:spChg>
        <pc:spChg chg="mod">
          <ac:chgData name="酒井 優治" userId="af82edebe887f20f" providerId="LiveId" clId="{09180B15-C956-4E6F-B8B9-D602D6DE1356}" dt="2022-03-31T06:19:19.518" v="864" actId="1035"/>
          <ac:spMkLst>
            <pc:docMk/>
            <pc:sldMk cId="889158849" sldId="300"/>
            <ac:spMk id="4" creationId="{B0465965-2CE3-4D93-8425-4A901A95AFFA}"/>
          </ac:spMkLst>
        </pc:spChg>
        <pc:spChg chg="add mod">
          <ac:chgData name="酒井 優治" userId="af82edebe887f20f" providerId="LiveId" clId="{09180B15-C956-4E6F-B8B9-D602D6DE1356}" dt="2022-03-31T06:19:19.518" v="864" actId="1035"/>
          <ac:spMkLst>
            <pc:docMk/>
            <pc:sldMk cId="889158849" sldId="300"/>
            <ac:spMk id="6" creationId="{2E145FF6-DF5E-4B84-B494-E5552844C883}"/>
          </ac:spMkLst>
        </pc:spChg>
        <pc:spChg chg="add mod">
          <ac:chgData name="酒井 優治" userId="af82edebe887f20f" providerId="LiveId" clId="{09180B15-C956-4E6F-B8B9-D602D6DE1356}" dt="2022-03-31T06:19:19.518" v="864" actId="1035"/>
          <ac:spMkLst>
            <pc:docMk/>
            <pc:sldMk cId="889158849" sldId="300"/>
            <ac:spMk id="8" creationId="{B205E640-F03A-479D-A425-5939AEC4CE63}"/>
          </ac:spMkLst>
        </pc:spChg>
        <pc:spChg chg="add del mod">
          <ac:chgData name="酒井 優治" userId="af82edebe887f20f" providerId="LiveId" clId="{09180B15-C956-4E6F-B8B9-D602D6DE1356}" dt="2022-03-31T06:13:23.735" v="669" actId="478"/>
          <ac:spMkLst>
            <pc:docMk/>
            <pc:sldMk cId="889158849" sldId="300"/>
            <ac:spMk id="9" creationId="{680B5908-6BE9-4BD0-9F98-DD39C17E3596}"/>
          </ac:spMkLst>
        </pc:spChg>
        <pc:spChg chg="add mod">
          <ac:chgData name="酒井 優治" userId="af82edebe887f20f" providerId="LiveId" clId="{09180B15-C956-4E6F-B8B9-D602D6DE1356}" dt="2022-03-31T06:13:34.047" v="670"/>
          <ac:spMkLst>
            <pc:docMk/>
            <pc:sldMk cId="889158849" sldId="300"/>
            <ac:spMk id="10" creationId="{45E46A14-AAF1-4422-B012-8B9E48650935}"/>
          </ac:spMkLst>
        </pc:spChg>
        <pc:spChg chg="add mod">
          <ac:chgData name="酒井 優治" userId="af82edebe887f20f" providerId="LiveId" clId="{09180B15-C956-4E6F-B8B9-D602D6DE1356}" dt="2022-03-31T06:13:34.047" v="670"/>
          <ac:spMkLst>
            <pc:docMk/>
            <pc:sldMk cId="889158849" sldId="300"/>
            <ac:spMk id="11" creationId="{22C34DCD-BCD3-460F-A26C-74BA2A487114}"/>
          </ac:spMkLst>
        </pc:spChg>
        <pc:picChg chg="mod">
          <ac:chgData name="酒井 優治" userId="af82edebe887f20f" providerId="LiveId" clId="{09180B15-C956-4E6F-B8B9-D602D6DE1356}" dt="2022-04-01T03:37:40.279" v="1248" actId="1076"/>
          <ac:picMkLst>
            <pc:docMk/>
            <pc:sldMk cId="889158849" sldId="300"/>
            <ac:picMk id="5" creationId="{11D10CE9-0D38-4D6B-9729-23C5A6E7172C}"/>
          </ac:picMkLst>
        </pc:picChg>
        <pc:picChg chg="mod">
          <ac:chgData name="酒井 優治" userId="af82edebe887f20f" providerId="LiveId" clId="{09180B15-C956-4E6F-B8B9-D602D6DE1356}" dt="2022-04-01T03:37:33.580" v="1247" actId="1076"/>
          <ac:picMkLst>
            <pc:docMk/>
            <pc:sldMk cId="889158849" sldId="300"/>
            <ac:picMk id="7" creationId="{10124C59-E056-41CD-94BC-56B9322259E3}"/>
          </ac:picMkLst>
        </pc:picChg>
      </pc:sldChg>
      <pc:sldChg chg="addSp delSp modSp add del mod ord">
        <pc:chgData name="酒井 優治" userId="af82edebe887f20f" providerId="LiveId" clId="{09180B15-C956-4E6F-B8B9-D602D6DE1356}" dt="2022-04-01T03:36:18.743" v="1242" actId="478"/>
        <pc:sldMkLst>
          <pc:docMk/>
          <pc:sldMk cId="3617991554" sldId="301"/>
        </pc:sldMkLst>
        <pc:spChg chg="mod">
          <ac:chgData name="酒井 優治" userId="af82edebe887f20f" providerId="LiveId" clId="{09180B15-C956-4E6F-B8B9-D602D6DE1356}" dt="2022-03-31T06:18:41.990" v="764" actId="14100"/>
          <ac:spMkLst>
            <pc:docMk/>
            <pc:sldMk cId="3617991554" sldId="301"/>
            <ac:spMk id="2" creationId="{00000000-0000-0000-0000-000000000000}"/>
          </ac:spMkLst>
        </pc:spChg>
        <pc:spChg chg="mod">
          <ac:chgData name="酒井 優治" userId="af82edebe887f20f" providerId="LiveId" clId="{09180B15-C956-4E6F-B8B9-D602D6DE1356}" dt="2022-04-01T03:35:53.449" v="1241" actId="114"/>
          <ac:spMkLst>
            <pc:docMk/>
            <pc:sldMk cId="3617991554" sldId="301"/>
            <ac:spMk id="7" creationId="{00000000-0000-0000-0000-000000000000}"/>
          </ac:spMkLst>
        </pc:spChg>
        <pc:spChg chg="add del mod">
          <ac:chgData name="酒井 優治" userId="af82edebe887f20f" providerId="LiveId" clId="{09180B15-C956-4E6F-B8B9-D602D6DE1356}" dt="2022-04-01T03:36:18.743" v="1242" actId="478"/>
          <ac:spMkLst>
            <pc:docMk/>
            <pc:sldMk cId="3617991554" sldId="301"/>
            <ac:spMk id="8" creationId="{677D9277-44FB-4418-AEB5-E5653F41380E}"/>
          </ac:spMkLst>
        </pc:spChg>
        <pc:spChg chg="add mod">
          <ac:chgData name="酒井 優治" userId="af82edebe887f20f" providerId="LiveId" clId="{09180B15-C956-4E6F-B8B9-D602D6DE1356}" dt="2022-03-31T06:19:45.860" v="866"/>
          <ac:spMkLst>
            <pc:docMk/>
            <pc:sldMk cId="3617991554" sldId="301"/>
            <ac:spMk id="9" creationId="{5A644CCD-DEBB-4505-A155-0E1FA0F4EF7D}"/>
          </ac:spMkLst>
        </pc:spChg>
        <pc:spChg chg="add mod">
          <ac:chgData name="酒井 優治" userId="af82edebe887f20f" providerId="LiveId" clId="{09180B15-C956-4E6F-B8B9-D602D6DE1356}" dt="2022-03-31T06:19:45.860" v="866"/>
          <ac:spMkLst>
            <pc:docMk/>
            <pc:sldMk cId="3617991554" sldId="301"/>
            <ac:spMk id="10" creationId="{1BF3F97C-D4C9-4650-A2ED-93049E06E7BF}"/>
          </ac:spMkLst>
        </pc:spChg>
        <pc:spChg chg="del">
          <ac:chgData name="酒井 優治" userId="af82edebe887f20f" providerId="LiveId" clId="{09180B15-C956-4E6F-B8B9-D602D6DE1356}" dt="2022-03-31T06:19:40.202" v="865" actId="478"/>
          <ac:spMkLst>
            <pc:docMk/>
            <pc:sldMk cId="3617991554" sldId="301"/>
            <ac:spMk id="59" creationId="{A5EBB3A2-3DDB-4131-B1A0-A870C43C6D39}"/>
          </ac:spMkLst>
        </pc:spChg>
        <pc:spChg chg="del">
          <ac:chgData name="酒井 優治" userId="af82edebe887f20f" providerId="LiveId" clId="{09180B15-C956-4E6F-B8B9-D602D6DE1356}" dt="2022-03-31T06:19:40.202" v="865" actId="478"/>
          <ac:spMkLst>
            <pc:docMk/>
            <pc:sldMk cId="3617991554" sldId="301"/>
            <ac:spMk id="61" creationId="{EB21CE13-E22F-42C6-9276-06F663EF7211}"/>
          </ac:spMkLst>
        </pc:spChg>
      </pc:sldChg>
      <pc:sldChg chg="delSp del mod">
        <pc:chgData name="酒井 優治" userId="af82edebe887f20f" providerId="LiveId" clId="{09180B15-C956-4E6F-B8B9-D602D6DE1356}" dt="2022-03-31T00:32:41.678" v="1" actId="47"/>
        <pc:sldMkLst>
          <pc:docMk/>
          <pc:sldMk cId="1014723978" sldId="302"/>
        </pc:sldMkLst>
        <pc:picChg chg="del">
          <ac:chgData name="酒井 優治" userId="af82edebe887f20f" providerId="LiveId" clId="{09180B15-C956-4E6F-B8B9-D602D6DE1356}" dt="2022-03-31T00:32:05.067" v="0" actId="21"/>
          <ac:picMkLst>
            <pc:docMk/>
            <pc:sldMk cId="1014723978" sldId="302"/>
            <ac:picMk id="7" creationId="{22EB307A-7006-4B88-A529-A543BB4BA2BC}"/>
          </ac:picMkLst>
        </pc:picChg>
      </pc:sldChg>
    </pc:docChg>
  </pc:docChgLst>
  <pc:docChgLst>
    <pc:chgData name="酒井 優治" userId="af82edebe887f20f" providerId="LiveId" clId="{BEEC8FF8-5D72-4736-8594-73EDDD29B652}"/>
    <pc:docChg chg="custSel modSld">
      <pc:chgData name="酒井 優治" userId="af82edebe887f20f" providerId="LiveId" clId="{BEEC8FF8-5D72-4736-8594-73EDDD29B652}" dt="2022-05-09T03:27:51.130" v="85" actId="478"/>
      <pc:docMkLst>
        <pc:docMk/>
      </pc:docMkLst>
      <pc:sldChg chg="addSp delSp modSp mod">
        <pc:chgData name="酒井 優治" userId="af82edebe887f20f" providerId="LiveId" clId="{BEEC8FF8-5D72-4736-8594-73EDDD29B652}" dt="2022-05-08T05:37:52.950" v="68" actId="1076"/>
        <pc:sldMkLst>
          <pc:docMk/>
          <pc:sldMk cId="1889218569" sldId="270"/>
        </pc:sldMkLst>
        <pc:spChg chg="del">
          <ac:chgData name="酒井 優治" userId="af82edebe887f20f" providerId="LiveId" clId="{BEEC8FF8-5D72-4736-8594-73EDDD29B652}" dt="2022-05-08T05:37:41.434" v="66" actId="478"/>
          <ac:spMkLst>
            <pc:docMk/>
            <pc:sldMk cId="1889218569" sldId="270"/>
            <ac:spMk id="2" creationId="{570BD45F-389C-494C-BEAD-EB538FCF75CA}"/>
          </ac:spMkLst>
        </pc:spChg>
        <pc:spChg chg="del">
          <ac:chgData name="酒井 優治" userId="af82edebe887f20f" providerId="LiveId" clId="{BEEC8FF8-5D72-4736-8594-73EDDD29B652}" dt="2022-05-08T05:37:41.434" v="66" actId="478"/>
          <ac:spMkLst>
            <pc:docMk/>
            <pc:sldMk cId="1889218569" sldId="270"/>
            <ac:spMk id="9" creationId="{79A8CFE1-09AF-4404-B9CD-5FEDED883CE6}"/>
          </ac:spMkLst>
        </pc:spChg>
        <pc:spChg chg="del">
          <ac:chgData name="酒井 優治" userId="af82edebe887f20f" providerId="LiveId" clId="{BEEC8FF8-5D72-4736-8594-73EDDD29B652}" dt="2022-05-08T05:37:41.434" v="66" actId="478"/>
          <ac:spMkLst>
            <pc:docMk/>
            <pc:sldMk cId="1889218569" sldId="270"/>
            <ac:spMk id="10" creationId="{F6DD3530-3EBC-40CD-82C7-56E876938897}"/>
          </ac:spMkLst>
        </pc:spChg>
        <pc:spChg chg="del">
          <ac:chgData name="酒井 優治" userId="af82edebe887f20f" providerId="LiveId" clId="{BEEC8FF8-5D72-4736-8594-73EDDD29B652}" dt="2022-05-08T05:37:41.434" v="66" actId="478"/>
          <ac:spMkLst>
            <pc:docMk/>
            <pc:sldMk cId="1889218569" sldId="270"/>
            <ac:spMk id="12" creationId="{387734E3-DCD4-41EA-95B1-E58CE4FEDA5E}"/>
          </ac:spMkLst>
        </pc:spChg>
        <pc:spChg chg="del">
          <ac:chgData name="酒井 優治" userId="af82edebe887f20f" providerId="LiveId" clId="{BEEC8FF8-5D72-4736-8594-73EDDD29B652}" dt="2022-05-08T05:37:41.434" v="66" actId="478"/>
          <ac:spMkLst>
            <pc:docMk/>
            <pc:sldMk cId="1889218569" sldId="270"/>
            <ac:spMk id="13" creationId="{3BD37D75-A52F-4A51-9F3D-4510E5AA36E6}"/>
          </ac:spMkLst>
        </pc:spChg>
        <pc:picChg chg="del">
          <ac:chgData name="酒井 優治" userId="af82edebe887f20f" providerId="LiveId" clId="{BEEC8FF8-5D72-4736-8594-73EDDD29B652}" dt="2022-05-08T05:37:39.093" v="65" actId="478"/>
          <ac:picMkLst>
            <pc:docMk/>
            <pc:sldMk cId="1889218569" sldId="270"/>
            <ac:picMk id="3" creationId="{9D9AD12F-5AF5-4E8E-8F51-40049E0F2DAE}"/>
          </ac:picMkLst>
        </pc:picChg>
        <pc:picChg chg="add mod">
          <ac:chgData name="酒井 優治" userId="af82edebe887f20f" providerId="LiveId" clId="{BEEC8FF8-5D72-4736-8594-73EDDD29B652}" dt="2022-05-08T05:37:52.950" v="68" actId="1076"/>
          <ac:picMkLst>
            <pc:docMk/>
            <pc:sldMk cId="1889218569" sldId="270"/>
            <ac:picMk id="4" creationId="{AE142F79-9850-5B58-0FE5-E9ACA2790DD1}"/>
          </ac:picMkLst>
        </pc:picChg>
      </pc:sldChg>
      <pc:sldChg chg="addSp delSp modSp mod">
        <pc:chgData name="酒井 優治" userId="af82edebe887f20f" providerId="LiveId" clId="{BEEC8FF8-5D72-4736-8594-73EDDD29B652}" dt="2022-05-08T05:45:53.430" v="81" actId="1076"/>
        <pc:sldMkLst>
          <pc:docMk/>
          <pc:sldMk cId="764672988" sldId="271"/>
        </pc:sldMkLst>
        <pc:picChg chg="del">
          <ac:chgData name="酒井 優治" userId="af82edebe887f20f" providerId="LiveId" clId="{BEEC8FF8-5D72-4736-8594-73EDDD29B652}" dt="2022-05-08T05:45:48.673" v="79" actId="478"/>
          <ac:picMkLst>
            <pc:docMk/>
            <pc:sldMk cId="764672988" sldId="271"/>
            <ac:picMk id="2" creationId="{7206F050-6AF0-4DEA-A19D-994D6A48E5FD}"/>
          </ac:picMkLst>
        </pc:picChg>
        <pc:picChg chg="add mod">
          <ac:chgData name="酒井 優治" userId="af82edebe887f20f" providerId="LiveId" clId="{BEEC8FF8-5D72-4736-8594-73EDDD29B652}" dt="2022-05-08T05:45:53.430" v="81" actId="1076"/>
          <ac:picMkLst>
            <pc:docMk/>
            <pc:sldMk cId="764672988" sldId="271"/>
            <ac:picMk id="3" creationId="{6EAE901D-EC40-AB0A-88BA-C359D73ADBB1}"/>
          </ac:picMkLst>
        </pc:picChg>
      </pc:sldChg>
      <pc:sldChg chg="addSp delSp modSp mod">
        <pc:chgData name="酒井 優治" userId="af82edebe887f20f" providerId="LiveId" clId="{BEEC8FF8-5D72-4736-8594-73EDDD29B652}" dt="2022-05-08T05:34:04.347" v="64" actId="20577"/>
        <pc:sldMkLst>
          <pc:docMk/>
          <pc:sldMk cId="2246250910" sldId="299"/>
        </pc:sldMkLst>
        <pc:spChg chg="add mod">
          <ac:chgData name="酒井 優治" userId="af82edebe887f20f" providerId="LiveId" clId="{BEEC8FF8-5D72-4736-8594-73EDDD29B652}" dt="2022-05-08T05:32:42.421" v="29" actId="1037"/>
          <ac:spMkLst>
            <pc:docMk/>
            <pc:sldMk cId="2246250910" sldId="299"/>
            <ac:spMk id="3" creationId="{A317180B-3DEC-D8BE-9F01-5011FFACFCF1}"/>
          </ac:spMkLst>
        </pc:spChg>
        <pc:spChg chg="mod">
          <ac:chgData name="酒井 優治" userId="af82edebe887f20f" providerId="LiveId" clId="{BEEC8FF8-5D72-4736-8594-73EDDD29B652}" dt="2022-05-08T05:34:04.347" v="64" actId="20577"/>
          <ac:spMkLst>
            <pc:docMk/>
            <pc:sldMk cId="2246250910" sldId="299"/>
            <ac:spMk id="7" creationId="{00000000-0000-0000-0000-000000000000}"/>
          </ac:spMkLst>
        </pc:spChg>
        <pc:picChg chg="add del mod">
          <ac:chgData name="酒井 優治" userId="af82edebe887f20f" providerId="LiveId" clId="{BEEC8FF8-5D72-4736-8594-73EDDD29B652}" dt="2022-05-08T05:32:35.996" v="21" actId="478"/>
          <ac:picMkLst>
            <pc:docMk/>
            <pc:sldMk cId="2246250910" sldId="299"/>
            <ac:picMk id="12" creationId="{3BDD367C-7FD1-EF34-B055-4A5522788F6C}"/>
          </ac:picMkLst>
        </pc:picChg>
      </pc:sldChg>
      <pc:sldChg chg="addSp delSp modSp mod">
        <pc:chgData name="酒井 優治" userId="af82edebe887f20f" providerId="LiveId" clId="{BEEC8FF8-5D72-4736-8594-73EDDD29B652}" dt="2022-05-09T03:27:51.130" v="85" actId="478"/>
        <pc:sldMkLst>
          <pc:docMk/>
          <pc:sldMk cId="889158849" sldId="300"/>
        </pc:sldMkLst>
        <pc:picChg chg="add mod">
          <ac:chgData name="酒井 優治" userId="af82edebe887f20f" providerId="LiveId" clId="{BEEC8FF8-5D72-4736-8594-73EDDD29B652}" dt="2022-05-08T05:42:41.448" v="75" actId="12789"/>
          <ac:picMkLst>
            <pc:docMk/>
            <pc:sldMk cId="889158849" sldId="300"/>
            <ac:picMk id="2" creationId="{E94F72D5-A54A-2F49-336D-1A55D160B384}"/>
          </ac:picMkLst>
        </pc:picChg>
        <pc:picChg chg="del">
          <ac:chgData name="酒井 優治" userId="af82edebe887f20f" providerId="LiveId" clId="{BEEC8FF8-5D72-4736-8594-73EDDD29B652}" dt="2022-05-08T05:41:27.384" v="69" actId="478"/>
          <ac:picMkLst>
            <pc:docMk/>
            <pc:sldMk cId="889158849" sldId="300"/>
            <ac:picMk id="5" creationId="{11D10CE9-0D38-4D6B-9729-23C5A6E7172C}"/>
          </ac:picMkLst>
        </pc:picChg>
        <pc:picChg chg="add mod ord">
          <ac:chgData name="酒井 優治" userId="af82edebe887f20f" providerId="LiveId" clId="{BEEC8FF8-5D72-4736-8594-73EDDD29B652}" dt="2022-05-09T03:27:49.257" v="84" actId="167"/>
          <ac:picMkLst>
            <pc:docMk/>
            <pc:sldMk cId="889158849" sldId="300"/>
            <ac:picMk id="5" creationId="{188ECD9C-1882-ECD2-1733-EABB3DDD9578}"/>
          </ac:picMkLst>
        </pc:picChg>
        <pc:picChg chg="del">
          <ac:chgData name="酒井 優治" userId="af82edebe887f20f" providerId="LiveId" clId="{BEEC8FF8-5D72-4736-8594-73EDDD29B652}" dt="2022-05-08T05:42:30.947" v="72" actId="478"/>
          <ac:picMkLst>
            <pc:docMk/>
            <pc:sldMk cId="889158849" sldId="300"/>
            <ac:picMk id="7" creationId="{10124C59-E056-41CD-94BC-56B9322259E3}"/>
          </ac:picMkLst>
        </pc:picChg>
        <pc:picChg chg="add del mod">
          <ac:chgData name="酒井 優治" userId="af82edebe887f20f" providerId="LiveId" clId="{BEEC8FF8-5D72-4736-8594-73EDDD29B652}" dt="2022-05-09T03:27:51.130" v="85" actId="478"/>
          <ac:picMkLst>
            <pc:docMk/>
            <pc:sldMk cId="889158849" sldId="300"/>
            <ac:picMk id="9" creationId="{D97641A7-0C03-2E80-3169-08EE11E86E19}"/>
          </ac:picMkLst>
        </pc:picChg>
      </pc:sldChg>
      <pc:sldChg chg="addSp delSp modSp mod">
        <pc:chgData name="酒井 優治" userId="af82edebe887f20f" providerId="LiveId" clId="{BEEC8FF8-5D72-4736-8594-73EDDD29B652}" dt="2022-05-08T05:43:19.661" v="78" actId="1076"/>
        <pc:sldMkLst>
          <pc:docMk/>
          <pc:sldMk cId="3617991554" sldId="301"/>
        </pc:sldMkLst>
        <pc:picChg chg="del">
          <ac:chgData name="酒井 優治" userId="af82edebe887f20f" providerId="LiveId" clId="{BEEC8FF8-5D72-4736-8594-73EDDD29B652}" dt="2022-05-08T05:43:15.737" v="76" actId="478"/>
          <ac:picMkLst>
            <pc:docMk/>
            <pc:sldMk cId="3617991554" sldId="301"/>
            <ac:picMk id="3" creationId="{6D56878A-D322-47F4-91E7-7B38C1D92422}"/>
          </ac:picMkLst>
        </pc:picChg>
        <pc:picChg chg="add mod">
          <ac:chgData name="酒井 優治" userId="af82edebe887f20f" providerId="LiveId" clId="{BEEC8FF8-5D72-4736-8594-73EDDD29B652}" dt="2022-05-08T05:43:19.661" v="78" actId="1076"/>
          <ac:picMkLst>
            <pc:docMk/>
            <pc:sldMk cId="3617991554" sldId="301"/>
            <ac:picMk id="4" creationId="{976EEF50-3BA2-FCE7-679A-8C24B0B5E184}"/>
          </ac:picMkLst>
        </pc:picChg>
      </pc:sldChg>
    </pc:docChg>
  </pc:docChgLst>
  <pc:docChgLst>
    <pc:chgData name="優治 酒井" userId="af82edebe887f20f" providerId="LiveId" clId="{19A80F29-C140-4CE5-9930-16191139BABB}"/>
    <pc:docChg chg="modSld">
      <pc:chgData name="優治 酒井" userId="af82edebe887f20f" providerId="LiveId" clId="{19A80F29-C140-4CE5-9930-16191139BABB}" dt="2024-09-13T02:58:07.126" v="1" actId="2710"/>
      <pc:docMkLst>
        <pc:docMk/>
      </pc:docMkLst>
      <pc:sldChg chg="modSp mod">
        <pc:chgData name="優治 酒井" userId="af82edebe887f20f" providerId="LiveId" clId="{19A80F29-C140-4CE5-9930-16191139BABB}" dt="2024-09-13T02:58:07.126" v="1" actId="2710"/>
        <pc:sldMkLst>
          <pc:docMk/>
          <pc:sldMk cId="2035010568" sldId="271"/>
        </pc:sldMkLst>
        <pc:spChg chg="mod">
          <ac:chgData name="優治 酒井" userId="af82edebe887f20f" providerId="LiveId" clId="{19A80F29-C140-4CE5-9930-16191139BABB}" dt="2024-09-13T02:58:07.126" v="1" actId="2710"/>
          <ac:spMkLst>
            <pc:docMk/>
            <pc:sldMk cId="2035010568" sldId="271"/>
            <ac:spMk id="61" creationId="{EB21CE13-E22F-42C6-9276-06F663EF7211}"/>
          </ac:spMkLst>
        </pc:spChg>
      </pc:sldChg>
    </pc:docChg>
  </pc:docChgLst>
  <pc:docChgLst>
    <pc:chgData name="酒井 優治" userId="af82edebe887f20f" providerId="LiveId" clId="{9F650527-A00A-434A-B15A-96ADB83AE303}"/>
    <pc:docChg chg="delSld modSld">
      <pc:chgData name="酒井 優治" userId="af82edebe887f20f" providerId="LiveId" clId="{9F650527-A00A-434A-B15A-96ADB83AE303}" dt="2023-07-31T03:49:48.594" v="6" actId="20577"/>
      <pc:docMkLst>
        <pc:docMk/>
      </pc:docMkLst>
      <pc:sldChg chg="modSp mod">
        <pc:chgData name="酒井 優治" userId="af82edebe887f20f" providerId="LiveId" clId="{9F650527-A00A-434A-B15A-96ADB83AE303}" dt="2023-07-31T03:49:43.450" v="4" actId="20577"/>
        <pc:sldMkLst>
          <pc:docMk/>
          <pc:sldMk cId="1889218569" sldId="270"/>
        </pc:sldMkLst>
        <pc:spChg chg="mod">
          <ac:chgData name="酒井 優治" userId="af82edebe887f20f" providerId="LiveId" clId="{9F650527-A00A-434A-B15A-96ADB83AE303}" dt="2023-07-31T03:49:43.450" v="4" actId="20577"/>
          <ac:spMkLst>
            <pc:docMk/>
            <pc:sldMk cId="1889218569" sldId="270"/>
            <ac:spMk id="6" creationId="{1DB06248-0732-43EE-BAA1-CC609C15D738}"/>
          </ac:spMkLst>
        </pc:spChg>
      </pc:sldChg>
      <pc:sldChg chg="modSp mod">
        <pc:chgData name="酒井 優治" userId="af82edebe887f20f" providerId="LiveId" clId="{9F650527-A00A-434A-B15A-96ADB83AE303}" dt="2023-07-31T03:49:48.594" v="6" actId="20577"/>
        <pc:sldMkLst>
          <pc:docMk/>
          <pc:sldMk cId="889158849" sldId="300"/>
        </pc:sldMkLst>
        <pc:spChg chg="mod">
          <ac:chgData name="酒井 優治" userId="af82edebe887f20f" providerId="LiveId" clId="{9F650527-A00A-434A-B15A-96ADB83AE303}" dt="2023-07-31T03:49:48.594" v="6" actId="20577"/>
          <ac:spMkLst>
            <pc:docMk/>
            <pc:sldMk cId="889158849" sldId="300"/>
            <ac:spMk id="4" creationId="{B0465965-2CE3-4D93-8425-4A901A95AFFA}"/>
          </ac:spMkLst>
        </pc:spChg>
      </pc:sldChg>
      <pc:sldChg chg="del">
        <pc:chgData name="酒井 優治" userId="af82edebe887f20f" providerId="LiveId" clId="{9F650527-A00A-434A-B15A-96ADB83AE303}" dt="2023-07-29T08:22:42.550" v="0" actId="47"/>
        <pc:sldMkLst>
          <pc:docMk/>
          <pc:sldMk cId="2964256653" sldId="303"/>
        </pc:sldMkLst>
      </pc:sldChg>
    </pc:docChg>
  </pc:docChgLst>
  <pc:docChgLst>
    <pc:chgData name="優治 酒井" userId="af82edebe887f20f" providerId="LiveId" clId="{BB530075-4794-4A1B-8A82-218ABAE7C627}"/>
    <pc:docChg chg="custSel modSld">
      <pc:chgData name="優治 酒井" userId="af82edebe887f20f" providerId="LiveId" clId="{BB530075-4794-4A1B-8A82-218ABAE7C627}" dt="2024-09-09T01:36:26.288" v="90" actId="20577"/>
      <pc:docMkLst>
        <pc:docMk/>
      </pc:docMkLst>
      <pc:sldChg chg="modSp mod">
        <pc:chgData name="優治 酒井" userId="af82edebe887f20f" providerId="LiveId" clId="{BB530075-4794-4A1B-8A82-218ABAE7C627}" dt="2024-09-09T01:36:26.288" v="90" actId="20577"/>
        <pc:sldMkLst>
          <pc:docMk/>
          <pc:sldMk cId="1973638820" sldId="272"/>
        </pc:sldMkLst>
        <pc:spChg chg="mod">
          <ac:chgData name="優治 酒井" userId="af82edebe887f20f" providerId="LiveId" clId="{BB530075-4794-4A1B-8A82-218ABAE7C627}" dt="2024-09-09T01:36:26.288" v="90" actId="20577"/>
          <ac:spMkLst>
            <pc:docMk/>
            <pc:sldMk cId="1973638820" sldId="272"/>
            <ac:spMk id="8" creationId="{837B71E1-4544-546D-4A73-0E895C9006F5}"/>
          </ac:spMkLst>
        </pc:spChg>
      </pc:sldChg>
      <pc:sldChg chg="modSp mod">
        <pc:chgData name="優治 酒井" userId="af82edebe887f20f" providerId="LiveId" clId="{BB530075-4794-4A1B-8A82-218ABAE7C627}" dt="2024-09-03T02:59:20.168" v="88" actId="14100"/>
        <pc:sldMkLst>
          <pc:docMk/>
          <pc:sldMk cId="2637805845" sldId="273"/>
        </pc:sldMkLst>
        <pc:spChg chg="mod">
          <ac:chgData name="優治 酒井" userId="af82edebe887f20f" providerId="LiveId" clId="{BB530075-4794-4A1B-8A82-218ABAE7C627}" dt="2024-09-03T02:59:20.168" v="88" actId="14100"/>
          <ac:spMkLst>
            <pc:docMk/>
            <pc:sldMk cId="2637805845" sldId="273"/>
            <ac:spMk id="4" creationId="{6866DEB3-F1FB-D5AF-EDE4-DFD705CF7F88}"/>
          </ac:spMkLst>
        </pc:spChg>
      </pc:sldChg>
    </pc:docChg>
  </pc:docChgLst>
  <pc:docChgLst>
    <pc:chgData name="優治 酒井" userId="af82edebe887f20f" providerId="LiveId" clId="{1B64EA3D-B370-4E78-AD19-C550250977BF}"/>
    <pc:docChg chg="undo custSel addSld delSld modSld">
      <pc:chgData name="優治 酒井" userId="af82edebe887f20f" providerId="LiveId" clId="{1B64EA3D-B370-4E78-AD19-C550250977BF}" dt="2024-09-02T04:22:29.738" v="822" actId="20577"/>
      <pc:docMkLst>
        <pc:docMk/>
      </pc:docMkLst>
      <pc:sldChg chg="addSp modSp add mod">
        <pc:chgData name="優治 酒井" userId="af82edebe887f20f" providerId="LiveId" clId="{1B64EA3D-B370-4E78-AD19-C550250977BF}" dt="2024-09-02T03:59:06.108" v="811" actId="20577"/>
        <pc:sldMkLst>
          <pc:docMk/>
          <pc:sldMk cId="4038104200" sldId="268"/>
        </pc:sldMkLst>
        <pc:spChg chg="add mod">
          <ac:chgData name="優治 酒井" userId="af82edebe887f20f" providerId="LiveId" clId="{1B64EA3D-B370-4E78-AD19-C550250977BF}" dt="2024-09-02T03:59:06.108" v="811" actId="20577"/>
          <ac:spMkLst>
            <pc:docMk/>
            <pc:sldMk cId="4038104200" sldId="268"/>
            <ac:spMk id="3" creationId="{C3555274-1409-B0FB-1282-9FC743C87D73}"/>
          </ac:spMkLst>
        </pc:spChg>
        <pc:spChg chg="add mod">
          <ac:chgData name="優治 酒井" userId="af82edebe887f20f" providerId="LiveId" clId="{1B64EA3D-B370-4E78-AD19-C550250977BF}" dt="2024-09-02T02:52:31.663" v="239" actId="1076"/>
          <ac:spMkLst>
            <pc:docMk/>
            <pc:sldMk cId="4038104200" sldId="268"/>
            <ac:spMk id="6" creationId="{EC0E472B-CCA1-0D39-21E8-FFA036703CD6}"/>
          </ac:spMkLst>
        </pc:spChg>
        <pc:spChg chg="mod">
          <ac:chgData name="優治 酒井" userId="af82edebe887f20f" providerId="LiveId" clId="{1B64EA3D-B370-4E78-AD19-C550250977BF}" dt="2024-09-02T02:49:02.252" v="183" actId="20577"/>
          <ac:spMkLst>
            <pc:docMk/>
            <pc:sldMk cId="4038104200" sldId="268"/>
            <ac:spMk id="12" creationId="{66D789F7-0FE8-02D9-AF2D-68B96B1A41F3}"/>
          </ac:spMkLst>
        </pc:spChg>
      </pc:sldChg>
      <pc:sldChg chg="del">
        <pc:chgData name="優治 酒井" userId="af82edebe887f20f" providerId="LiveId" clId="{1B64EA3D-B370-4E78-AD19-C550250977BF}" dt="2024-09-02T02:51:02.986" v="229" actId="47"/>
        <pc:sldMkLst>
          <pc:docMk/>
          <pc:sldMk cId="1889218569" sldId="270"/>
        </pc:sldMkLst>
      </pc:sldChg>
      <pc:sldChg chg="modSp mod">
        <pc:chgData name="優治 酒井" userId="af82edebe887f20f" providerId="LiveId" clId="{1B64EA3D-B370-4E78-AD19-C550250977BF}" dt="2024-09-02T02:52:56.525" v="243" actId="1076"/>
        <pc:sldMkLst>
          <pc:docMk/>
          <pc:sldMk cId="2035010568" sldId="271"/>
        </pc:sldMkLst>
        <pc:spChg chg="mod">
          <ac:chgData name="優治 酒井" userId="af82edebe887f20f" providerId="LiveId" clId="{1B64EA3D-B370-4E78-AD19-C550250977BF}" dt="2024-09-02T02:52:45.317" v="240" actId="1076"/>
          <ac:spMkLst>
            <pc:docMk/>
            <pc:sldMk cId="2035010568" sldId="271"/>
            <ac:spMk id="4" creationId="{A5EBB3A2-3DDB-4131-B1A0-A870C43C6D39}"/>
          </ac:spMkLst>
        </pc:spChg>
        <pc:spChg chg="mod">
          <ac:chgData name="優治 酒井" userId="af82edebe887f20f" providerId="LiveId" clId="{1B64EA3D-B370-4E78-AD19-C550250977BF}" dt="2024-09-02T02:52:56.525" v="243" actId="1076"/>
          <ac:spMkLst>
            <pc:docMk/>
            <pc:sldMk cId="2035010568" sldId="271"/>
            <ac:spMk id="59" creationId="{A5EBB3A2-3DDB-4131-B1A0-A870C43C6D39}"/>
          </ac:spMkLst>
        </pc:spChg>
        <pc:spChg chg="mod">
          <ac:chgData name="優治 酒井" userId="af82edebe887f20f" providerId="LiveId" clId="{1B64EA3D-B370-4E78-AD19-C550250977BF}" dt="2024-09-02T02:52:49.627" v="242" actId="6549"/>
          <ac:spMkLst>
            <pc:docMk/>
            <pc:sldMk cId="2035010568" sldId="271"/>
            <ac:spMk id="61" creationId="{EB21CE13-E22F-42C6-9276-06F663EF7211}"/>
          </ac:spMkLst>
        </pc:spChg>
      </pc:sldChg>
      <pc:sldChg chg="addSp delSp modSp add mod">
        <pc:chgData name="優治 酒井" userId="af82edebe887f20f" providerId="LiveId" clId="{1B64EA3D-B370-4E78-AD19-C550250977BF}" dt="2024-09-02T04:22:29.738" v="822" actId="20577"/>
        <pc:sldMkLst>
          <pc:docMk/>
          <pc:sldMk cId="1973638820" sldId="272"/>
        </pc:sldMkLst>
        <pc:spChg chg="add mod">
          <ac:chgData name="優治 酒井" userId="af82edebe887f20f" providerId="LiveId" clId="{1B64EA3D-B370-4E78-AD19-C550250977BF}" dt="2024-09-02T04:22:29.738" v="822" actId="20577"/>
          <ac:spMkLst>
            <pc:docMk/>
            <pc:sldMk cId="1973638820" sldId="272"/>
            <ac:spMk id="8" creationId="{837B71E1-4544-546D-4A73-0E895C9006F5}"/>
          </ac:spMkLst>
        </pc:spChg>
        <pc:spChg chg="add mod">
          <ac:chgData name="優治 酒井" userId="af82edebe887f20f" providerId="LiveId" clId="{1B64EA3D-B370-4E78-AD19-C550250977BF}" dt="2024-09-02T02:51:27.197" v="230"/>
          <ac:spMkLst>
            <pc:docMk/>
            <pc:sldMk cId="1973638820" sldId="272"/>
            <ac:spMk id="9" creationId="{AA6FA420-8417-C6B2-D91D-73322F24894F}"/>
          </ac:spMkLst>
        </pc:spChg>
        <pc:picChg chg="del mod modCrop">
          <ac:chgData name="優治 酒井" userId="af82edebe887f20f" providerId="LiveId" clId="{1B64EA3D-B370-4E78-AD19-C550250977BF}" dt="2024-09-02T03:07:20.179" v="493" actId="478"/>
          <ac:picMkLst>
            <pc:docMk/>
            <pc:sldMk cId="1973638820" sldId="272"/>
            <ac:picMk id="4" creationId="{5AD2967A-F4C8-22FF-3515-2748B5BAC234}"/>
          </ac:picMkLst>
        </pc:picChg>
        <pc:picChg chg="add del mod">
          <ac:chgData name="優治 酒井" userId="af82edebe887f20f" providerId="LiveId" clId="{1B64EA3D-B370-4E78-AD19-C550250977BF}" dt="2024-09-02T03:58:03.987" v="789" actId="478"/>
          <ac:picMkLst>
            <pc:docMk/>
            <pc:sldMk cId="1973638820" sldId="272"/>
            <ac:picMk id="4" creationId="{E12D1F11-9054-3F75-3C6D-F4886BC97006}"/>
          </ac:picMkLst>
        </pc:picChg>
        <pc:picChg chg="add mod">
          <ac:chgData name="優治 酒井" userId="af82edebe887f20f" providerId="LiveId" clId="{1B64EA3D-B370-4E78-AD19-C550250977BF}" dt="2024-09-02T03:58:23.641" v="791" actId="1076"/>
          <ac:picMkLst>
            <pc:docMk/>
            <pc:sldMk cId="1973638820" sldId="272"/>
            <ac:picMk id="6" creationId="{0601D486-E8CD-B9D4-BF01-62954E34AF7B}"/>
          </ac:picMkLst>
        </pc:picChg>
        <pc:picChg chg="add del mod modCrop">
          <ac:chgData name="優治 酒井" userId="af82edebe887f20f" providerId="LiveId" clId="{1B64EA3D-B370-4E78-AD19-C550250977BF}" dt="2024-09-02T03:10:15.553" v="502" actId="478"/>
          <ac:picMkLst>
            <pc:docMk/>
            <pc:sldMk cId="1973638820" sldId="272"/>
            <ac:picMk id="6" creationId="{55E3905F-0F08-E200-21A8-1199CD0AD20F}"/>
          </ac:picMkLst>
        </pc:picChg>
        <pc:picChg chg="add del mod">
          <ac:chgData name="優治 酒井" userId="af82edebe887f20f" providerId="LiveId" clId="{1B64EA3D-B370-4E78-AD19-C550250977BF}" dt="2024-09-02T03:10:24.393" v="505" actId="478"/>
          <ac:picMkLst>
            <pc:docMk/>
            <pc:sldMk cId="1973638820" sldId="272"/>
            <ac:picMk id="10" creationId="{35D66B7C-6F44-837B-0E14-58B94E49511D}"/>
          </ac:picMkLst>
        </pc:picChg>
        <pc:picChg chg="add del mod">
          <ac:chgData name="優治 酒井" userId="af82edebe887f20f" providerId="LiveId" clId="{1B64EA3D-B370-4E78-AD19-C550250977BF}" dt="2024-09-02T03:57:10.670" v="785" actId="478"/>
          <ac:picMkLst>
            <pc:docMk/>
            <pc:sldMk cId="1973638820" sldId="272"/>
            <ac:picMk id="11" creationId="{F27A600C-82E2-BF42-DB1F-FC34BFA72694}"/>
          </ac:picMkLst>
        </pc:picChg>
      </pc:sldChg>
      <pc:sldChg chg="addSp modSp add mod">
        <pc:chgData name="優治 酒井" userId="af82edebe887f20f" providerId="LiveId" clId="{1B64EA3D-B370-4E78-AD19-C550250977BF}" dt="2024-09-02T04:00:07.230" v="820" actId="20577"/>
        <pc:sldMkLst>
          <pc:docMk/>
          <pc:sldMk cId="2637805845" sldId="273"/>
        </pc:sldMkLst>
        <pc:spChg chg="add mod">
          <ac:chgData name="優治 酒井" userId="af82edebe887f20f" providerId="LiveId" clId="{1B64EA3D-B370-4E78-AD19-C550250977BF}" dt="2024-09-02T04:00:07.230" v="820" actId="20577"/>
          <ac:spMkLst>
            <pc:docMk/>
            <pc:sldMk cId="2637805845" sldId="273"/>
            <ac:spMk id="4" creationId="{6866DEB3-F1FB-D5AF-EDE4-DFD705CF7F88}"/>
          </ac:spMkLst>
        </pc:spChg>
        <pc:spChg chg="add mod">
          <ac:chgData name="優治 酒井" userId="af82edebe887f20f" providerId="LiveId" clId="{1B64EA3D-B370-4E78-AD19-C550250977BF}" dt="2024-09-02T02:52:10.805" v="234" actId="1076"/>
          <ac:spMkLst>
            <pc:docMk/>
            <pc:sldMk cId="2637805845" sldId="273"/>
            <ac:spMk id="5" creationId="{A1053185-CC71-DF88-47D8-279B4F83EA63}"/>
          </ac:spMkLst>
        </pc:spChg>
      </pc:sldChg>
    </pc:docChg>
  </pc:docChgLst>
  <pc:docChgLst>
    <pc:chgData name="酒井 優治" userId="af82edebe887f20f" providerId="LiveId" clId="{183F8396-2F2F-4BAB-9DCA-1B87AED799B7}"/>
    <pc:docChg chg="undo custSel addSld delSld modSld sldOrd">
      <pc:chgData name="酒井 優治" userId="af82edebe887f20f" providerId="LiveId" clId="{183F8396-2F2F-4BAB-9DCA-1B87AED799B7}" dt="2023-05-30T03:23:54.839" v="58" actId="1076"/>
      <pc:docMkLst>
        <pc:docMk/>
      </pc:docMkLst>
      <pc:sldChg chg="del">
        <pc:chgData name="酒井 優治" userId="af82edebe887f20f" providerId="LiveId" clId="{183F8396-2F2F-4BAB-9DCA-1B87AED799B7}" dt="2023-05-28T00:05:34.425" v="31" actId="47"/>
        <pc:sldMkLst>
          <pc:docMk/>
          <pc:sldMk cId="2696857125" sldId="266"/>
        </pc:sldMkLst>
      </pc:sldChg>
      <pc:sldChg chg="addSp delSp modSp mod">
        <pc:chgData name="酒井 優治" userId="af82edebe887f20f" providerId="LiveId" clId="{183F8396-2F2F-4BAB-9DCA-1B87AED799B7}" dt="2023-05-28T00:00:15.900" v="6" actId="1076"/>
        <pc:sldMkLst>
          <pc:docMk/>
          <pc:sldMk cId="1889218569" sldId="270"/>
        </pc:sldMkLst>
        <pc:picChg chg="add mod">
          <ac:chgData name="酒井 優治" userId="af82edebe887f20f" providerId="LiveId" clId="{183F8396-2F2F-4BAB-9DCA-1B87AED799B7}" dt="2023-05-28T00:00:09.653" v="5" actId="1076"/>
          <ac:picMkLst>
            <pc:docMk/>
            <pc:sldMk cId="1889218569" sldId="270"/>
            <ac:picMk id="2" creationId="{DB353A91-1ED3-1A41-A1EC-07F54DD8B3AA}"/>
          </ac:picMkLst>
        </pc:picChg>
        <pc:picChg chg="add mod">
          <ac:chgData name="酒井 優治" userId="af82edebe887f20f" providerId="LiveId" clId="{183F8396-2F2F-4BAB-9DCA-1B87AED799B7}" dt="2023-05-28T00:00:15.900" v="6" actId="1076"/>
          <ac:picMkLst>
            <pc:docMk/>
            <pc:sldMk cId="1889218569" sldId="270"/>
            <ac:picMk id="3" creationId="{2A4995AD-5500-152D-CB14-91DDE17EE7F3}"/>
          </ac:picMkLst>
        </pc:picChg>
        <pc:picChg chg="del">
          <ac:chgData name="酒井 優治" userId="af82edebe887f20f" providerId="LiveId" clId="{183F8396-2F2F-4BAB-9DCA-1B87AED799B7}" dt="2023-05-27T23:59:45.637" v="3" actId="478"/>
          <ac:picMkLst>
            <pc:docMk/>
            <pc:sldMk cId="1889218569" sldId="270"/>
            <ac:picMk id="4" creationId="{AE142F79-9850-5B58-0FE5-E9ACA2790DD1}"/>
          </ac:picMkLst>
        </pc:picChg>
      </pc:sldChg>
      <pc:sldChg chg="del">
        <pc:chgData name="酒井 優治" userId="af82edebe887f20f" providerId="LiveId" clId="{183F8396-2F2F-4BAB-9DCA-1B87AED799B7}" dt="2023-05-28T00:05:33.356" v="30" actId="47"/>
        <pc:sldMkLst>
          <pc:docMk/>
          <pc:sldMk cId="764672988" sldId="271"/>
        </pc:sldMkLst>
      </pc:sldChg>
      <pc:sldChg chg="addSp delSp modSp del mod">
        <pc:chgData name="酒井 優治" userId="af82edebe887f20f" providerId="LiveId" clId="{183F8396-2F2F-4BAB-9DCA-1B87AED799B7}" dt="2023-05-28T06:26:23.223" v="39" actId="47"/>
        <pc:sldMkLst>
          <pc:docMk/>
          <pc:sldMk cId="2246250910" sldId="299"/>
        </pc:sldMkLst>
        <pc:spChg chg="del">
          <ac:chgData name="酒井 優治" userId="af82edebe887f20f" providerId="LiveId" clId="{183F8396-2F2F-4BAB-9DCA-1B87AED799B7}" dt="2023-05-27T23:58:33.248" v="0" actId="478"/>
          <ac:spMkLst>
            <pc:docMk/>
            <pc:sldMk cId="2246250910" sldId="299"/>
            <ac:spMk id="3" creationId="{A317180B-3DEC-D8BE-9F01-5011FFACFCF1}"/>
          </ac:spMkLst>
        </pc:spChg>
        <pc:picChg chg="add mod">
          <ac:chgData name="酒井 優治" userId="af82edebe887f20f" providerId="LiveId" clId="{183F8396-2F2F-4BAB-9DCA-1B87AED799B7}" dt="2023-05-27T23:59:21.729" v="2" actId="1076"/>
          <ac:picMkLst>
            <pc:docMk/>
            <pc:sldMk cId="2246250910" sldId="299"/>
            <ac:picMk id="4" creationId="{A2C137C2-E048-0FC1-3152-DB8A1A3EBDD5}"/>
          </ac:picMkLst>
        </pc:picChg>
        <pc:picChg chg="del">
          <ac:chgData name="酒井 優治" userId="af82edebe887f20f" providerId="LiveId" clId="{183F8396-2F2F-4BAB-9DCA-1B87AED799B7}" dt="2023-05-27T23:58:33.248" v="0" actId="478"/>
          <ac:picMkLst>
            <pc:docMk/>
            <pc:sldMk cId="2246250910" sldId="299"/>
            <ac:picMk id="5" creationId="{1AF38D4B-0A29-4145-B576-B46E171C76A6}"/>
          </ac:picMkLst>
        </pc:picChg>
        <pc:picChg chg="del">
          <ac:chgData name="酒井 優治" userId="af82edebe887f20f" providerId="LiveId" clId="{183F8396-2F2F-4BAB-9DCA-1B87AED799B7}" dt="2023-05-27T23:58:33.248" v="0" actId="478"/>
          <ac:picMkLst>
            <pc:docMk/>
            <pc:sldMk cId="2246250910" sldId="299"/>
            <ac:picMk id="65" creationId="{407250B4-F3AA-4122-9DA0-5B8D9C29E4BB}"/>
          </ac:picMkLst>
        </pc:picChg>
        <pc:picChg chg="del">
          <ac:chgData name="酒井 優治" userId="af82edebe887f20f" providerId="LiveId" clId="{183F8396-2F2F-4BAB-9DCA-1B87AED799B7}" dt="2023-05-27T23:58:33.248" v="0" actId="478"/>
          <ac:picMkLst>
            <pc:docMk/>
            <pc:sldMk cId="2246250910" sldId="299"/>
            <ac:picMk id="69" creationId="{9E8F5F08-CDC3-4899-A7BF-1CABA6039D1E}"/>
          </ac:picMkLst>
        </pc:picChg>
        <pc:picChg chg="del">
          <ac:chgData name="酒井 優治" userId="af82edebe887f20f" providerId="LiveId" clId="{183F8396-2F2F-4BAB-9DCA-1B87AED799B7}" dt="2023-05-27T23:58:33.248" v="0" actId="478"/>
          <ac:picMkLst>
            <pc:docMk/>
            <pc:sldMk cId="2246250910" sldId="299"/>
            <ac:picMk id="71" creationId="{56436CA7-7F11-4C57-B751-7DF1DAAA8E91}"/>
          </ac:picMkLst>
        </pc:picChg>
        <pc:cxnChg chg="del">
          <ac:chgData name="酒井 優治" userId="af82edebe887f20f" providerId="LiveId" clId="{183F8396-2F2F-4BAB-9DCA-1B87AED799B7}" dt="2023-05-27T23:58:33.248" v="0" actId="478"/>
          <ac:cxnSpMkLst>
            <pc:docMk/>
            <pc:sldMk cId="2246250910" sldId="299"/>
            <ac:cxnSpMk id="67" creationId="{704ECDE3-12C3-42D9-9437-1CAE8D6B9D9C}"/>
          </ac:cxnSpMkLst>
        </pc:cxnChg>
        <pc:cxnChg chg="del">
          <ac:chgData name="酒井 優治" userId="af82edebe887f20f" providerId="LiveId" clId="{183F8396-2F2F-4BAB-9DCA-1B87AED799B7}" dt="2023-05-27T23:58:33.248" v="0" actId="478"/>
          <ac:cxnSpMkLst>
            <pc:docMk/>
            <pc:sldMk cId="2246250910" sldId="299"/>
            <ac:cxnSpMk id="70" creationId="{B0B121F0-DA4F-41F9-ACE3-A8EB405928BC}"/>
          </ac:cxnSpMkLst>
        </pc:cxnChg>
      </pc:sldChg>
      <pc:sldChg chg="addSp delSp modSp mod ord">
        <pc:chgData name="酒井 優治" userId="af82edebe887f20f" providerId="LiveId" clId="{183F8396-2F2F-4BAB-9DCA-1B87AED799B7}" dt="2023-05-30T03:23:54.839" v="58" actId="1076"/>
        <pc:sldMkLst>
          <pc:docMk/>
          <pc:sldMk cId="889158849" sldId="300"/>
        </pc:sldMkLst>
        <pc:spChg chg="del">
          <ac:chgData name="酒井 優治" userId="af82edebe887f20f" providerId="LiveId" clId="{183F8396-2F2F-4BAB-9DCA-1B87AED799B7}" dt="2023-05-30T03:23:25.153" v="54" actId="478"/>
          <ac:spMkLst>
            <pc:docMk/>
            <pc:sldMk cId="889158849" sldId="300"/>
            <ac:spMk id="8" creationId="{B205E640-F03A-479D-A425-5939AEC4CE63}"/>
          </ac:spMkLst>
        </pc:spChg>
        <pc:picChg chg="del">
          <ac:chgData name="酒井 優治" userId="af82edebe887f20f" providerId="LiveId" clId="{183F8396-2F2F-4BAB-9DCA-1B87AED799B7}" dt="2023-05-28T00:00:50.954" v="8" actId="478"/>
          <ac:picMkLst>
            <pc:docMk/>
            <pc:sldMk cId="889158849" sldId="300"/>
            <ac:picMk id="2" creationId="{E94F72D5-A54A-2F49-336D-1A55D160B384}"/>
          </ac:picMkLst>
        </pc:picChg>
        <pc:picChg chg="add mod">
          <ac:chgData name="酒井 優治" userId="af82edebe887f20f" providerId="LiveId" clId="{183F8396-2F2F-4BAB-9DCA-1B87AED799B7}" dt="2023-05-30T03:23:54.839" v="58" actId="1076"/>
          <ac:picMkLst>
            <pc:docMk/>
            <pc:sldMk cId="889158849" sldId="300"/>
            <ac:picMk id="2" creationId="{F282B739-9FD7-EF1F-0ADB-265EC44CEC3F}"/>
          </ac:picMkLst>
        </pc:picChg>
        <pc:picChg chg="del">
          <ac:chgData name="酒井 優治" userId="af82edebe887f20f" providerId="LiveId" clId="{183F8396-2F2F-4BAB-9DCA-1B87AED799B7}" dt="2023-05-28T00:00:50.302" v="7" actId="478"/>
          <ac:picMkLst>
            <pc:docMk/>
            <pc:sldMk cId="889158849" sldId="300"/>
            <ac:picMk id="5" creationId="{188ECD9C-1882-ECD2-1733-EABB3DDD9578}"/>
          </ac:picMkLst>
        </pc:picChg>
        <pc:picChg chg="add del mod">
          <ac:chgData name="酒井 優治" userId="af82edebe887f20f" providerId="LiveId" clId="{183F8396-2F2F-4BAB-9DCA-1B87AED799B7}" dt="2023-05-30T03:23:21.866" v="51" actId="478"/>
          <ac:picMkLst>
            <pc:docMk/>
            <pc:sldMk cId="889158849" sldId="300"/>
            <ac:picMk id="7" creationId="{6A226E4B-5034-FA5C-690C-DADF06B600AA}"/>
          </ac:picMkLst>
        </pc:picChg>
        <pc:picChg chg="add del mod">
          <ac:chgData name="酒井 優治" userId="af82edebe887f20f" providerId="LiveId" clId="{183F8396-2F2F-4BAB-9DCA-1B87AED799B7}" dt="2023-05-30T03:23:22.565" v="52" actId="478"/>
          <ac:picMkLst>
            <pc:docMk/>
            <pc:sldMk cId="889158849" sldId="300"/>
            <ac:picMk id="9" creationId="{BB6A2678-4726-0D70-FD11-905418E732A1}"/>
          </ac:picMkLst>
        </pc:picChg>
        <pc:picChg chg="add del mod">
          <ac:chgData name="酒井 優治" userId="af82edebe887f20f" providerId="LiveId" clId="{183F8396-2F2F-4BAB-9DCA-1B87AED799B7}" dt="2023-05-30T03:23:23.550" v="53" actId="478"/>
          <ac:picMkLst>
            <pc:docMk/>
            <pc:sldMk cId="889158849" sldId="300"/>
            <ac:picMk id="12" creationId="{4684874B-87B1-C8BC-062D-2DF2934CBE18}"/>
          </ac:picMkLst>
        </pc:picChg>
        <pc:picChg chg="add del mod">
          <ac:chgData name="酒井 優治" userId="af82edebe887f20f" providerId="LiveId" clId="{183F8396-2F2F-4BAB-9DCA-1B87AED799B7}" dt="2023-05-30T03:21:00.228" v="50" actId="478"/>
          <ac:picMkLst>
            <pc:docMk/>
            <pc:sldMk cId="889158849" sldId="300"/>
            <ac:picMk id="13" creationId="{03DDEFE2-EED6-F2FD-400B-500FA343274D}"/>
          </ac:picMkLst>
        </pc:picChg>
      </pc:sldChg>
      <pc:sldChg chg="addSp delSp modSp del mod ord">
        <pc:chgData name="酒井 優治" userId="af82edebe887f20f" providerId="LiveId" clId="{183F8396-2F2F-4BAB-9DCA-1B87AED799B7}" dt="2023-05-28T06:26:31.768" v="41" actId="47"/>
        <pc:sldMkLst>
          <pc:docMk/>
          <pc:sldMk cId="3617991554" sldId="301"/>
        </pc:sldMkLst>
        <pc:picChg chg="add del mod">
          <ac:chgData name="酒井 優治" userId="af82edebe887f20f" providerId="LiveId" clId="{183F8396-2F2F-4BAB-9DCA-1B87AED799B7}" dt="2023-05-28T06:26:29.393" v="40" actId="21"/>
          <ac:picMkLst>
            <pc:docMk/>
            <pc:sldMk cId="3617991554" sldId="301"/>
            <ac:picMk id="3" creationId="{99866268-2680-CE18-CF85-E5268D04F3B0}"/>
          </ac:picMkLst>
        </pc:picChg>
        <pc:picChg chg="del">
          <ac:chgData name="酒井 優治" userId="af82edebe887f20f" providerId="LiveId" clId="{183F8396-2F2F-4BAB-9DCA-1B87AED799B7}" dt="2023-05-28T00:04:41.686" v="10" actId="478"/>
          <ac:picMkLst>
            <pc:docMk/>
            <pc:sldMk cId="3617991554" sldId="301"/>
            <ac:picMk id="4" creationId="{976EEF50-3BA2-FCE7-679A-8C24B0B5E184}"/>
          </ac:picMkLst>
        </pc:picChg>
        <pc:picChg chg="add del mod">
          <ac:chgData name="酒井 優治" userId="af82edebe887f20f" providerId="LiveId" clId="{183F8396-2F2F-4BAB-9DCA-1B87AED799B7}" dt="2023-05-28T00:05:19.108" v="26" actId="478"/>
          <ac:picMkLst>
            <pc:docMk/>
            <pc:sldMk cId="3617991554" sldId="301"/>
            <ac:picMk id="5" creationId="{D4AB0E0F-70A3-74B8-FCA2-EB1BAD738E5D}"/>
          </ac:picMkLst>
        </pc:picChg>
        <pc:picChg chg="add del mod">
          <ac:chgData name="酒井 優治" userId="af82edebe887f20f" providerId="LiveId" clId="{183F8396-2F2F-4BAB-9DCA-1B87AED799B7}" dt="2023-05-28T00:04:53.920" v="14" actId="478"/>
          <ac:picMkLst>
            <pc:docMk/>
            <pc:sldMk cId="3617991554" sldId="301"/>
            <ac:picMk id="6" creationId="{AE22CD8D-9FA4-403E-DE5C-855203033FD6}"/>
          </ac:picMkLst>
        </pc:picChg>
        <pc:picChg chg="add del mod">
          <ac:chgData name="酒井 優治" userId="af82edebe887f20f" providerId="LiveId" clId="{183F8396-2F2F-4BAB-9DCA-1B87AED799B7}" dt="2023-05-28T00:04:53.920" v="14" actId="478"/>
          <ac:picMkLst>
            <pc:docMk/>
            <pc:sldMk cId="3617991554" sldId="301"/>
            <ac:picMk id="8" creationId="{A3DF3D48-BC65-96B7-F7E2-4CDD3CE34FF1}"/>
          </ac:picMkLst>
        </pc:picChg>
      </pc:sldChg>
      <pc:sldChg chg="delSp modSp add del mod">
        <pc:chgData name="酒井 優治" userId="af82edebe887f20f" providerId="LiveId" clId="{183F8396-2F2F-4BAB-9DCA-1B87AED799B7}" dt="2023-05-28T06:26:14.775" v="38" actId="47"/>
        <pc:sldMkLst>
          <pc:docMk/>
          <pc:sldMk cId="515138136" sldId="302"/>
        </pc:sldMkLst>
        <pc:picChg chg="del">
          <ac:chgData name="酒井 優治" userId="af82edebe887f20f" providerId="LiveId" clId="{183F8396-2F2F-4BAB-9DCA-1B87AED799B7}" dt="2023-05-28T00:05:00.449" v="16" actId="478"/>
          <ac:picMkLst>
            <pc:docMk/>
            <pc:sldMk cId="515138136" sldId="302"/>
            <ac:picMk id="3" creationId="{99866268-2680-CE18-CF85-E5268D04F3B0}"/>
          </ac:picMkLst>
        </pc:picChg>
        <pc:picChg chg="mod">
          <ac:chgData name="酒井 優治" userId="af82edebe887f20f" providerId="LiveId" clId="{183F8396-2F2F-4BAB-9DCA-1B87AED799B7}" dt="2023-05-28T00:05:01.734" v="17" actId="1076"/>
          <ac:picMkLst>
            <pc:docMk/>
            <pc:sldMk cId="515138136" sldId="302"/>
            <ac:picMk id="5" creationId="{D4AB0E0F-70A3-74B8-FCA2-EB1BAD738E5D}"/>
          </ac:picMkLst>
        </pc:picChg>
      </pc:sldChg>
      <pc:sldChg chg="addSp delSp modSp add mod ord">
        <pc:chgData name="酒井 優治" userId="af82edebe887f20f" providerId="LiveId" clId="{183F8396-2F2F-4BAB-9DCA-1B87AED799B7}" dt="2023-05-28T22:01:57.658" v="43"/>
        <pc:sldMkLst>
          <pc:docMk/>
          <pc:sldMk cId="2964256653" sldId="303"/>
        </pc:sldMkLst>
        <pc:picChg chg="add mod">
          <ac:chgData name="酒井 優治" userId="af82edebe887f20f" providerId="LiveId" clId="{183F8396-2F2F-4BAB-9DCA-1B87AED799B7}" dt="2023-05-28T00:10:17.319" v="37" actId="1076"/>
          <ac:picMkLst>
            <pc:docMk/>
            <pc:sldMk cId="2964256653" sldId="303"/>
            <ac:picMk id="3" creationId="{A3147070-0043-5A27-0083-E85CDC8876B1}"/>
          </ac:picMkLst>
        </pc:picChg>
        <pc:picChg chg="del">
          <ac:chgData name="酒井 優治" userId="af82edebe887f20f" providerId="LiveId" clId="{183F8396-2F2F-4BAB-9DCA-1B87AED799B7}" dt="2023-05-28T00:10:05.920" v="35" actId="478"/>
          <ac:picMkLst>
            <pc:docMk/>
            <pc:sldMk cId="2964256653" sldId="303"/>
            <ac:picMk id="4" creationId="{A2C137C2-E048-0FC1-3152-DB8A1A3EBDD5}"/>
          </ac:picMkLst>
        </pc:picChg>
      </pc:sldChg>
      <pc:sldChg chg="addSp delSp modSp add del mod">
        <pc:chgData name="酒井 優治" userId="af82edebe887f20f" providerId="LiveId" clId="{183F8396-2F2F-4BAB-9DCA-1B87AED799B7}" dt="2023-05-29T00:57:24.680" v="49" actId="47"/>
        <pc:sldMkLst>
          <pc:docMk/>
          <pc:sldMk cId="1650574270" sldId="304"/>
        </pc:sldMkLst>
        <pc:picChg chg="add del mod">
          <ac:chgData name="酒井 優治" userId="af82edebe887f20f" providerId="LiveId" clId="{183F8396-2F2F-4BAB-9DCA-1B87AED799B7}" dt="2023-05-29T00:57:19.972" v="48" actId="21"/>
          <ac:picMkLst>
            <pc:docMk/>
            <pc:sldMk cId="1650574270" sldId="304"/>
            <ac:picMk id="2" creationId="{BA264C44-A37A-0CC7-0CA4-D9927F9423A4}"/>
          </ac:picMkLst>
        </pc:picChg>
        <pc:picChg chg="del">
          <ac:chgData name="酒井 優治" userId="af82edebe887f20f" providerId="LiveId" clId="{183F8396-2F2F-4BAB-9DCA-1B87AED799B7}" dt="2023-05-29T00:52:28.258" v="45" actId="478"/>
          <ac:picMkLst>
            <pc:docMk/>
            <pc:sldMk cId="1650574270" sldId="304"/>
            <ac:picMk id="7" creationId="{6A226E4B-5034-FA5C-690C-DADF06B600AA}"/>
          </ac:picMkLst>
        </pc:picChg>
        <pc:picChg chg="del">
          <ac:chgData name="酒井 優治" userId="af82edebe887f20f" providerId="LiveId" clId="{183F8396-2F2F-4BAB-9DCA-1B87AED799B7}" dt="2023-05-29T00:52:28.258" v="45" actId="478"/>
          <ac:picMkLst>
            <pc:docMk/>
            <pc:sldMk cId="1650574270" sldId="304"/>
            <ac:picMk id="9" creationId="{BB6A2678-4726-0D70-FD11-905418E732A1}"/>
          </ac:picMkLst>
        </pc:picChg>
        <pc:picChg chg="del">
          <ac:chgData name="酒井 優治" userId="af82edebe887f20f" providerId="LiveId" clId="{183F8396-2F2F-4BAB-9DCA-1B87AED799B7}" dt="2023-05-29T00:52:28.258" v="45" actId="478"/>
          <ac:picMkLst>
            <pc:docMk/>
            <pc:sldMk cId="1650574270" sldId="304"/>
            <ac:picMk id="12" creationId="{4684874B-87B1-C8BC-062D-2DF2934CBE18}"/>
          </ac:picMkLst>
        </pc:picChg>
        <pc:picChg chg="del">
          <ac:chgData name="酒井 優治" userId="af82edebe887f20f" providerId="LiveId" clId="{183F8396-2F2F-4BAB-9DCA-1B87AED799B7}" dt="2023-05-29T00:52:28.258" v="45" actId="478"/>
          <ac:picMkLst>
            <pc:docMk/>
            <pc:sldMk cId="1650574270" sldId="304"/>
            <ac:picMk id="13" creationId="{03DDEFE2-EED6-F2FD-400B-500FA343274D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21582" cy="49550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8971" y="0"/>
            <a:ext cx="2921582" cy="49550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E755DE-C051-4777-B741-69860656B698}" type="datetimeFigureOut">
              <a:rPr kumimoji="1" lang="ja-JP" altLang="en-US" smtClean="0"/>
              <a:t>2024/12/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17738" y="1235075"/>
            <a:ext cx="2306637" cy="33321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4212" y="4752747"/>
            <a:ext cx="5393690" cy="388861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80333"/>
            <a:ext cx="2921582" cy="49550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8971" y="9380333"/>
            <a:ext cx="2921582" cy="49550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9F59B2F-FAA2-4E52-94BB-E47B1D7959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91953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9F59B2F-FAA2-4E52-94BB-E47B1D795971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212468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r>
              <a:rPr kumimoji="1" lang="en-US" altLang="ja-JP" sz="1200" dirty="0"/>
              <a:t>Discussion</a:t>
            </a:r>
            <a:r>
              <a:rPr kumimoji="1" lang="ja-JP" altLang="en-US" sz="1200" dirty="0"/>
              <a:t>にて、</a:t>
            </a:r>
            <a:r>
              <a:rPr kumimoji="1" lang="en-US" altLang="ja-JP" sz="1200" dirty="0" err="1"/>
              <a:t>NfkB</a:t>
            </a:r>
            <a:r>
              <a:rPr kumimoji="1" lang="ja-JP" altLang="en-US" sz="1200" dirty="0"/>
              <a:t>の寄与が低いことを述べるのに使用する。</a:t>
            </a:r>
            <a:endParaRPr kumimoji="1" lang="en-US" altLang="ja-JP" sz="1200" dirty="0"/>
          </a:p>
          <a:p>
            <a:pPr algn="just"/>
            <a:r>
              <a:rPr kumimoji="1" lang="en-US" altLang="ja-JP" sz="1200" dirty="0"/>
              <a:t>JSH</a:t>
            </a:r>
            <a:r>
              <a:rPr kumimoji="1" lang="ja-JP" altLang="en-US" sz="1200" dirty="0"/>
              <a:t>は</a:t>
            </a:r>
            <a:r>
              <a:rPr kumimoji="1" lang="en-US" altLang="ja-JP" sz="1200" dirty="0" err="1"/>
              <a:t>Stattic</a:t>
            </a:r>
            <a:r>
              <a:rPr kumimoji="1" lang="ja-JP" altLang="en-US" sz="1200" dirty="0"/>
              <a:t>よりも</a:t>
            </a:r>
            <a:r>
              <a:rPr kumimoji="1" lang="en-US" altLang="ja-JP" sz="1200" dirty="0"/>
              <a:t>5 µM</a:t>
            </a:r>
            <a:r>
              <a:rPr kumimoji="1" lang="ja-JP" altLang="en-US" sz="1200" dirty="0"/>
              <a:t>で細胞生存率を抑制せず、</a:t>
            </a:r>
            <a:r>
              <a:rPr kumimoji="1" lang="en-US" altLang="ja-JP" sz="1200" dirty="0"/>
              <a:t>10 µM</a:t>
            </a:r>
            <a:r>
              <a:rPr kumimoji="1" lang="ja-JP" altLang="en-US" sz="1200" dirty="0"/>
              <a:t>では細胞死を引き起こした。</a:t>
            </a:r>
            <a:endParaRPr kumimoji="1" lang="en-US" altLang="ja-JP" sz="1200" dirty="0"/>
          </a:p>
          <a:p>
            <a:pPr algn="just"/>
            <a:r>
              <a:rPr kumimoji="1" lang="en-US" altLang="ja-JP" sz="1200" dirty="0" err="1"/>
              <a:t>Stattic</a:t>
            </a:r>
            <a:r>
              <a:rPr kumimoji="1" lang="ja-JP" altLang="en-US" sz="1200" dirty="0"/>
              <a:t>は</a:t>
            </a:r>
            <a:r>
              <a:rPr kumimoji="1" lang="en-US" altLang="ja-JP" sz="1200" dirty="0"/>
              <a:t>0.5 </a:t>
            </a:r>
            <a:r>
              <a:rPr kumimoji="1" lang="ja-JP" altLang="en-US" sz="1200" dirty="0"/>
              <a:t>及び </a:t>
            </a:r>
            <a:r>
              <a:rPr kumimoji="1" lang="en-US" altLang="ja-JP" sz="1200" dirty="0"/>
              <a:t>1 µM</a:t>
            </a:r>
            <a:r>
              <a:rPr kumimoji="1" lang="ja-JP" altLang="en-US" sz="1200" dirty="0"/>
              <a:t>で細胞生存の維持を抑制した一方で、</a:t>
            </a:r>
            <a:r>
              <a:rPr kumimoji="1" lang="en-US" altLang="ja-JP" sz="1200" dirty="0"/>
              <a:t>5 µM</a:t>
            </a:r>
            <a:r>
              <a:rPr kumimoji="1" lang="ja-JP" altLang="en-US" sz="1200" dirty="0"/>
              <a:t>では細胞死を引き起こした。</a:t>
            </a:r>
            <a:endParaRPr kumimoji="1" lang="en-US" altLang="ja-JP" sz="1200" dirty="0"/>
          </a:p>
          <a:p>
            <a:pPr algn="just"/>
            <a:endParaRPr kumimoji="1" lang="en-US" altLang="ja-JP" sz="1200" dirty="0"/>
          </a:p>
          <a:p>
            <a:pPr algn="just"/>
            <a:r>
              <a:rPr kumimoji="1" lang="ja-JP" altLang="en-US" sz="1200" dirty="0"/>
              <a:t>これらのことから、</a:t>
            </a:r>
            <a:r>
              <a:rPr kumimoji="1" lang="en-US" altLang="ja-JP" sz="1200" dirty="0"/>
              <a:t>HMC3</a:t>
            </a:r>
            <a:r>
              <a:rPr kumimoji="1" lang="ja-JP" altLang="en-US" sz="1200" dirty="0"/>
              <a:t>においては</a:t>
            </a:r>
            <a:r>
              <a:rPr kumimoji="1" lang="en-US" altLang="ja-JP" sz="1200" dirty="0" err="1"/>
              <a:t>NfkB</a:t>
            </a:r>
            <a:r>
              <a:rPr kumimoji="1" lang="ja-JP" altLang="en-US" sz="1200" dirty="0"/>
              <a:t>よりも</a:t>
            </a:r>
            <a:r>
              <a:rPr kumimoji="1" lang="en-US" altLang="ja-JP" sz="1200" dirty="0"/>
              <a:t>STAT3</a:t>
            </a:r>
            <a:r>
              <a:rPr kumimoji="1" lang="ja-JP" altLang="en-US" sz="1200" dirty="0"/>
              <a:t>経路への寄与が高いことが推察される。</a:t>
            </a:r>
            <a:endParaRPr kumimoji="1" lang="en-US" altLang="ja-JP" sz="1200" dirty="0"/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3AE2B5F-49BE-43E3-AC99-36C85568AAD0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23644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563FF-DD27-49B8-AB15-FDFDAE7C85F3}" type="datetimeFigureOut">
              <a:rPr lang="ja-JP" altLang="en-US" smtClean="0"/>
              <a:pPr/>
              <a:t>2024/12/2</a:t>
            </a:fld>
            <a:endParaRPr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1EAC1-ACDF-40F2-BB67-D98ECABA6684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6925956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563FF-DD27-49B8-AB15-FDFDAE7C85F3}" type="datetimeFigureOut">
              <a:rPr lang="ja-JP" altLang="en-US" smtClean="0"/>
              <a:pPr/>
              <a:t>2024/12/2</a:t>
            </a:fld>
            <a:endParaRPr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1EAC1-ACDF-40F2-BB67-D98ECABA6684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0816534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563FF-DD27-49B8-AB15-FDFDAE7C85F3}" type="datetimeFigureOut">
              <a:rPr lang="ja-JP" altLang="en-US" smtClean="0"/>
              <a:pPr/>
              <a:t>2024/12/2</a:t>
            </a:fld>
            <a:endParaRPr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1EAC1-ACDF-40F2-BB67-D98ECABA6684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1716223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563FF-DD27-49B8-AB15-FDFDAE7C85F3}" type="datetimeFigureOut">
              <a:rPr lang="ja-JP" altLang="en-US" smtClean="0"/>
              <a:pPr/>
              <a:t>2024/12/2</a:t>
            </a:fld>
            <a:endParaRPr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1EAC1-ACDF-40F2-BB67-D98ECABA6684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434949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563FF-DD27-49B8-AB15-FDFDAE7C85F3}" type="datetimeFigureOut">
              <a:rPr lang="ja-JP" altLang="en-US" smtClean="0"/>
              <a:pPr/>
              <a:t>2024/12/2</a:t>
            </a:fld>
            <a:endParaRPr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1EAC1-ACDF-40F2-BB67-D98ECABA6684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2194277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563FF-DD27-49B8-AB15-FDFDAE7C85F3}" type="datetimeFigureOut">
              <a:rPr lang="ja-JP" altLang="en-US" smtClean="0"/>
              <a:pPr/>
              <a:t>2024/12/2</a:t>
            </a:fld>
            <a:endParaRPr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1EAC1-ACDF-40F2-BB67-D98ECABA6684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9023392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563FF-DD27-49B8-AB15-FDFDAE7C85F3}" type="datetimeFigureOut">
              <a:rPr lang="ja-JP" altLang="en-US" smtClean="0"/>
              <a:pPr/>
              <a:t>2024/12/2</a:t>
            </a:fld>
            <a:endParaRPr lang="ja-JP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1EAC1-ACDF-40F2-BB67-D98ECABA6684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4155931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563FF-DD27-49B8-AB15-FDFDAE7C85F3}" type="datetimeFigureOut">
              <a:rPr lang="ja-JP" altLang="en-US" smtClean="0"/>
              <a:pPr/>
              <a:t>2024/12/2</a:t>
            </a:fld>
            <a:endParaRPr lang="ja-JP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1EAC1-ACDF-40F2-BB67-D98ECABA6684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3806885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563FF-DD27-49B8-AB15-FDFDAE7C85F3}" type="datetimeFigureOut">
              <a:rPr lang="ja-JP" altLang="en-US" smtClean="0"/>
              <a:pPr/>
              <a:t>2024/12/2</a:t>
            </a:fld>
            <a:endParaRPr lang="ja-JP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1EAC1-ACDF-40F2-BB67-D98ECABA6684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978514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563FF-DD27-49B8-AB15-FDFDAE7C85F3}" type="datetimeFigureOut">
              <a:rPr lang="ja-JP" altLang="en-US" smtClean="0"/>
              <a:pPr/>
              <a:t>2024/12/2</a:t>
            </a:fld>
            <a:endParaRPr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1EAC1-ACDF-40F2-BB67-D98ECABA6684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8898776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563FF-DD27-49B8-AB15-FDFDAE7C85F3}" type="datetimeFigureOut">
              <a:rPr lang="ja-JP" altLang="en-US" smtClean="0"/>
              <a:pPr/>
              <a:t>2024/12/2</a:t>
            </a:fld>
            <a:endParaRPr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1EAC1-ACDF-40F2-BB67-D98ECABA6684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5679638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563FF-DD27-49B8-AB15-FDFDAE7C85F3}" type="datetimeFigureOut">
              <a:rPr lang="ja-JP" altLang="en-US" smtClean="0"/>
              <a:pPr/>
              <a:t>2024/12/2</a:t>
            </a:fld>
            <a:endParaRPr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B1EAC1-ACDF-40F2-BB67-D98ECABA6684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6148445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xmlns="" id="{A5EBB3A2-3DDB-4131-B1A0-A870C43C6D39}"/>
              </a:ext>
            </a:extLst>
          </p:cNvPr>
          <p:cNvSpPr txBox="1"/>
          <p:nvPr/>
        </p:nvSpPr>
        <p:spPr>
          <a:xfrm>
            <a:off x="161051" y="412716"/>
            <a:ext cx="295144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s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xmlns="" id="{EB21CE13-E22F-42C6-9276-06F663EF7211}"/>
              </a:ext>
            </a:extLst>
          </p:cNvPr>
          <p:cNvSpPr txBox="1"/>
          <p:nvPr/>
        </p:nvSpPr>
        <p:spPr>
          <a:xfrm>
            <a:off x="20552" y="1136255"/>
            <a:ext cx="6816895" cy="26495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altLang="ja-JP" sz="18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α-Pyrrolidinooctanophenone facilitates activation of human microglial cells via ROS/STAT3 dependent pathway</a:t>
            </a:r>
            <a:endParaRPr lang="ja-JP" altLang="ja-JP" sz="1800" dirty="0">
              <a:effectLst/>
              <a:latin typeface="Calibri" panose="020F050202020403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spcAft>
                <a:spcPts val="1200"/>
              </a:spcAft>
            </a:pPr>
            <a:r>
              <a:rPr lang="en-US" altLang="ja-JP" sz="14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Yuji Sakai</a:t>
            </a:r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,*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Junta </a:t>
            </a:r>
            <a:r>
              <a:rPr lang="en-US" altLang="ja-JP" sz="14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Hattori</a:t>
            </a:r>
            <a:r>
              <a:rPr lang="en-US" altLang="ja-JP" sz="1400" baseline="30000" dirty="0" err="1">
                <a:effectLst/>
                <a:latin typeface="Times New Roman" panose="02020603050405020304" pitchFamily="18" charset="0"/>
                <a:ea typeface="HGPｺﾞｼｯｸE" panose="020B0900000000000000" pitchFamily="50" charset="-128"/>
                <a:cs typeface="Times New Roman" panose="02020603050405020304" pitchFamily="18" charset="0"/>
              </a:rPr>
              <a:t>b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Yoshifumi Morikawa</a:t>
            </a:r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Toshihiro </a:t>
            </a:r>
            <a:r>
              <a:rPr lang="en-US" altLang="ja-JP" sz="14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atsumura</a:t>
            </a:r>
            <a:r>
              <a:rPr lang="en-US" altLang="ja-JP" sz="1400" baseline="30000" dirty="0" err="1">
                <a:effectLst/>
                <a:latin typeface="Times New Roman" panose="02020603050405020304" pitchFamily="18" charset="0"/>
                <a:ea typeface="HGPｺﾞｼｯｸE" panose="020B0900000000000000" pitchFamily="50" charset="-128"/>
                <a:cs typeface="Times New Roman" panose="02020603050405020304" pitchFamily="18" charset="0"/>
              </a:rPr>
              <a:t>b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</a:t>
            </a:r>
            <a:r>
              <a:rPr lang="en-US" altLang="ja-JP" sz="14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hunsuke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4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Jimbo</a:t>
            </a:r>
            <a:r>
              <a:rPr lang="en-US" altLang="ja-JP" sz="1400" baseline="300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Koichi Suenami</a:t>
            </a:r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HGPｺﾞｼｯｸE" panose="020B0900000000000000" pitchFamily="50" charset="-128"/>
                <a:cs typeface="Times New Roman" panose="02020603050405020304" pitchFamily="18" charset="0"/>
              </a:rPr>
              <a:t>, Tomohiro Takayama</a:t>
            </a:r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HGPｺﾞｼｯｸE" panose="020B0900000000000000" pitchFamily="50" charset="-128"/>
                <a:cs typeface="Times New Roman" panose="02020603050405020304" pitchFamily="18" charset="0"/>
              </a:rPr>
              <a:t>a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HGPｺﾞｼｯｸE" panose="020B0900000000000000" pitchFamily="50" charset="-128"/>
                <a:cs typeface="Times New Roman" panose="02020603050405020304" pitchFamily="18" charset="0"/>
              </a:rPr>
              <a:t>, Atsushi </a:t>
            </a:r>
            <a:r>
              <a:rPr lang="en-US" altLang="ja-JP" sz="1400" dirty="0" err="1">
                <a:effectLst/>
                <a:latin typeface="Times New Roman" panose="02020603050405020304" pitchFamily="18" charset="0"/>
                <a:ea typeface="HGPｺﾞｼｯｸE" panose="020B0900000000000000" pitchFamily="50" charset="-128"/>
                <a:cs typeface="Times New Roman" panose="02020603050405020304" pitchFamily="18" charset="0"/>
              </a:rPr>
              <a:t>Nagai</a:t>
            </a:r>
            <a:r>
              <a:rPr lang="en-US" altLang="ja-JP" sz="1400" baseline="30000" dirty="0" err="1">
                <a:effectLst/>
                <a:latin typeface="Times New Roman" panose="02020603050405020304" pitchFamily="18" charset="0"/>
                <a:ea typeface="HGPｺﾞｼｯｸE" panose="020B0900000000000000" pitchFamily="50" charset="-128"/>
                <a:cs typeface="Times New Roman" panose="02020603050405020304" pitchFamily="18" charset="0"/>
              </a:rPr>
              <a:t>c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HGPｺﾞｼｯｸE" panose="020B0900000000000000" pitchFamily="50" charset="-128"/>
                <a:cs typeface="Times New Roman" panose="02020603050405020304" pitchFamily="18" charset="0"/>
              </a:rPr>
              <a:t>, Tomomi Michiue</a:t>
            </a:r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HGPｺﾞｼｯｸE" panose="020B0900000000000000" pitchFamily="50" charset="-128"/>
                <a:cs typeface="Times New Roman" panose="02020603050405020304" pitchFamily="18" charset="0"/>
              </a:rPr>
              <a:t>c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HGPｺﾞｼｯｸE" panose="020B0900000000000000" pitchFamily="50" charset="-128"/>
                <a:cs typeface="Times New Roman" panose="02020603050405020304" pitchFamily="18" charset="0"/>
              </a:rPr>
              <a:t>, Akira </a:t>
            </a:r>
            <a:r>
              <a:rPr lang="en-US" altLang="ja-JP" sz="1400" dirty="0" err="1">
                <a:effectLst/>
                <a:latin typeface="Times New Roman" panose="02020603050405020304" pitchFamily="18" charset="0"/>
                <a:ea typeface="HGPｺﾞｼｯｸE" panose="020B0900000000000000" pitchFamily="50" charset="-128"/>
                <a:cs typeface="Times New Roman" panose="02020603050405020304" pitchFamily="18" charset="0"/>
              </a:rPr>
              <a:t>Ikari</a:t>
            </a:r>
            <a:r>
              <a:rPr lang="en-US" altLang="ja-JP" sz="1400" baseline="300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HGPｺﾞｼｯｸE" panose="020B0900000000000000" pitchFamily="50" charset="-128"/>
                <a:cs typeface="Times New Roman" panose="02020603050405020304" pitchFamily="18" charset="0"/>
              </a:rPr>
              <a:t>, 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oshiyuki </a:t>
            </a:r>
            <a:r>
              <a:rPr lang="en-US" altLang="ja-JP" sz="14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atsunaga</a:t>
            </a:r>
            <a:r>
              <a:rPr lang="en-US" altLang="ja-JP" sz="1400" baseline="300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</a:t>
            </a:r>
            <a:endParaRPr lang="ja-JP" altLang="ja-JP" sz="1400" dirty="0">
              <a:effectLst/>
              <a:latin typeface="Calibri" panose="020F050202020403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1000"/>
              </a:spcAft>
            </a:pPr>
            <a:r>
              <a:rPr lang="en-US" altLang="ja-JP" sz="1200" i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orensic Science Laboratory, Gifu Prefectural Police Headquarters, Gifu, 500-8501, Japan,</a:t>
            </a:r>
            <a:br>
              <a:rPr lang="en-US" altLang="ja-JP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</a:br>
            <a:r>
              <a:rPr lang="en-US" altLang="ja-JP" sz="1200" i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</a:t>
            </a:r>
            <a:r>
              <a:rPr lang="en-US" altLang="ja-JP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Laboratory of Bioinformatics, Gifu Pharmaceutical University, Gifu, 502-8585, Japan,</a:t>
            </a:r>
            <a:br>
              <a:rPr lang="en-US" altLang="ja-JP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</a:br>
            <a:r>
              <a:rPr lang="en-US" altLang="ja-JP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</a:t>
            </a:r>
            <a:r>
              <a:rPr lang="en-US" altLang="ja-JP" sz="1200" i="1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L</a:t>
            </a:r>
            <a:r>
              <a:rPr lang="en-US" altLang="ja-JP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boratory of Biochemistry, Gifu Pharmaceutical University, Gifu, 501-1196, Japan,</a:t>
            </a:r>
            <a:br>
              <a:rPr lang="en-US" altLang="ja-JP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</a:br>
            <a:r>
              <a:rPr lang="en-US" altLang="ja-JP" sz="1200" i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 </a:t>
            </a:r>
            <a:r>
              <a:rPr lang="en-US" altLang="ja-JP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epartment of Legal Medicine, Graduate School of Medicine, Gifu University, Gifu, 501-1112, Japan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A5EBB3A2-3DDB-4131-B1A0-A870C43C6D39}"/>
              </a:ext>
            </a:extLst>
          </p:cNvPr>
          <p:cNvSpPr txBox="1"/>
          <p:nvPr/>
        </p:nvSpPr>
        <p:spPr>
          <a:xfrm>
            <a:off x="61343" y="4211848"/>
            <a:ext cx="6414929" cy="21544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ents</a:t>
            </a:r>
          </a:p>
          <a:p>
            <a:pPr marL="809625" indent="-633413">
              <a:spcAft>
                <a:spcPts val="600"/>
              </a:spcAft>
            </a:pPr>
            <a:r>
              <a:rPr lang="en-US" altLang="ja-JP" sz="1400" b="1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Fig. S1.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 of serum-free medium </a:t>
            </a:r>
            <a:r>
              <a:rPr lang="en-US" altLang="ja-JP" sz="1400" b="1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on IL-6 expression and caspase-3 activity in HMC3 cells. </a:t>
            </a:r>
          </a:p>
          <a:p>
            <a:pPr marL="809625" indent="-633413">
              <a:spcAft>
                <a:spcPts val="600"/>
              </a:spcAft>
            </a:pPr>
            <a:r>
              <a:rPr lang="en-US" altLang="ja-JP" sz="1400" b="1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Fig. S2.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 of lethal concentration of </a:t>
            </a:r>
            <a:r>
              <a:rPr lang="en-US" altLang="ja-JP" sz="1400" b="1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α-POP on expression of IL-6 in HMC3 cells. </a:t>
            </a:r>
          </a:p>
          <a:p>
            <a:pPr marL="809625" indent="-633413">
              <a:spcAft>
                <a:spcPts val="600"/>
              </a:spcAft>
            </a:pPr>
            <a:r>
              <a:rPr lang="en-US" altLang="ja-JP" sz="1400" b="1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Fig. S3. 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 of </a:t>
            </a:r>
            <a:r>
              <a:rPr lang="en-US" altLang="ja-JP" sz="1400" b="1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α-POP on expression of IL-1β and </a:t>
            </a:r>
            <a:r>
              <a:rPr lang="en-US" altLang="ja-JP" sz="1400" b="1" kern="100" dirty="0" err="1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iNOS</a:t>
            </a:r>
            <a:r>
              <a:rPr lang="en-US" altLang="ja-JP" sz="1400" b="1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 in HMC3 cells.</a:t>
            </a:r>
          </a:p>
          <a:p>
            <a:pPr marL="809625" indent="-633413">
              <a:spcAft>
                <a:spcPts val="600"/>
              </a:spcAft>
            </a:pPr>
            <a:r>
              <a:rPr lang="en-US" altLang="ja-JP" sz="1400" b="1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Fig. S4. 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 of </a:t>
            </a:r>
            <a:r>
              <a:rPr lang="en-US" altLang="ja-JP" sz="1400" b="1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JSH23 on microglial activation by α-POP treatment in HMC3 cells.</a:t>
            </a:r>
          </a:p>
        </p:txBody>
      </p:sp>
    </p:spTree>
    <p:extLst>
      <p:ext uri="{BB962C8B-B14F-4D97-AF65-F5344CB8AC3E}">
        <p14:creationId xmlns:p14="http://schemas.microsoft.com/office/powerpoint/2010/main" val="20350105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xmlns="" id="{0C0902AC-53C6-F1B9-8F14-F8892B2EFAE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67081" y="3533262"/>
            <a:ext cx="3377477" cy="3029975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47E62A99-253C-2075-D8A2-5A69A876CB53}"/>
              </a:ext>
            </a:extLst>
          </p:cNvPr>
          <p:cNvSpPr txBox="1"/>
          <p:nvPr/>
        </p:nvSpPr>
        <p:spPr>
          <a:xfrm>
            <a:off x="6000073" y="9511749"/>
            <a:ext cx="8579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510CF516-10C1-4D71-10C5-355F553F8A91}"/>
              </a:ext>
            </a:extLst>
          </p:cNvPr>
          <p:cNvSpPr txBox="1"/>
          <p:nvPr/>
        </p:nvSpPr>
        <p:spPr>
          <a:xfrm>
            <a:off x="2768238" y="3176402"/>
            <a:ext cx="68480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xmlns="" id="{837B71E1-4544-546D-4A73-0E895C9006F5}"/>
              </a:ext>
            </a:extLst>
          </p:cNvPr>
          <p:cNvSpPr/>
          <p:nvPr/>
        </p:nvSpPr>
        <p:spPr>
          <a:xfrm>
            <a:off x="83397" y="7066354"/>
            <a:ext cx="6691205" cy="1277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100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    (A) IL-6 concentration in the medium. The concentration of IL-6 in the medium supplemented without (-) or with 10% FBS was measured by ELISA, and then quantitated by using a linear standard curve. (B) Caspase-3 activity. The cells were cultured for 24 h with the indicated concentrations of α-POP in the absence or presence of 10% FBS. The caspase-3 activity was measured using N-acetyl Asp-Glu-Val-Asp-7-AMC, as a fluorogenic substrate and expressed as the percentage to that in the control cells cultured in the medium supplemented with 10% FBS.  Significant difference from the control cells, *</a:t>
            </a:r>
            <a:r>
              <a:rPr lang="en-US" altLang="ja-JP" sz="1100" i="1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p</a:t>
            </a:r>
            <a:r>
              <a:rPr lang="en-US" altLang="ja-JP" sz="1100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 &lt; 0.05 and **</a:t>
            </a:r>
            <a:r>
              <a:rPr lang="en-US" altLang="ja-JP" sz="1100" i="1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p</a:t>
            </a:r>
            <a:r>
              <a:rPr lang="en-US" altLang="ja-JP" sz="1100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 &lt; 0.01. Significant difference from the cells cultured in the serum-free medium, </a:t>
            </a:r>
            <a:r>
              <a:rPr lang="en-US" altLang="ja-JP" sz="1100" kern="100" baseline="300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#</a:t>
            </a:r>
            <a:r>
              <a:rPr lang="en-US" altLang="ja-JP" sz="1100" i="1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p</a:t>
            </a:r>
            <a:r>
              <a:rPr lang="en-US" altLang="ja-JP" sz="1100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 &lt; 0.05 and </a:t>
            </a:r>
            <a:r>
              <a:rPr lang="en-US" altLang="ja-JP" sz="1100" kern="100" baseline="30000" dirty="0" err="1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NS</a:t>
            </a:r>
            <a:r>
              <a:rPr lang="en-US" altLang="ja-JP" sz="1100" i="1" kern="100" dirty="0" err="1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p</a:t>
            </a:r>
            <a:r>
              <a:rPr lang="en-US" altLang="ja-JP" sz="1100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 &gt; 0.05.</a:t>
            </a:r>
            <a:endParaRPr lang="ja-JP" altLang="ja-JP" sz="1100" kern="100" dirty="0">
              <a:latin typeface="Times New Roman" panose="02020603050405020304" pitchFamily="18" charset="0"/>
              <a:ea typeface="Arial Unicode MS" panose="020B060402020202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xmlns="" id="{AA6FA420-8417-C6B2-D91D-73322F24894F}"/>
              </a:ext>
            </a:extLst>
          </p:cNvPr>
          <p:cNvSpPr/>
          <p:nvPr/>
        </p:nvSpPr>
        <p:spPr>
          <a:xfrm>
            <a:off x="56230" y="6563237"/>
            <a:ext cx="678818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630238" indent="-630238"/>
            <a:r>
              <a:rPr lang="en-US" altLang="ja-JP" sz="1400" b="1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Fig. S1.</a:t>
            </a:r>
            <a:r>
              <a:rPr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 of serum-free medium </a:t>
            </a:r>
            <a:r>
              <a:rPr lang="en-US" altLang="ja-JP" sz="1400" b="1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on IL-6 expression and caspase-3 activity in HMC3 cells. </a:t>
            </a:r>
          </a:p>
        </p:txBody>
      </p: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xmlns="" id="{4863F006-CFB4-282F-4F61-14DF35F5B172}"/>
              </a:ext>
            </a:extLst>
          </p:cNvPr>
          <p:cNvGrpSpPr/>
          <p:nvPr/>
        </p:nvGrpSpPr>
        <p:grpSpPr>
          <a:xfrm>
            <a:off x="703057" y="3533262"/>
            <a:ext cx="1822862" cy="2838701"/>
            <a:chOff x="703057" y="3533262"/>
            <a:chExt cx="1822862" cy="2838701"/>
          </a:xfrm>
        </p:grpSpPr>
        <p:pic>
          <p:nvPicPr>
            <p:cNvPr id="6" name="図 5">
              <a:extLst>
                <a:ext uri="{FF2B5EF4-FFF2-40B4-BE49-F238E27FC236}">
                  <a16:creationId xmlns:a16="http://schemas.microsoft.com/office/drawing/2014/main" xmlns="" id="{0601D486-E8CD-B9D4-BF01-62954E34AF7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03057" y="3610236"/>
              <a:ext cx="1822862" cy="2761727"/>
            </a:xfrm>
            <a:prstGeom prst="rect">
              <a:avLst/>
            </a:prstGeom>
          </p:spPr>
        </p:pic>
        <p:pic>
          <p:nvPicPr>
            <p:cNvPr id="4" name="図 3">
              <a:extLst>
                <a:ext uri="{FF2B5EF4-FFF2-40B4-BE49-F238E27FC236}">
                  <a16:creationId xmlns:a16="http://schemas.microsoft.com/office/drawing/2014/main" xmlns="" id="{C44E3AD4-C2CD-F73D-2202-5B0304430A0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r="83938"/>
            <a:stretch/>
          </p:blipFill>
          <p:spPr>
            <a:xfrm>
              <a:off x="703057" y="3533262"/>
              <a:ext cx="349578" cy="2810500"/>
            </a:xfrm>
            <a:prstGeom prst="rect">
              <a:avLst/>
            </a:prstGeom>
            <a:solidFill>
              <a:schemeClr val="bg1"/>
            </a:solidFill>
          </p:spPr>
        </p:pic>
      </p:grp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B4BD2C2B-666D-0F9D-B75C-128A1F1B956F}"/>
              </a:ext>
            </a:extLst>
          </p:cNvPr>
          <p:cNvSpPr txBox="1"/>
          <p:nvPr/>
        </p:nvSpPr>
        <p:spPr>
          <a:xfrm>
            <a:off x="254860" y="3176402"/>
            <a:ext cx="68480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736388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xmlns="" id="{6BB8370C-263F-6A77-E9B2-B4A0B6707F2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C0A86C14-81C8-8E3F-0951-5A6D090F13AD}"/>
              </a:ext>
            </a:extLst>
          </p:cNvPr>
          <p:cNvSpPr txBox="1"/>
          <p:nvPr/>
        </p:nvSpPr>
        <p:spPr>
          <a:xfrm>
            <a:off x="6000073" y="9511749"/>
            <a:ext cx="8579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Fig. S2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xmlns="" id="{AFC9886A-AF24-CF3B-11D6-DA35C9E497EB}"/>
              </a:ext>
            </a:extLst>
          </p:cNvPr>
          <p:cNvSpPr/>
          <p:nvPr/>
        </p:nvSpPr>
        <p:spPr>
          <a:xfrm>
            <a:off x="80380" y="6717847"/>
            <a:ext cx="6677608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100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    The cells were treated for 12 h with the 0 or 80 µM of α-POP. The expression levels of IL-6 mRNA were measured by RT-qPCR analyses using their specific primers. The value in the treated cells was normalized to that of β-actin and is expressed as the percentage to that in the vehicle-treated cells (control, </a:t>
            </a:r>
            <a:r>
              <a:rPr lang="en-US" altLang="ja-JP" sz="1100" i="1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open bar</a:t>
            </a:r>
            <a:r>
              <a:rPr lang="en-US" altLang="ja-JP" sz="1100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) in the bar graph. **Significant difference from the control cells, </a:t>
            </a:r>
            <a:r>
              <a:rPr lang="en-US" altLang="ja-JP" sz="1100" i="1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p</a:t>
            </a:r>
            <a:r>
              <a:rPr lang="en-US" altLang="ja-JP" sz="1100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 &lt; 0.01. </a:t>
            </a:r>
            <a:endParaRPr lang="ja-JP" altLang="ja-JP" sz="1100" kern="100" dirty="0">
              <a:latin typeface="Times New Roman" panose="02020603050405020304" pitchFamily="18" charset="0"/>
              <a:ea typeface="Arial Unicode MS" panose="020B060402020202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xmlns="" id="{0BE06C8E-34C4-7672-8BDA-F2224B925B45}"/>
              </a:ext>
            </a:extLst>
          </p:cNvPr>
          <p:cNvSpPr/>
          <p:nvPr/>
        </p:nvSpPr>
        <p:spPr>
          <a:xfrm>
            <a:off x="36513" y="6410070"/>
            <a:ext cx="68580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630238" indent="-630238"/>
            <a:r>
              <a:rPr lang="en-US" altLang="ja-JP" sz="1400" b="1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Fig. S2.</a:t>
            </a:r>
            <a:r>
              <a:rPr lang="ja-JP" altLang="en-US" sz="1400" b="1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 of lethal concentration of </a:t>
            </a:r>
            <a:r>
              <a:rPr lang="en-US" altLang="ja-JP" sz="1400" b="1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α-POP on expression of IL-6 in HMC3 cells.</a:t>
            </a: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xmlns="" id="{68B092E7-C028-7AD6-2A39-89588C66EAC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17859" y="3470068"/>
            <a:ext cx="1932599" cy="27861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869600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xmlns="" id="{8765E0B0-46A5-4394-9136-245AFCAEF95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75094" y="3495929"/>
            <a:ext cx="2859272" cy="2914141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03DB2D03-761C-871E-B84B-2A37290E04A2}"/>
              </a:ext>
            </a:extLst>
          </p:cNvPr>
          <p:cNvSpPr txBox="1"/>
          <p:nvPr/>
        </p:nvSpPr>
        <p:spPr>
          <a:xfrm>
            <a:off x="6000073" y="9511749"/>
            <a:ext cx="8579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Fig. S3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xmlns="" id="{6866DEB3-F1FB-D5AF-EDE4-DFD705CF7F88}"/>
              </a:ext>
            </a:extLst>
          </p:cNvPr>
          <p:cNvSpPr/>
          <p:nvPr/>
        </p:nvSpPr>
        <p:spPr>
          <a:xfrm>
            <a:off x="80380" y="6717847"/>
            <a:ext cx="6677608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100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    The cells were treated for 12 h with the 0 or 20 µM of α-POP. The expression levels of IL-1β and iNOS mRNA were measured by RT-qPCR analyses using their specific primers (IL-1β forward: 5’-GGCCCTAAACAGATGAAGTGCT-3’, IL-1β reverse: 5’-ATGAAGGGAAAGAAGGTGCTCA-3’, iNOS forward: 5’-TCCCGAGTCAGAGTCACCAT-3’, iNOS reverse: 5’-TCCATGCAGACAACCTTGGG-3’). The value in the treated cells was normalized to that of β-actin and is expressed as the percentage to that in the vehicle-treated cells (control, </a:t>
            </a:r>
            <a:r>
              <a:rPr lang="en-US" altLang="ja-JP" sz="1100" i="1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open bar</a:t>
            </a:r>
            <a:r>
              <a:rPr lang="en-US" altLang="ja-JP" sz="1100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) in the bar graph. *Significant difference from the control cells, </a:t>
            </a:r>
            <a:r>
              <a:rPr lang="en-US" altLang="ja-JP" sz="1100" i="1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p</a:t>
            </a:r>
            <a:r>
              <a:rPr lang="en-US" altLang="ja-JP" sz="1100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 &lt; 0.05. </a:t>
            </a:r>
            <a:endParaRPr lang="ja-JP" altLang="ja-JP" sz="1100" kern="100" dirty="0">
              <a:latin typeface="Times New Roman" panose="02020603050405020304" pitchFamily="18" charset="0"/>
              <a:ea typeface="Arial Unicode MS" panose="020B060402020202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xmlns="" id="{A1053185-CC71-DF88-47D8-279B4F83EA63}"/>
              </a:ext>
            </a:extLst>
          </p:cNvPr>
          <p:cNvSpPr/>
          <p:nvPr/>
        </p:nvSpPr>
        <p:spPr>
          <a:xfrm>
            <a:off x="36513" y="6410070"/>
            <a:ext cx="68580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630238" indent="-630238"/>
            <a:r>
              <a:rPr lang="en-US" altLang="ja-JP" sz="1400" b="1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Fig. S3.</a:t>
            </a:r>
            <a:r>
              <a:rPr lang="ja-JP" altLang="en-US" sz="1400" b="1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 of </a:t>
            </a:r>
            <a:r>
              <a:rPr lang="en-US" altLang="ja-JP" sz="1400" b="1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α-POP on expression of IL-1β and </a:t>
            </a:r>
            <a:r>
              <a:rPr lang="en-US" altLang="ja-JP" sz="1400" b="1" kern="100" dirty="0" err="1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iNOS</a:t>
            </a:r>
            <a:r>
              <a:rPr lang="en-US" altLang="ja-JP" sz="1400" b="1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 in HMC3 cells.</a:t>
            </a:r>
          </a:p>
        </p:txBody>
      </p:sp>
    </p:spTree>
    <p:extLst>
      <p:ext uri="{BB962C8B-B14F-4D97-AF65-F5344CB8AC3E}">
        <p14:creationId xmlns:p14="http://schemas.microsoft.com/office/powerpoint/2010/main" val="263780584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xmlns="" id="{10E7485E-34EE-720E-A195-DFAF661198B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xmlns="" id="{AEEC4535-ADF9-3CA4-0EE7-922D45DF0261}"/>
              </a:ext>
            </a:extLst>
          </p:cNvPr>
          <p:cNvGrpSpPr/>
          <p:nvPr/>
        </p:nvGrpSpPr>
        <p:grpSpPr>
          <a:xfrm>
            <a:off x="4800572" y="4349231"/>
            <a:ext cx="1766192" cy="977385"/>
            <a:chOff x="4714875" y="514114"/>
            <a:chExt cx="1766192" cy="977385"/>
          </a:xfrm>
        </p:grpSpPr>
        <p:sp>
          <p:nvSpPr>
            <p:cNvPr id="4" name="正方形/長方形 3">
              <a:extLst>
                <a:ext uri="{FF2B5EF4-FFF2-40B4-BE49-F238E27FC236}">
                  <a16:creationId xmlns:a16="http://schemas.microsoft.com/office/drawing/2014/main" xmlns="" id="{4930C014-F191-1E4B-E532-0D45BA7F7DBC}"/>
                </a:ext>
              </a:extLst>
            </p:cNvPr>
            <p:cNvSpPr/>
            <p:nvPr/>
          </p:nvSpPr>
          <p:spPr>
            <a:xfrm>
              <a:off x="4714875" y="581919"/>
              <a:ext cx="126000" cy="126000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en-US" altLang="ja-JP" dirty="0"/>
            </a:p>
          </p:txBody>
        </p:sp>
        <p:sp>
          <p:nvSpPr>
            <p:cNvPr id="5" name="正方形/長方形 4">
              <a:extLst>
                <a:ext uri="{FF2B5EF4-FFF2-40B4-BE49-F238E27FC236}">
                  <a16:creationId xmlns:a16="http://schemas.microsoft.com/office/drawing/2014/main" xmlns="" id="{4B4BE472-6374-2D41-4851-A48B02056915}"/>
                </a:ext>
              </a:extLst>
            </p:cNvPr>
            <p:cNvSpPr/>
            <p:nvPr/>
          </p:nvSpPr>
          <p:spPr>
            <a:xfrm>
              <a:off x="4714875" y="818401"/>
              <a:ext cx="126000" cy="126000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en-US" altLang="ja-JP" dirty="0"/>
            </a:p>
          </p:txBody>
        </p:sp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xmlns="" id="{E6BB6EED-B8EF-393C-97AB-9C2A6658ED6D}"/>
                </a:ext>
              </a:extLst>
            </p:cNvPr>
            <p:cNvSpPr/>
            <p:nvPr/>
          </p:nvSpPr>
          <p:spPr>
            <a:xfrm>
              <a:off x="4714875" y="1054883"/>
              <a:ext cx="126000" cy="126000"/>
            </a:xfrm>
            <a:prstGeom prst="rect">
              <a:avLst/>
            </a:prstGeom>
            <a:pattFill prst="wdUpDiag">
              <a:fgClr>
                <a:schemeClr val="tx1"/>
              </a:fgClr>
              <a:bgClr>
                <a:schemeClr val="bg1"/>
              </a:bgClr>
            </a:patt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en-US" altLang="ja-JP" dirty="0"/>
            </a:p>
          </p:txBody>
        </p:sp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xmlns="" id="{A57917C3-68D0-97E8-48A9-576220110CC5}"/>
                </a:ext>
              </a:extLst>
            </p:cNvPr>
            <p:cNvSpPr/>
            <p:nvPr/>
          </p:nvSpPr>
          <p:spPr>
            <a:xfrm>
              <a:off x="4714875" y="1291364"/>
              <a:ext cx="126000" cy="126000"/>
            </a:xfrm>
            <a:prstGeom prst="rect">
              <a:avLst/>
            </a:prstGeom>
            <a:pattFill prst="pct5">
              <a:fgClr>
                <a:schemeClr val="tx1"/>
              </a:fgClr>
              <a:bgClr>
                <a:schemeClr val="bg1"/>
              </a:bgClr>
            </a:patt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en-US" altLang="ja-JP" dirty="0"/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xmlns="" id="{66D789F7-0FE8-02D9-AF2D-68B96B1A41F3}"/>
                </a:ext>
              </a:extLst>
            </p:cNvPr>
            <p:cNvSpPr txBox="1"/>
            <p:nvPr/>
          </p:nvSpPr>
          <p:spPr>
            <a:xfrm>
              <a:off x="4840875" y="514114"/>
              <a:ext cx="67839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xmlns="" id="{90C27E54-48BC-98A8-D977-BDB5EDE0CE17}"/>
                </a:ext>
              </a:extLst>
            </p:cNvPr>
            <p:cNvSpPr txBox="1"/>
            <p:nvPr/>
          </p:nvSpPr>
          <p:spPr>
            <a:xfrm>
              <a:off x="4840874" y="752706"/>
              <a:ext cx="63190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l-GR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kumimoji="1"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POP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xmlns="" id="{C36147E4-6DCA-5923-9C10-AEF5B47AE2BF}"/>
                </a:ext>
              </a:extLst>
            </p:cNvPr>
            <p:cNvSpPr txBox="1"/>
            <p:nvPr/>
          </p:nvSpPr>
          <p:spPr>
            <a:xfrm>
              <a:off x="4840874" y="991298"/>
              <a:ext cx="163859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l-GR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kumimoji="1"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POP +   5 µM JSH23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xmlns="" id="{BE3C37BC-F736-082F-7BB5-24C24541BD3A}"/>
                </a:ext>
              </a:extLst>
            </p:cNvPr>
            <p:cNvSpPr txBox="1"/>
            <p:nvPr/>
          </p:nvSpPr>
          <p:spPr>
            <a:xfrm>
              <a:off x="4840874" y="1229889"/>
              <a:ext cx="164019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l-GR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kumimoji="1"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POP + 10 µM JSH23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38" name="図 37">
            <a:extLst>
              <a:ext uri="{FF2B5EF4-FFF2-40B4-BE49-F238E27FC236}">
                <a16:creationId xmlns:a16="http://schemas.microsoft.com/office/drawing/2014/main" xmlns="" id="{0305CABB-8EB0-B726-55B2-3EF87DE4F31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1327" y="3544702"/>
            <a:ext cx="4005419" cy="2816596"/>
          </a:xfrm>
          <a:prstGeom prst="rect">
            <a:avLst/>
          </a:prstGeom>
        </p:spPr>
      </p:pic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xmlns="" id="{2D809454-6C6F-441A-FF22-695A5AB34C54}"/>
              </a:ext>
            </a:extLst>
          </p:cNvPr>
          <p:cNvSpPr txBox="1"/>
          <p:nvPr/>
        </p:nvSpPr>
        <p:spPr>
          <a:xfrm>
            <a:off x="6000073" y="9511749"/>
            <a:ext cx="8579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Fig. S4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xmlns="" id="{C3555274-1409-B0FB-1282-9FC743C87D73}"/>
              </a:ext>
            </a:extLst>
          </p:cNvPr>
          <p:cNvSpPr/>
          <p:nvPr/>
        </p:nvSpPr>
        <p:spPr>
          <a:xfrm>
            <a:off x="36513" y="6588209"/>
            <a:ext cx="6691205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100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    The cells were pretreated for 2 h with 0, 5 (slashed bars) or 10 µM JSH23 (dotted bars), and then treated for 24 h with 0, 10 or 20 µM α-POP. The value in the treated cells is expressed as the percentage to that in the vehicle-treated control cells (open bar). Significant difference from the control cells, *</a:t>
            </a:r>
            <a:r>
              <a:rPr lang="en-US" altLang="ja-JP" sz="1100" i="1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p</a:t>
            </a:r>
            <a:r>
              <a:rPr lang="en-US" altLang="ja-JP" sz="1100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 &lt; 0.05 and **</a:t>
            </a:r>
            <a:r>
              <a:rPr lang="en-US" altLang="ja-JP" sz="1100" i="1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p</a:t>
            </a:r>
            <a:r>
              <a:rPr lang="en-US" altLang="ja-JP" sz="1100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 &lt; 0.01. </a:t>
            </a:r>
            <a:r>
              <a:rPr lang="en-US" altLang="ja-JP" sz="1100" kern="100" baseline="300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##</a:t>
            </a:r>
            <a:r>
              <a:rPr lang="en-US" altLang="ja-JP" sz="1100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Significant difference from the cells treated with α-POP alone, </a:t>
            </a:r>
            <a:r>
              <a:rPr lang="en-US" altLang="ja-JP" sz="1100" i="1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p</a:t>
            </a:r>
            <a:r>
              <a:rPr lang="en-US" altLang="ja-JP" sz="1100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 &lt; 0.01. </a:t>
            </a:r>
            <a:r>
              <a:rPr lang="en-US" altLang="ja-JP" sz="1100" kern="100" baseline="300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NS</a:t>
            </a:r>
            <a:r>
              <a:rPr lang="en-US" altLang="ja-JP" sz="1100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No significant difference, </a:t>
            </a:r>
            <a:r>
              <a:rPr lang="en-US" altLang="ja-JP" sz="1100" i="1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p</a:t>
            </a:r>
            <a:r>
              <a:rPr lang="en-US" altLang="ja-JP" sz="1100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 &gt; 0.05.</a:t>
            </a:r>
            <a:endParaRPr lang="ja-JP" altLang="ja-JP" sz="1100" kern="100" dirty="0">
              <a:latin typeface="Times New Roman" panose="02020603050405020304" pitchFamily="18" charset="0"/>
              <a:ea typeface="Arial Unicode MS" panose="020B060402020202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xmlns="" id="{EC0E472B-CCA1-0D39-21E8-FFA036703CD6}"/>
              </a:ext>
            </a:extLst>
          </p:cNvPr>
          <p:cNvSpPr/>
          <p:nvPr/>
        </p:nvSpPr>
        <p:spPr>
          <a:xfrm>
            <a:off x="36513" y="6292112"/>
            <a:ext cx="68580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630238" indent="-630238"/>
            <a:r>
              <a:rPr lang="en-US" altLang="ja-JP" sz="1400" b="1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Fig. S4.</a:t>
            </a:r>
            <a:r>
              <a:rPr lang="ja-JP" altLang="en-US" sz="1400" b="1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 of </a:t>
            </a:r>
            <a:r>
              <a:rPr lang="en-US" altLang="ja-JP" sz="1400" b="1" kern="1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JSH23 on microglial activation by α-POP treatment in HMC3 cells.</a:t>
            </a:r>
          </a:p>
        </p:txBody>
      </p:sp>
    </p:spTree>
    <p:extLst>
      <p:ext uri="{BB962C8B-B14F-4D97-AF65-F5344CB8AC3E}">
        <p14:creationId xmlns:p14="http://schemas.microsoft.com/office/powerpoint/2010/main" val="40381042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129</TotalTime>
  <Words>804</Words>
  <Application>Microsoft Office PowerPoint</Application>
  <PresentationFormat>A4 Paper (210x297 mm)</PresentationFormat>
  <Paragraphs>34</Paragraphs>
  <Slides>5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9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5" baseType="lpstr">
      <vt:lpstr>Arial Unicode MS</vt:lpstr>
      <vt:lpstr>游ゴシック</vt:lpstr>
      <vt:lpstr>游ゴシック Light</vt:lpstr>
      <vt:lpstr>Arial</vt:lpstr>
      <vt:lpstr>Calibri</vt:lpstr>
      <vt:lpstr>Calibri Light</vt:lpstr>
      <vt:lpstr>HGPｺﾞｼｯｸE</vt:lpstr>
      <vt:lpstr>ＭＳ 明朝</vt:lpstr>
      <vt:lpstr>Times New Roman</vt:lpstr>
      <vt:lpstr>Office テーマ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ki</dc:creator>
  <cp:lastModifiedBy>Poornima Thiruvudaiselvi</cp:lastModifiedBy>
  <cp:revision>343</cp:revision>
  <cp:lastPrinted>2024-10-17T23:12:22Z</cp:lastPrinted>
  <dcterms:created xsi:type="dcterms:W3CDTF">2019-10-31T12:08:53Z</dcterms:created>
  <dcterms:modified xsi:type="dcterms:W3CDTF">2024-12-02T12:25:37Z</dcterms:modified>
</cp:coreProperties>
</file>